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  <p:sldId id="277" r:id="rId3"/>
    <p:sldId id="278" r:id="rId4"/>
    <p:sldId id="279" r:id="rId5"/>
    <p:sldId id="280" r:id="rId6"/>
    <p:sldId id="281" r:id="rId7"/>
    <p:sldId id="282" r:id="rId8"/>
    <p:sldId id="283" r:id="rId9"/>
    <p:sldId id="28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2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80EFCB-59DD-4805-AABD-184895342B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7EB8ED6-64BA-4532-B634-C5AAC8C96A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5C8C3F-9FF7-4A5A-89E3-9E508EBA3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1A818C-C16C-4AD1-B4E8-A79AC1068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41143C-EE85-4CCD-A1DC-3726BD749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44868A-C4BF-4292-B0A6-EAAB1E7179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95AF7A-10C8-49AE-9520-F730AB53A8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18A4D3-D4FA-4843-B245-A4F25900D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37F55C-EFCB-414D-93FE-5FDD39B44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9FE382-2218-40AE-B37B-77BB9D587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8315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8796CDA-C05F-416A-B87D-13176A7C78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9DAC4D1-FD73-45AC-89D0-B7C2AE3776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96EC40-AB6B-4953-8585-0E246C7EE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C579EE-3FA8-40AE-97B9-B9A029554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62F90C-A7F6-49B4-BB39-375BA716D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083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8E8174-CF46-4942-9920-40593580E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74AD6B-C4C1-44B1-8939-B252F34138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737EE6-45D1-4BE7-8166-5F55F07D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207A5B-0915-4C45-8939-0421B1D23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54E190-0824-48D5-82D8-A1C4E90C9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917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E7CDF2-D899-43DD-AAED-ACDF61FA0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A3A92B-FF2F-4A38-A33D-B6C39F33BD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F2E955-B095-4374-BFFD-CF622B248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EE9730-73ED-4F14-AF7C-524CD8E31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93D5F7-D890-4B4A-96E0-52019107B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7467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9E9047-6924-4B0A-86A8-1E54CEC9D6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AEACBD-F2C0-4F64-AFEF-493D0155F4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7A542E-AA56-4E71-B90A-1000207FBA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A9F3D7-5077-4001-98AA-7D70276ED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29B69B-544A-44E1-A9FB-8F9345AAD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D65AA3-B8CE-492D-A413-9B2CC0611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3069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89F181-C9DF-4EAF-84DA-6F479A54C6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F36882-8BE7-4D7E-9D11-8274758A1C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C45B812-BFFD-4AE2-BE63-AE1D44EAFF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95F08B1-D4E2-455A-904C-59FB73C514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C9A6129-DC3F-4D08-9633-B00DB8B628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5D83AC5-5296-4EDB-9786-1936BFFCF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E65AD14-0CDB-4865-BBFE-45E6076F5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0991667-CF4A-40CE-923B-AF7646D3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1032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AF37E2-16E4-437C-9F9F-A7CC824FB0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FF0071B-5A75-4829-8477-EFE551DF4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FDD3C55-F2A7-47B7-8704-F5407999C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5949E43-5773-482E-BB13-F265DF494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2466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D6A7730-79A5-4210-A37E-CC43DDBB1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CE37618-99DC-40CC-8762-75C9310A1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CF1B0EC-21CF-4593-AF12-5B0D726F3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3473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0A1B7E-790E-4A09-A271-678BB433E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C699392-78FC-4818-944C-6CFD3CB4CC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57250E3-66F9-4E46-92E8-DFA49F2CFA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7FAC44B-63DE-4662-B663-9693C0EE6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7CAC06-A630-41C1-80C7-665B58FF3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D8CB274-223D-4CF5-9785-1D71F1716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098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35EFAE-FF9C-43FB-9395-7C2365DEB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B363677-AFCE-4566-A0FC-80F929AC25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811D28-5E73-4E81-9BB9-CF7C616B8E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900428-7291-4C3E-98CF-B0E40571B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F54FBA-1152-47B3-82A7-7783420F1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9B93447-9466-40F9-9926-088BBCA58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001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687DA99-E337-49C1-8DEF-DA819DCB8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EF07055-E559-4785-89BF-AC634B21B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3086EF-F76D-4376-8B64-B67F3D5634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EEF62-9E9D-4217-BDD8-1A6846E94878}" type="datetimeFigureOut">
              <a:rPr lang="zh-CN" altLang="en-US" smtClean="0"/>
              <a:t>2022/3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1531F4-8E75-44D5-BFC8-113C200CC0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F22188-C8E8-4DA8-BFFD-E9430B0525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4B456-0C01-42B4-876C-9B60FA5D309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182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A55857B9-8679-4557-B95B-817CB6BF2B1B}"/>
              </a:ext>
            </a:extLst>
          </p:cNvPr>
          <p:cNvSpPr txBox="1"/>
          <p:nvPr/>
        </p:nvSpPr>
        <p:spPr>
          <a:xfrm>
            <a:off x="342732" y="45734"/>
            <a:ext cx="10221068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. Network comparison plots for the incidence of (A) cardiac events, (B) neutropenia; </a:t>
            </a:r>
          </a:p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C) febrile neutropenia; (D) diarrhea; (E) vomiting; (F) rash or erythema; (G) hepatobiliary; (H) arthralgia; and (I) fatigue</a:t>
            </a:r>
          </a:p>
          <a:p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bbreviations: CT, chemotherapy;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zm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trastuzumab;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zm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ertuzuma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; T-DM1, trastuzumab emtansine; Lapa, lapatinib 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5965BFB-C128-4AE9-AD5C-CE3167D32327}"/>
              </a:ext>
            </a:extLst>
          </p:cNvPr>
          <p:cNvSpPr txBox="1"/>
          <p:nvPr/>
        </p:nvSpPr>
        <p:spPr>
          <a:xfrm>
            <a:off x="2988399" y="167326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Line 6">
            <a:extLst>
              <a:ext uri="{FF2B5EF4-FFF2-40B4-BE49-F238E27FC236}">
                <a16:creationId xmlns:a16="http://schemas.microsoft.com/office/drawing/2014/main" id="{629353EA-C768-4AED-A5BB-62B016EA5BCF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7651427" y="2927937"/>
            <a:ext cx="371475" cy="99853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Line 7">
            <a:extLst>
              <a:ext uri="{FF2B5EF4-FFF2-40B4-BE49-F238E27FC236}">
                <a16:creationId xmlns:a16="http://schemas.microsoft.com/office/drawing/2014/main" id="{74971312-25DC-49E5-A95F-547BC734FD5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7677" y="4086812"/>
            <a:ext cx="3611563" cy="627063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Line 8">
            <a:extLst>
              <a:ext uri="{FF2B5EF4-FFF2-40B4-BE49-F238E27FC236}">
                <a16:creationId xmlns:a16="http://schemas.microsoft.com/office/drawing/2014/main" id="{85B5995A-C5B4-4763-9A7A-7D4462DDFD5B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538590" y="2184987"/>
            <a:ext cx="936625" cy="533400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9">
            <a:extLst>
              <a:ext uri="{FF2B5EF4-FFF2-40B4-BE49-F238E27FC236}">
                <a16:creationId xmlns:a16="http://schemas.microsoft.com/office/drawing/2014/main" id="{4791B6B7-1D78-4C6F-B769-D7C25EF7ADCA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5200327" y="2372312"/>
            <a:ext cx="2257425" cy="392113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10">
            <a:extLst>
              <a:ext uri="{FF2B5EF4-FFF2-40B4-BE49-F238E27FC236}">
                <a16:creationId xmlns:a16="http://schemas.microsoft.com/office/drawing/2014/main" id="{41714E55-76C1-46D7-854C-A3F4D238F2B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98627" y="2862849"/>
            <a:ext cx="3176588" cy="180498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835D5ACC-E9E5-45F8-AA0F-96C248CAC54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200327" y="2138949"/>
            <a:ext cx="1066800" cy="18573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2">
            <a:extLst>
              <a:ext uri="{FF2B5EF4-FFF2-40B4-BE49-F238E27FC236}">
                <a16:creationId xmlns:a16="http://schemas.microsoft.com/office/drawing/2014/main" id="{0DA72887-E6C9-4103-AF44-2913A4A69EB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68465" y="2224674"/>
            <a:ext cx="2047875" cy="240188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3">
            <a:extLst>
              <a:ext uri="{FF2B5EF4-FFF2-40B4-BE49-F238E27FC236}">
                <a16:creationId xmlns:a16="http://schemas.microsoft.com/office/drawing/2014/main" id="{665852A9-4143-44C1-B293-3C2358B862E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24015" y="2485024"/>
            <a:ext cx="782638" cy="2117725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4">
            <a:extLst>
              <a:ext uri="{FF2B5EF4-FFF2-40B4-BE49-F238E27FC236}">
                <a16:creationId xmlns:a16="http://schemas.microsoft.com/office/drawing/2014/main" id="{CE2FEEEB-106A-4477-8E1F-C3F4551DF16C}"/>
              </a:ext>
            </a:extLst>
          </p:cNvPr>
          <p:cNvSpPr>
            <a:spLocks noChangeShapeType="1"/>
          </p:cNvSpPr>
          <p:nvPr/>
        </p:nvSpPr>
        <p:spPr bwMode="auto">
          <a:xfrm>
            <a:off x="4173215" y="3531187"/>
            <a:ext cx="0" cy="106203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5">
            <a:extLst>
              <a:ext uri="{FF2B5EF4-FFF2-40B4-BE49-F238E27FC236}">
                <a16:creationId xmlns:a16="http://schemas.microsoft.com/office/drawing/2014/main" id="{740300AB-EF1B-4608-8B50-D35089DA8616}"/>
              </a:ext>
            </a:extLst>
          </p:cNvPr>
          <p:cNvSpPr>
            <a:spLocks noChangeShapeType="1"/>
          </p:cNvSpPr>
          <p:nvPr/>
        </p:nvSpPr>
        <p:spPr bwMode="auto">
          <a:xfrm>
            <a:off x="4224015" y="3523249"/>
            <a:ext cx="782638" cy="211613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Line 16">
            <a:extLst>
              <a:ext uri="{FF2B5EF4-FFF2-40B4-BE49-F238E27FC236}">
                <a16:creationId xmlns:a16="http://schemas.microsoft.com/office/drawing/2014/main" id="{BEF55C28-FCCF-45A4-B2AF-B517E5ACC322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8627" y="3458162"/>
            <a:ext cx="3176588" cy="1803400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Line 17">
            <a:extLst>
              <a:ext uri="{FF2B5EF4-FFF2-40B4-BE49-F238E27FC236}">
                <a16:creationId xmlns:a16="http://schemas.microsoft.com/office/drawing/2014/main" id="{A409DA97-0705-45C8-A7C3-E1386256B6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268465" y="4850399"/>
            <a:ext cx="693738" cy="815975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Line 18">
            <a:extLst>
              <a:ext uri="{FF2B5EF4-FFF2-40B4-BE49-F238E27FC236}">
                <a16:creationId xmlns:a16="http://schemas.microsoft.com/office/drawing/2014/main" id="{EC2168B7-0653-49E2-ADC4-6F85C8C551F0}"/>
              </a:ext>
            </a:extLst>
          </p:cNvPr>
          <p:cNvSpPr>
            <a:spLocks noChangeShapeType="1"/>
          </p:cNvSpPr>
          <p:nvPr/>
        </p:nvSpPr>
        <p:spPr bwMode="auto">
          <a:xfrm>
            <a:off x="4317677" y="4763087"/>
            <a:ext cx="3140075" cy="54768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19">
            <a:extLst>
              <a:ext uri="{FF2B5EF4-FFF2-40B4-BE49-F238E27FC236}">
                <a16:creationId xmlns:a16="http://schemas.microsoft.com/office/drawing/2014/main" id="{A4497849-E517-43D0-88B9-E38EFFDD5CC5}"/>
              </a:ext>
            </a:extLst>
          </p:cNvPr>
          <p:cNvSpPr>
            <a:spLocks noChangeShapeType="1"/>
          </p:cNvSpPr>
          <p:nvPr/>
        </p:nvSpPr>
        <p:spPr bwMode="auto">
          <a:xfrm>
            <a:off x="5200327" y="5801312"/>
            <a:ext cx="1066800" cy="185738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ine 20">
            <a:extLst>
              <a:ext uri="{FF2B5EF4-FFF2-40B4-BE49-F238E27FC236}">
                <a16:creationId xmlns:a16="http://schemas.microsoft.com/office/drawing/2014/main" id="{A43DE2BF-44EE-4837-9434-BD08AC980BB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00327" y="5358399"/>
            <a:ext cx="2257425" cy="392113"/>
          </a:xfrm>
          <a:prstGeom prst="line">
            <a:avLst/>
          </a:prstGeom>
          <a:noFill/>
          <a:ln w="6350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1">
            <a:extLst>
              <a:ext uri="{FF2B5EF4-FFF2-40B4-BE49-F238E27FC236}">
                <a16:creationId xmlns:a16="http://schemas.microsoft.com/office/drawing/2014/main" id="{7D0F5BF1-575E-45A9-A4DB-B98EB150FF86}"/>
              </a:ext>
            </a:extLst>
          </p:cNvPr>
          <p:cNvSpPr>
            <a:spLocks/>
          </p:cNvSpPr>
          <p:nvPr/>
        </p:nvSpPr>
        <p:spPr bwMode="auto">
          <a:xfrm>
            <a:off x="7926065" y="3915362"/>
            <a:ext cx="292100" cy="293688"/>
          </a:xfrm>
          <a:custGeom>
            <a:avLst/>
            <a:gdLst>
              <a:gd name="T0" fmla="*/ 0 w 184"/>
              <a:gd name="T1" fmla="*/ 92 h 185"/>
              <a:gd name="T2" fmla="*/ 2 w 184"/>
              <a:gd name="T3" fmla="*/ 74 h 185"/>
              <a:gd name="T4" fmla="*/ 7 w 184"/>
              <a:gd name="T5" fmla="*/ 57 h 185"/>
              <a:gd name="T6" fmla="*/ 16 w 184"/>
              <a:gd name="T7" fmla="*/ 41 h 185"/>
              <a:gd name="T8" fmla="*/ 27 w 184"/>
              <a:gd name="T9" fmla="*/ 27 h 185"/>
              <a:gd name="T10" fmla="*/ 40 w 184"/>
              <a:gd name="T11" fmla="*/ 17 h 185"/>
              <a:gd name="T12" fmla="*/ 57 w 184"/>
              <a:gd name="T13" fmla="*/ 8 h 185"/>
              <a:gd name="T14" fmla="*/ 73 w 184"/>
              <a:gd name="T15" fmla="*/ 3 h 185"/>
              <a:gd name="T16" fmla="*/ 91 w 184"/>
              <a:gd name="T17" fmla="*/ 0 h 185"/>
              <a:gd name="T18" fmla="*/ 102 w 184"/>
              <a:gd name="T19" fmla="*/ 1 h 185"/>
              <a:gd name="T20" fmla="*/ 120 w 184"/>
              <a:gd name="T21" fmla="*/ 4 h 185"/>
              <a:gd name="T22" fmla="*/ 136 w 184"/>
              <a:gd name="T23" fmla="*/ 12 h 185"/>
              <a:gd name="T24" fmla="*/ 150 w 184"/>
              <a:gd name="T25" fmla="*/ 22 h 185"/>
              <a:gd name="T26" fmla="*/ 163 w 184"/>
              <a:gd name="T27" fmla="*/ 33 h 185"/>
              <a:gd name="T28" fmla="*/ 173 w 184"/>
              <a:gd name="T29" fmla="*/ 49 h 185"/>
              <a:gd name="T30" fmla="*/ 180 w 184"/>
              <a:gd name="T31" fmla="*/ 65 h 185"/>
              <a:gd name="T32" fmla="*/ 184 w 184"/>
              <a:gd name="T33" fmla="*/ 83 h 185"/>
              <a:gd name="T34" fmla="*/ 184 w 184"/>
              <a:gd name="T35" fmla="*/ 92 h 185"/>
              <a:gd name="T36" fmla="*/ 182 w 184"/>
              <a:gd name="T37" fmla="*/ 112 h 185"/>
              <a:gd name="T38" fmla="*/ 177 w 184"/>
              <a:gd name="T39" fmla="*/ 128 h 185"/>
              <a:gd name="T40" fmla="*/ 168 w 184"/>
              <a:gd name="T41" fmla="*/ 144 h 185"/>
              <a:gd name="T42" fmla="*/ 157 w 184"/>
              <a:gd name="T43" fmla="*/ 158 h 185"/>
              <a:gd name="T44" fmla="*/ 144 w 184"/>
              <a:gd name="T45" fmla="*/ 169 h 185"/>
              <a:gd name="T46" fmla="*/ 127 w 184"/>
              <a:gd name="T47" fmla="*/ 177 h 185"/>
              <a:gd name="T48" fmla="*/ 111 w 184"/>
              <a:gd name="T49" fmla="*/ 183 h 185"/>
              <a:gd name="T50" fmla="*/ 91 w 184"/>
              <a:gd name="T51" fmla="*/ 185 h 185"/>
              <a:gd name="T52" fmla="*/ 82 w 184"/>
              <a:gd name="T53" fmla="*/ 185 h 185"/>
              <a:gd name="T54" fmla="*/ 64 w 184"/>
              <a:gd name="T55" fmla="*/ 181 h 185"/>
              <a:gd name="T56" fmla="*/ 48 w 184"/>
              <a:gd name="T57" fmla="*/ 173 h 185"/>
              <a:gd name="T58" fmla="*/ 34 w 184"/>
              <a:gd name="T59" fmla="*/ 164 h 185"/>
              <a:gd name="T60" fmla="*/ 21 w 184"/>
              <a:gd name="T61" fmla="*/ 151 h 185"/>
              <a:gd name="T62" fmla="*/ 11 w 184"/>
              <a:gd name="T63" fmla="*/ 136 h 185"/>
              <a:gd name="T64" fmla="*/ 4 w 184"/>
              <a:gd name="T65" fmla="*/ 119 h 185"/>
              <a:gd name="T66" fmla="*/ 0 w 184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2" y="74"/>
                </a:lnTo>
                <a:lnTo>
                  <a:pt x="4" y="65"/>
                </a:lnTo>
                <a:lnTo>
                  <a:pt x="7" y="57"/>
                </a:lnTo>
                <a:lnTo>
                  <a:pt x="11" y="49"/>
                </a:lnTo>
                <a:lnTo>
                  <a:pt x="16" y="41"/>
                </a:lnTo>
                <a:lnTo>
                  <a:pt x="21" y="33"/>
                </a:lnTo>
                <a:lnTo>
                  <a:pt x="27" y="27"/>
                </a:lnTo>
                <a:lnTo>
                  <a:pt x="34" y="22"/>
                </a:lnTo>
                <a:lnTo>
                  <a:pt x="40" y="17"/>
                </a:lnTo>
                <a:lnTo>
                  <a:pt x="48" y="12"/>
                </a:lnTo>
                <a:lnTo>
                  <a:pt x="57" y="8"/>
                </a:lnTo>
                <a:lnTo>
                  <a:pt x="64" y="4"/>
                </a:lnTo>
                <a:lnTo>
                  <a:pt x="73" y="3"/>
                </a:lnTo>
                <a:lnTo>
                  <a:pt x="82" y="1"/>
                </a:lnTo>
                <a:lnTo>
                  <a:pt x="91" y="0"/>
                </a:lnTo>
                <a:lnTo>
                  <a:pt x="91" y="0"/>
                </a:lnTo>
                <a:lnTo>
                  <a:pt x="102" y="1"/>
                </a:lnTo>
                <a:lnTo>
                  <a:pt x="111" y="3"/>
                </a:lnTo>
                <a:lnTo>
                  <a:pt x="120" y="4"/>
                </a:lnTo>
                <a:lnTo>
                  <a:pt x="127" y="8"/>
                </a:lnTo>
                <a:lnTo>
                  <a:pt x="136" y="12"/>
                </a:lnTo>
                <a:lnTo>
                  <a:pt x="144" y="17"/>
                </a:lnTo>
                <a:lnTo>
                  <a:pt x="150" y="22"/>
                </a:lnTo>
                <a:lnTo>
                  <a:pt x="157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80" y="65"/>
                </a:lnTo>
                <a:lnTo>
                  <a:pt x="182" y="74"/>
                </a:lnTo>
                <a:lnTo>
                  <a:pt x="184" y="83"/>
                </a:lnTo>
                <a:lnTo>
                  <a:pt x="184" y="92"/>
                </a:lnTo>
                <a:lnTo>
                  <a:pt x="184" y="92"/>
                </a:lnTo>
                <a:lnTo>
                  <a:pt x="184" y="101"/>
                </a:lnTo>
                <a:lnTo>
                  <a:pt x="182" y="112"/>
                </a:lnTo>
                <a:lnTo>
                  <a:pt x="180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7" y="158"/>
                </a:lnTo>
                <a:lnTo>
                  <a:pt x="150" y="164"/>
                </a:lnTo>
                <a:lnTo>
                  <a:pt x="144" y="169"/>
                </a:lnTo>
                <a:lnTo>
                  <a:pt x="136" y="173"/>
                </a:lnTo>
                <a:lnTo>
                  <a:pt x="127" y="177"/>
                </a:lnTo>
                <a:lnTo>
                  <a:pt x="120" y="181"/>
                </a:lnTo>
                <a:lnTo>
                  <a:pt x="111" y="183"/>
                </a:lnTo>
                <a:lnTo>
                  <a:pt x="102" y="185"/>
                </a:lnTo>
                <a:lnTo>
                  <a:pt x="91" y="185"/>
                </a:lnTo>
                <a:lnTo>
                  <a:pt x="91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7" y="177"/>
                </a:lnTo>
                <a:lnTo>
                  <a:pt x="48" y="173"/>
                </a:lnTo>
                <a:lnTo>
                  <a:pt x="40" y="169"/>
                </a:lnTo>
                <a:lnTo>
                  <a:pt x="34" y="164"/>
                </a:lnTo>
                <a:lnTo>
                  <a:pt x="27" y="158"/>
                </a:lnTo>
                <a:lnTo>
                  <a:pt x="21" y="151"/>
                </a:lnTo>
                <a:lnTo>
                  <a:pt x="16" y="144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2" y="112"/>
                </a:lnTo>
                <a:lnTo>
                  <a:pt x="0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2">
            <a:extLst>
              <a:ext uri="{FF2B5EF4-FFF2-40B4-BE49-F238E27FC236}">
                <a16:creationId xmlns:a16="http://schemas.microsoft.com/office/drawing/2014/main" id="{A1F986DB-9C08-4E65-95B6-750EC9EC0CA1}"/>
              </a:ext>
            </a:extLst>
          </p:cNvPr>
          <p:cNvSpPr>
            <a:spLocks/>
          </p:cNvSpPr>
          <p:nvPr/>
        </p:nvSpPr>
        <p:spPr bwMode="auto">
          <a:xfrm>
            <a:off x="7926065" y="3915362"/>
            <a:ext cx="292100" cy="293688"/>
          </a:xfrm>
          <a:custGeom>
            <a:avLst/>
            <a:gdLst>
              <a:gd name="T0" fmla="*/ 0 w 184"/>
              <a:gd name="T1" fmla="*/ 92 h 185"/>
              <a:gd name="T2" fmla="*/ 2 w 184"/>
              <a:gd name="T3" fmla="*/ 74 h 185"/>
              <a:gd name="T4" fmla="*/ 7 w 184"/>
              <a:gd name="T5" fmla="*/ 57 h 185"/>
              <a:gd name="T6" fmla="*/ 16 w 184"/>
              <a:gd name="T7" fmla="*/ 41 h 185"/>
              <a:gd name="T8" fmla="*/ 27 w 184"/>
              <a:gd name="T9" fmla="*/ 27 h 185"/>
              <a:gd name="T10" fmla="*/ 40 w 184"/>
              <a:gd name="T11" fmla="*/ 17 h 185"/>
              <a:gd name="T12" fmla="*/ 57 w 184"/>
              <a:gd name="T13" fmla="*/ 8 h 185"/>
              <a:gd name="T14" fmla="*/ 73 w 184"/>
              <a:gd name="T15" fmla="*/ 3 h 185"/>
              <a:gd name="T16" fmla="*/ 91 w 184"/>
              <a:gd name="T17" fmla="*/ 0 h 185"/>
              <a:gd name="T18" fmla="*/ 102 w 184"/>
              <a:gd name="T19" fmla="*/ 1 h 185"/>
              <a:gd name="T20" fmla="*/ 120 w 184"/>
              <a:gd name="T21" fmla="*/ 4 h 185"/>
              <a:gd name="T22" fmla="*/ 136 w 184"/>
              <a:gd name="T23" fmla="*/ 12 h 185"/>
              <a:gd name="T24" fmla="*/ 150 w 184"/>
              <a:gd name="T25" fmla="*/ 22 h 185"/>
              <a:gd name="T26" fmla="*/ 163 w 184"/>
              <a:gd name="T27" fmla="*/ 33 h 185"/>
              <a:gd name="T28" fmla="*/ 173 w 184"/>
              <a:gd name="T29" fmla="*/ 49 h 185"/>
              <a:gd name="T30" fmla="*/ 180 w 184"/>
              <a:gd name="T31" fmla="*/ 65 h 185"/>
              <a:gd name="T32" fmla="*/ 184 w 184"/>
              <a:gd name="T33" fmla="*/ 83 h 185"/>
              <a:gd name="T34" fmla="*/ 184 w 184"/>
              <a:gd name="T35" fmla="*/ 92 h 185"/>
              <a:gd name="T36" fmla="*/ 182 w 184"/>
              <a:gd name="T37" fmla="*/ 112 h 185"/>
              <a:gd name="T38" fmla="*/ 177 w 184"/>
              <a:gd name="T39" fmla="*/ 128 h 185"/>
              <a:gd name="T40" fmla="*/ 168 w 184"/>
              <a:gd name="T41" fmla="*/ 144 h 185"/>
              <a:gd name="T42" fmla="*/ 157 w 184"/>
              <a:gd name="T43" fmla="*/ 158 h 185"/>
              <a:gd name="T44" fmla="*/ 144 w 184"/>
              <a:gd name="T45" fmla="*/ 169 h 185"/>
              <a:gd name="T46" fmla="*/ 127 w 184"/>
              <a:gd name="T47" fmla="*/ 177 h 185"/>
              <a:gd name="T48" fmla="*/ 111 w 184"/>
              <a:gd name="T49" fmla="*/ 183 h 185"/>
              <a:gd name="T50" fmla="*/ 91 w 184"/>
              <a:gd name="T51" fmla="*/ 185 h 185"/>
              <a:gd name="T52" fmla="*/ 82 w 184"/>
              <a:gd name="T53" fmla="*/ 185 h 185"/>
              <a:gd name="T54" fmla="*/ 64 w 184"/>
              <a:gd name="T55" fmla="*/ 181 h 185"/>
              <a:gd name="T56" fmla="*/ 48 w 184"/>
              <a:gd name="T57" fmla="*/ 173 h 185"/>
              <a:gd name="T58" fmla="*/ 34 w 184"/>
              <a:gd name="T59" fmla="*/ 164 h 185"/>
              <a:gd name="T60" fmla="*/ 21 w 184"/>
              <a:gd name="T61" fmla="*/ 151 h 185"/>
              <a:gd name="T62" fmla="*/ 11 w 184"/>
              <a:gd name="T63" fmla="*/ 136 h 185"/>
              <a:gd name="T64" fmla="*/ 4 w 184"/>
              <a:gd name="T65" fmla="*/ 119 h 185"/>
              <a:gd name="T66" fmla="*/ 0 w 184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2" y="74"/>
                </a:lnTo>
                <a:lnTo>
                  <a:pt x="4" y="65"/>
                </a:lnTo>
                <a:lnTo>
                  <a:pt x="7" y="57"/>
                </a:lnTo>
                <a:lnTo>
                  <a:pt x="11" y="49"/>
                </a:lnTo>
                <a:lnTo>
                  <a:pt x="16" y="41"/>
                </a:lnTo>
                <a:lnTo>
                  <a:pt x="21" y="33"/>
                </a:lnTo>
                <a:lnTo>
                  <a:pt x="27" y="27"/>
                </a:lnTo>
                <a:lnTo>
                  <a:pt x="34" y="22"/>
                </a:lnTo>
                <a:lnTo>
                  <a:pt x="40" y="17"/>
                </a:lnTo>
                <a:lnTo>
                  <a:pt x="48" y="12"/>
                </a:lnTo>
                <a:lnTo>
                  <a:pt x="57" y="8"/>
                </a:lnTo>
                <a:lnTo>
                  <a:pt x="64" y="4"/>
                </a:lnTo>
                <a:lnTo>
                  <a:pt x="73" y="3"/>
                </a:lnTo>
                <a:lnTo>
                  <a:pt x="82" y="1"/>
                </a:lnTo>
                <a:lnTo>
                  <a:pt x="91" y="0"/>
                </a:lnTo>
                <a:lnTo>
                  <a:pt x="91" y="0"/>
                </a:lnTo>
                <a:lnTo>
                  <a:pt x="102" y="1"/>
                </a:lnTo>
                <a:lnTo>
                  <a:pt x="111" y="3"/>
                </a:lnTo>
                <a:lnTo>
                  <a:pt x="120" y="4"/>
                </a:lnTo>
                <a:lnTo>
                  <a:pt x="127" y="8"/>
                </a:lnTo>
                <a:lnTo>
                  <a:pt x="136" y="12"/>
                </a:lnTo>
                <a:lnTo>
                  <a:pt x="144" y="17"/>
                </a:lnTo>
                <a:lnTo>
                  <a:pt x="150" y="22"/>
                </a:lnTo>
                <a:lnTo>
                  <a:pt x="157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80" y="65"/>
                </a:lnTo>
                <a:lnTo>
                  <a:pt x="182" y="74"/>
                </a:lnTo>
                <a:lnTo>
                  <a:pt x="184" y="83"/>
                </a:lnTo>
                <a:lnTo>
                  <a:pt x="184" y="92"/>
                </a:lnTo>
                <a:lnTo>
                  <a:pt x="184" y="92"/>
                </a:lnTo>
                <a:lnTo>
                  <a:pt x="184" y="101"/>
                </a:lnTo>
                <a:lnTo>
                  <a:pt x="182" y="112"/>
                </a:lnTo>
                <a:lnTo>
                  <a:pt x="180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7" y="158"/>
                </a:lnTo>
                <a:lnTo>
                  <a:pt x="150" y="164"/>
                </a:lnTo>
                <a:lnTo>
                  <a:pt x="144" y="169"/>
                </a:lnTo>
                <a:lnTo>
                  <a:pt x="136" y="173"/>
                </a:lnTo>
                <a:lnTo>
                  <a:pt x="127" y="177"/>
                </a:lnTo>
                <a:lnTo>
                  <a:pt x="120" y="181"/>
                </a:lnTo>
                <a:lnTo>
                  <a:pt x="111" y="183"/>
                </a:lnTo>
                <a:lnTo>
                  <a:pt x="102" y="185"/>
                </a:lnTo>
                <a:lnTo>
                  <a:pt x="91" y="185"/>
                </a:lnTo>
                <a:lnTo>
                  <a:pt x="91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7" y="177"/>
                </a:lnTo>
                <a:lnTo>
                  <a:pt x="48" y="173"/>
                </a:lnTo>
                <a:lnTo>
                  <a:pt x="40" y="169"/>
                </a:lnTo>
                <a:lnTo>
                  <a:pt x="34" y="164"/>
                </a:lnTo>
                <a:lnTo>
                  <a:pt x="27" y="158"/>
                </a:lnTo>
                <a:lnTo>
                  <a:pt x="21" y="151"/>
                </a:lnTo>
                <a:lnTo>
                  <a:pt x="16" y="144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2" y="112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3">
            <a:extLst>
              <a:ext uri="{FF2B5EF4-FFF2-40B4-BE49-F238E27FC236}">
                <a16:creationId xmlns:a16="http://schemas.microsoft.com/office/drawing/2014/main" id="{7ECC868B-08B1-46C4-90C6-7DC89AF8E915}"/>
              </a:ext>
            </a:extLst>
          </p:cNvPr>
          <p:cNvSpPr>
            <a:spLocks/>
          </p:cNvSpPr>
          <p:nvPr/>
        </p:nvSpPr>
        <p:spPr bwMode="auto">
          <a:xfrm>
            <a:off x="7926065" y="3915362"/>
            <a:ext cx="292100" cy="293688"/>
          </a:xfrm>
          <a:custGeom>
            <a:avLst/>
            <a:gdLst>
              <a:gd name="T0" fmla="*/ 0 w 184"/>
              <a:gd name="T1" fmla="*/ 92 h 185"/>
              <a:gd name="T2" fmla="*/ 2 w 184"/>
              <a:gd name="T3" fmla="*/ 74 h 185"/>
              <a:gd name="T4" fmla="*/ 7 w 184"/>
              <a:gd name="T5" fmla="*/ 57 h 185"/>
              <a:gd name="T6" fmla="*/ 16 w 184"/>
              <a:gd name="T7" fmla="*/ 41 h 185"/>
              <a:gd name="T8" fmla="*/ 27 w 184"/>
              <a:gd name="T9" fmla="*/ 27 h 185"/>
              <a:gd name="T10" fmla="*/ 40 w 184"/>
              <a:gd name="T11" fmla="*/ 17 h 185"/>
              <a:gd name="T12" fmla="*/ 57 w 184"/>
              <a:gd name="T13" fmla="*/ 8 h 185"/>
              <a:gd name="T14" fmla="*/ 73 w 184"/>
              <a:gd name="T15" fmla="*/ 3 h 185"/>
              <a:gd name="T16" fmla="*/ 91 w 184"/>
              <a:gd name="T17" fmla="*/ 0 h 185"/>
              <a:gd name="T18" fmla="*/ 102 w 184"/>
              <a:gd name="T19" fmla="*/ 1 h 185"/>
              <a:gd name="T20" fmla="*/ 120 w 184"/>
              <a:gd name="T21" fmla="*/ 4 h 185"/>
              <a:gd name="T22" fmla="*/ 136 w 184"/>
              <a:gd name="T23" fmla="*/ 12 h 185"/>
              <a:gd name="T24" fmla="*/ 150 w 184"/>
              <a:gd name="T25" fmla="*/ 22 h 185"/>
              <a:gd name="T26" fmla="*/ 163 w 184"/>
              <a:gd name="T27" fmla="*/ 33 h 185"/>
              <a:gd name="T28" fmla="*/ 173 w 184"/>
              <a:gd name="T29" fmla="*/ 49 h 185"/>
              <a:gd name="T30" fmla="*/ 180 w 184"/>
              <a:gd name="T31" fmla="*/ 65 h 185"/>
              <a:gd name="T32" fmla="*/ 184 w 184"/>
              <a:gd name="T33" fmla="*/ 83 h 185"/>
              <a:gd name="T34" fmla="*/ 184 w 184"/>
              <a:gd name="T35" fmla="*/ 92 h 185"/>
              <a:gd name="T36" fmla="*/ 182 w 184"/>
              <a:gd name="T37" fmla="*/ 112 h 185"/>
              <a:gd name="T38" fmla="*/ 177 w 184"/>
              <a:gd name="T39" fmla="*/ 128 h 185"/>
              <a:gd name="T40" fmla="*/ 168 w 184"/>
              <a:gd name="T41" fmla="*/ 144 h 185"/>
              <a:gd name="T42" fmla="*/ 157 w 184"/>
              <a:gd name="T43" fmla="*/ 158 h 185"/>
              <a:gd name="T44" fmla="*/ 144 w 184"/>
              <a:gd name="T45" fmla="*/ 169 h 185"/>
              <a:gd name="T46" fmla="*/ 127 w 184"/>
              <a:gd name="T47" fmla="*/ 177 h 185"/>
              <a:gd name="T48" fmla="*/ 111 w 184"/>
              <a:gd name="T49" fmla="*/ 183 h 185"/>
              <a:gd name="T50" fmla="*/ 91 w 184"/>
              <a:gd name="T51" fmla="*/ 185 h 185"/>
              <a:gd name="T52" fmla="*/ 82 w 184"/>
              <a:gd name="T53" fmla="*/ 185 h 185"/>
              <a:gd name="T54" fmla="*/ 64 w 184"/>
              <a:gd name="T55" fmla="*/ 181 h 185"/>
              <a:gd name="T56" fmla="*/ 48 w 184"/>
              <a:gd name="T57" fmla="*/ 173 h 185"/>
              <a:gd name="T58" fmla="*/ 34 w 184"/>
              <a:gd name="T59" fmla="*/ 164 h 185"/>
              <a:gd name="T60" fmla="*/ 21 w 184"/>
              <a:gd name="T61" fmla="*/ 151 h 185"/>
              <a:gd name="T62" fmla="*/ 11 w 184"/>
              <a:gd name="T63" fmla="*/ 136 h 185"/>
              <a:gd name="T64" fmla="*/ 4 w 184"/>
              <a:gd name="T65" fmla="*/ 119 h 185"/>
              <a:gd name="T66" fmla="*/ 0 w 184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2" y="74"/>
                </a:lnTo>
                <a:lnTo>
                  <a:pt x="4" y="65"/>
                </a:lnTo>
                <a:lnTo>
                  <a:pt x="7" y="57"/>
                </a:lnTo>
                <a:lnTo>
                  <a:pt x="11" y="49"/>
                </a:lnTo>
                <a:lnTo>
                  <a:pt x="16" y="41"/>
                </a:lnTo>
                <a:lnTo>
                  <a:pt x="21" y="33"/>
                </a:lnTo>
                <a:lnTo>
                  <a:pt x="27" y="27"/>
                </a:lnTo>
                <a:lnTo>
                  <a:pt x="34" y="22"/>
                </a:lnTo>
                <a:lnTo>
                  <a:pt x="40" y="17"/>
                </a:lnTo>
                <a:lnTo>
                  <a:pt x="48" y="12"/>
                </a:lnTo>
                <a:lnTo>
                  <a:pt x="57" y="8"/>
                </a:lnTo>
                <a:lnTo>
                  <a:pt x="64" y="4"/>
                </a:lnTo>
                <a:lnTo>
                  <a:pt x="73" y="3"/>
                </a:lnTo>
                <a:lnTo>
                  <a:pt x="82" y="1"/>
                </a:lnTo>
                <a:lnTo>
                  <a:pt x="91" y="0"/>
                </a:lnTo>
                <a:lnTo>
                  <a:pt x="91" y="0"/>
                </a:lnTo>
                <a:lnTo>
                  <a:pt x="102" y="1"/>
                </a:lnTo>
                <a:lnTo>
                  <a:pt x="111" y="3"/>
                </a:lnTo>
                <a:lnTo>
                  <a:pt x="120" y="4"/>
                </a:lnTo>
                <a:lnTo>
                  <a:pt x="127" y="8"/>
                </a:lnTo>
                <a:lnTo>
                  <a:pt x="136" y="12"/>
                </a:lnTo>
                <a:lnTo>
                  <a:pt x="144" y="17"/>
                </a:lnTo>
                <a:lnTo>
                  <a:pt x="150" y="22"/>
                </a:lnTo>
                <a:lnTo>
                  <a:pt x="157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80" y="65"/>
                </a:lnTo>
                <a:lnTo>
                  <a:pt x="182" y="74"/>
                </a:lnTo>
                <a:lnTo>
                  <a:pt x="184" y="83"/>
                </a:lnTo>
                <a:lnTo>
                  <a:pt x="184" y="92"/>
                </a:lnTo>
                <a:lnTo>
                  <a:pt x="184" y="92"/>
                </a:lnTo>
                <a:lnTo>
                  <a:pt x="184" y="101"/>
                </a:lnTo>
                <a:lnTo>
                  <a:pt x="182" y="112"/>
                </a:lnTo>
                <a:lnTo>
                  <a:pt x="180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7" y="158"/>
                </a:lnTo>
                <a:lnTo>
                  <a:pt x="150" y="164"/>
                </a:lnTo>
                <a:lnTo>
                  <a:pt x="144" y="169"/>
                </a:lnTo>
                <a:lnTo>
                  <a:pt x="136" y="173"/>
                </a:lnTo>
                <a:lnTo>
                  <a:pt x="127" y="177"/>
                </a:lnTo>
                <a:lnTo>
                  <a:pt x="120" y="181"/>
                </a:lnTo>
                <a:lnTo>
                  <a:pt x="111" y="183"/>
                </a:lnTo>
                <a:lnTo>
                  <a:pt x="102" y="185"/>
                </a:lnTo>
                <a:lnTo>
                  <a:pt x="91" y="185"/>
                </a:lnTo>
                <a:lnTo>
                  <a:pt x="91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7" y="177"/>
                </a:lnTo>
                <a:lnTo>
                  <a:pt x="48" y="173"/>
                </a:lnTo>
                <a:lnTo>
                  <a:pt x="40" y="169"/>
                </a:lnTo>
                <a:lnTo>
                  <a:pt x="34" y="164"/>
                </a:lnTo>
                <a:lnTo>
                  <a:pt x="27" y="158"/>
                </a:lnTo>
                <a:lnTo>
                  <a:pt x="21" y="151"/>
                </a:lnTo>
                <a:lnTo>
                  <a:pt x="16" y="144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2" y="112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4">
            <a:extLst>
              <a:ext uri="{FF2B5EF4-FFF2-40B4-BE49-F238E27FC236}">
                <a16:creationId xmlns:a16="http://schemas.microsoft.com/office/drawing/2014/main" id="{2C03B355-0A94-4069-9393-31B7BD60CECF}"/>
              </a:ext>
            </a:extLst>
          </p:cNvPr>
          <p:cNvSpPr>
            <a:spLocks/>
          </p:cNvSpPr>
          <p:nvPr/>
        </p:nvSpPr>
        <p:spPr bwMode="auto">
          <a:xfrm>
            <a:off x="7454577" y="2643774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4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8 h 184"/>
              <a:gd name="T10" fmla="*/ 41 w 185"/>
              <a:gd name="T11" fmla="*/ 16 h 184"/>
              <a:gd name="T12" fmla="*/ 57 w 185"/>
              <a:gd name="T13" fmla="*/ 7 h 184"/>
              <a:gd name="T14" fmla="*/ 75 w 185"/>
              <a:gd name="T15" fmla="*/ 2 h 184"/>
              <a:gd name="T16" fmla="*/ 92 w 185"/>
              <a:gd name="T17" fmla="*/ 0 h 184"/>
              <a:gd name="T18" fmla="*/ 101 w 185"/>
              <a:gd name="T19" fmla="*/ 1 h 184"/>
              <a:gd name="T20" fmla="*/ 119 w 185"/>
              <a:gd name="T21" fmla="*/ 5 h 184"/>
              <a:gd name="T22" fmla="*/ 136 w 185"/>
              <a:gd name="T23" fmla="*/ 11 h 184"/>
              <a:gd name="T24" fmla="*/ 151 w 185"/>
              <a:gd name="T25" fmla="*/ 21 h 184"/>
              <a:gd name="T26" fmla="*/ 164 w 185"/>
              <a:gd name="T27" fmla="*/ 34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1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9 h 184"/>
              <a:gd name="T46" fmla="*/ 128 w 185"/>
              <a:gd name="T47" fmla="*/ 178 h 184"/>
              <a:gd name="T48" fmla="*/ 112 w 185"/>
              <a:gd name="T49" fmla="*/ 183 h 184"/>
              <a:gd name="T50" fmla="*/ 92 w 185"/>
              <a:gd name="T51" fmla="*/ 184 h 184"/>
              <a:gd name="T52" fmla="*/ 83 w 185"/>
              <a:gd name="T53" fmla="*/ 184 h 184"/>
              <a:gd name="T54" fmla="*/ 66 w 185"/>
              <a:gd name="T55" fmla="*/ 180 h 184"/>
              <a:gd name="T56" fmla="*/ 49 w 185"/>
              <a:gd name="T57" fmla="*/ 174 h 184"/>
              <a:gd name="T58" fmla="*/ 34 w 185"/>
              <a:gd name="T59" fmla="*/ 163 h 184"/>
              <a:gd name="T60" fmla="*/ 22 w 185"/>
              <a:gd name="T61" fmla="*/ 151 h 184"/>
              <a:gd name="T62" fmla="*/ 12 w 185"/>
              <a:gd name="T63" fmla="*/ 137 h 184"/>
              <a:gd name="T64" fmla="*/ 4 w 185"/>
              <a:gd name="T65" fmla="*/ 120 h 184"/>
              <a:gd name="T66" fmla="*/ 2 w 185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4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4"/>
                </a:lnTo>
                <a:lnTo>
                  <a:pt x="27" y="28"/>
                </a:lnTo>
                <a:lnTo>
                  <a:pt x="34" y="21"/>
                </a:lnTo>
                <a:lnTo>
                  <a:pt x="41" y="16"/>
                </a:lnTo>
                <a:lnTo>
                  <a:pt x="49" y="11"/>
                </a:lnTo>
                <a:lnTo>
                  <a:pt x="57" y="7"/>
                </a:lnTo>
                <a:lnTo>
                  <a:pt x="66" y="5"/>
                </a:lnTo>
                <a:lnTo>
                  <a:pt x="75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2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4" y="16"/>
                </a:lnTo>
                <a:lnTo>
                  <a:pt x="151" y="21"/>
                </a:lnTo>
                <a:lnTo>
                  <a:pt x="158" y="28"/>
                </a:lnTo>
                <a:lnTo>
                  <a:pt x="164" y="34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4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2"/>
                </a:lnTo>
                <a:lnTo>
                  <a:pt x="183" y="111"/>
                </a:lnTo>
                <a:lnTo>
                  <a:pt x="181" y="120"/>
                </a:lnTo>
                <a:lnTo>
                  <a:pt x="177" y="128"/>
                </a:lnTo>
                <a:lnTo>
                  <a:pt x="173" y="137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3"/>
                </a:lnTo>
                <a:lnTo>
                  <a:pt x="144" y="169"/>
                </a:lnTo>
                <a:lnTo>
                  <a:pt x="136" y="174"/>
                </a:lnTo>
                <a:lnTo>
                  <a:pt x="128" y="178"/>
                </a:lnTo>
                <a:lnTo>
                  <a:pt x="119" y="180"/>
                </a:lnTo>
                <a:lnTo>
                  <a:pt x="112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5" y="183"/>
                </a:lnTo>
                <a:lnTo>
                  <a:pt x="66" y="180"/>
                </a:lnTo>
                <a:lnTo>
                  <a:pt x="57" y="178"/>
                </a:lnTo>
                <a:lnTo>
                  <a:pt x="49" y="174"/>
                </a:lnTo>
                <a:lnTo>
                  <a:pt x="41" y="169"/>
                </a:lnTo>
                <a:lnTo>
                  <a:pt x="34" y="163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7"/>
                </a:lnTo>
                <a:lnTo>
                  <a:pt x="8" y="128"/>
                </a:lnTo>
                <a:lnTo>
                  <a:pt x="4" y="120"/>
                </a:lnTo>
                <a:lnTo>
                  <a:pt x="3" y="111"/>
                </a:lnTo>
                <a:lnTo>
                  <a:pt x="2" y="102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5">
            <a:extLst>
              <a:ext uri="{FF2B5EF4-FFF2-40B4-BE49-F238E27FC236}">
                <a16:creationId xmlns:a16="http://schemas.microsoft.com/office/drawing/2014/main" id="{E5498031-9D9D-4D60-BDD8-FF4DB04EC725}"/>
              </a:ext>
            </a:extLst>
          </p:cNvPr>
          <p:cNvSpPr>
            <a:spLocks/>
          </p:cNvSpPr>
          <p:nvPr/>
        </p:nvSpPr>
        <p:spPr bwMode="auto">
          <a:xfrm>
            <a:off x="7454577" y="2643774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4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8 h 184"/>
              <a:gd name="T10" fmla="*/ 41 w 185"/>
              <a:gd name="T11" fmla="*/ 16 h 184"/>
              <a:gd name="T12" fmla="*/ 57 w 185"/>
              <a:gd name="T13" fmla="*/ 7 h 184"/>
              <a:gd name="T14" fmla="*/ 75 w 185"/>
              <a:gd name="T15" fmla="*/ 2 h 184"/>
              <a:gd name="T16" fmla="*/ 92 w 185"/>
              <a:gd name="T17" fmla="*/ 0 h 184"/>
              <a:gd name="T18" fmla="*/ 101 w 185"/>
              <a:gd name="T19" fmla="*/ 1 h 184"/>
              <a:gd name="T20" fmla="*/ 119 w 185"/>
              <a:gd name="T21" fmla="*/ 5 h 184"/>
              <a:gd name="T22" fmla="*/ 136 w 185"/>
              <a:gd name="T23" fmla="*/ 11 h 184"/>
              <a:gd name="T24" fmla="*/ 151 w 185"/>
              <a:gd name="T25" fmla="*/ 21 h 184"/>
              <a:gd name="T26" fmla="*/ 164 w 185"/>
              <a:gd name="T27" fmla="*/ 34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1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9 h 184"/>
              <a:gd name="T46" fmla="*/ 128 w 185"/>
              <a:gd name="T47" fmla="*/ 178 h 184"/>
              <a:gd name="T48" fmla="*/ 112 w 185"/>
              <a:gd name="T49" fmla="*/ 183 h 184"/>
              <a:gd name="T50" fmla="*/ 92 w 185"/>
              <a:gd name="T51" fmla="*/ 184 h 184"/>
              <a:gd name="T52" fmla="*/ 83 w 185"/>
              <a:gd name="T53" fmla="*/ 184 h 184"/>
              <a:gd name="T54" fmla="*/ 66 w 185"/>
              <a:gd name="T55" fmla="*/ 180 h 184"/>
              <a:gd name="T56" fmla="*/ 49 w 185"/>
              <a:gd name="T57" fmla="*/ 174 h 184"/>
              <a:gd name="T58" fmla="*/ 34 w 185"/>
              <a:gd name="T59" fmla="*/ 163 h 184"/>
              <a:gd name="T60" fmla="*/ 22 w 185"/>
              <a:gd name="T61" fmla="*/ 151 h 184"/>
              <a:gd name="T62" fmla="*/ 12 w 185"/>
              <a:gd name="T63" fmla="*/ 137 h 184"/>
              <a:gd name="T64" fmla="*/ 4 w 185"/>
              <a:gd name="T65" fmla="*/ 120 h 184"/>
              <a:gd name="T66" fmla="*/ 2 w 185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4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4"/>
                </a:lnTo>
                <a:lnTo>
                  <a:pt x="27" y="28"/>
                </a:lnTo>
                <a:lnTo>
                  <a:pt x="34" y="21"/>
                </a:lnTo>
                <a:lnTo>
                  <a:pt x="41" y="16"/>
                </a:lnTo>
                <a:lnTo>
                  <a:pt x="49" y="11"/>
                </a:lnTo>
                <a:lnTo>
                  <a:pt x="57" y="7"/>
                </a:lnTo>
                <a:lnTo>
                  <a:pt x="66" y="5"/>
                </a:lnTo>
                <a:lnTo>
                  <a:pt x="75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2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4" y="16"/>
                </a:lnTo>
                <a:lnTo>
                  <a:pt x="151" y="21"/>
                </a:lnTo>
                <a:lnTo>
                  <a:pt x="158" y="28"/>
                </a:lnTo>
                <a:lnTo>
                  <a:pt x="164" y="34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4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2"/>
                </a:lnTo>
                <a:lnTo>
                  <a:pt x="183" y="111"/>
                </a:lnTo>
                <a:lnTo>
                  <a:pt x="181" y="120"/>
                </a:lnTo>
                <a:lnTo>
                  <a:pt x="177" y="128"/>
                </a:lnTo>
                <a:lnTo>
                  <a:pt x="173" y="137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3"/>
                </a:lnTo>
                <a:lnTo>
                  <a:pt x="144" y="169"/>
                </a:lnTo>
                <a:lnTo>
                  <a:pt x="136" y="174"/>
                </a:lnTo>
                <a:lnTo>
                  <a:pt x="128" y="178"/>
                </a:lnTo>
                <a:lnTo>
                  <a:pt x="119" y="180"/>
                </a:lnTo>
                <a:lnTo>
                  <a:pt x="112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5" y="183"/>
                </a:lnTo>
                <a:lnTo>
                  <a:pt x="66" y="180"/>
                </a:lnTo>
                <a:lnTo>
                  <a:pt x="57" y="178"/>
                </a:lnTo>
                <a:lnTo>
                  <a:pt x="49" y="174"/>
                </a:lnTo>
                <a:lnTo>
                  <a:pt x="41" y="169"/>
                </a:lnTo>
                <a:lnTo>
                  <a:pt x="34" y="163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7"/>
                </a:lnTo>
                <a:lnTo>
                  <a:pt x="8" y="128"/>
                </a:lnTo>
                <a:lnTo>
                  <a:pt x="4" y="120"/>
                </a:lnTo>
                <a:lnTo>
                  <a:pt x="3" y="111"/>
                </a:lnTo>
                <a:lnTo>
                  <a:pt x="2" y="102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6">
            <a:extLst>
              <a:ext uri="{FF2B5EF4-FFF2-40B4-BE49-F238E27FC236}">
                <a16:creationId xmlns:a16="http://schemas.microsoft.com/office/drawing/2014/main" id="{B781EDA2-5F73-40AE-A711-9610A6EE40A4}"/>
              </a:ext>
            </a:extLst>
          </p:cNvPr>
          <p:cNvSpPr>
            <a:spLocks/>
          </p:cNvSpPr>
          <p:nvPr/>
        </p:nvSpPr>
        <p:spPr bwMode="auto">
          <a:xfrm>
            <a:off x="7454577" y="2643774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4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8 h 184"/>
              <a:gd name="T10" fmla="*/ 41 w 185"/>
              <a:gd name="T11" fmla="*/ 16 h 184"/>
              <a:gd name="T12" fmla="*/ 57 w 185"/>
              <a:gd name="T13" fmla="*/ 7 h 184"/>
              <a:gd name="T14" fmla="*/ 75 w 185"/>
              <a:gd name="T15" fmla="*/ 2 h 184"/>
              <a:gd name="T16" fmla="*/ 92 w 185"/>
              <a:gd name="T17" fmla="*/ 0 h 184"/>
              <a:gd name="T18" fmla="*/ 101 w 185"/>
              <a:gd name="T19" fmla="*/ 1 h 184"/>
              <a:gd name="T20" fmla="*/ 119 w 185"/>
              <a:gd name="T21" fmla="*/ 5 h 184"/>
              <a:gd name="T22" fmla="*/ 136 w 185"/>
              <a:gd name="T23" fmla="*/ 11 h 184"/>
              <a:gd name="T24" fmla="*/ 151 w 185"/>
              <a:gd name="T25" fmla="*/ 21 h 184"/>
              <a:gd name="T26" fmla="*/ 164 w 185"/>
              <a:gd name="T27" fmla="*/ 34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1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9 h 184"/>
              <a:gd name="T46" fmla="*/ 128 w 185"/>
              <a:gd name="T47" fmla="*/ 178 h 184"/>
              <a:gd name="T48" fmla="*/ 112 w 185"/>
              <a:gd name="T49" fmla="*/ 183 h 184"/>
              <a:gd name="T50" fmla="*/ 92 w 185"/>
              <a:gd name="T51" fmla="*/ 184 h 184"/>
              <a:gd name="T52" fmla="*/ 83 w 185"/>
              <a:gd name="T53" fmla="*/ 184 h 184"/>
              <a:gd name="T54" fmla="*/ 66 w 185"/>
              <a:gd name="T55" fmla="*/ 180 h 184"/>
              <a:gd name="T56" fmla="*/ 49 w 185"/>
              <a:gd name="T57" fmla="*/ 174 h 184"/>
              <a:gd name="T58" fmla="*/ 34 w 185"/>
              <a:gd name="T59" fmla="*/ 163 h 184"/>
              <a:gd name="T60" fmla="*/ 22 w 185"/>
              <a:gd name="T61" fmla="*/ 151 h 184"/>
              <a:gd name="T62" fmla="*/ 12 w 185"/>
              <a:gd name="T63" fmla="*/ 137 h 184"/>
              <a:gd name="T64" fmla="*/ 4 w 185"/>
              <a:gd name="T65" fmla="*/ 120 h 184"/>
              <a:gd name="T66" fmla="*/ 2 w 185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4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4"/>
                </a:lnTo>
                <a:lnTo>
                  <a:pt x="27" y="28"/>
                </a:lnTo>
                <a:lnTo>
                  <a:pt x="34" y="21"/>
                </a:lnTo>
                <a:lnTo>
                  <a:pt x="41" y="16"/>
                </a:lnTo>
                <a:lnTo>
                  <a:pt x="49" y="11"/>
                </a:lnTo>
                <a:lnTo>
                  <a:pt x="57" y="7"/>
                </a:lnTo>
                <a:lnTo>
                  <a:pt x="66" y="5"/>
                </a:lnTo>
                <a:lnTo>
                  <a:pt x="75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2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4" y="16"/>
                </a:lnTo>
                <a:lnTo>
                  <a:pt x="151" y="21"/>
                </a:lnTo>
                <a:lnTo>
                  <a:pt x="158" y="28"/>
                </a:lnTo>
                <a:lnTo>
                  <a:pt x="164" y="34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4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2"/>
                </a:lnTo>
                <a:lnTo>
                  <a:pt x="183" y="111"/>
                </a:lnTo>
                <a:lnTo>
                  <a:pt x="181" y="120"/>
                </a:lnTo>
                <a:lnTo>
                  <a:pt x="177" y="128"/>
                </a:lnTo>
                <a:lnTo>
                  <a:pt x="173" y="137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3"/>
                </a:lnTo>
                <a:lnTo>
                  <a:pt x="144" y="169"/>
                </a:lnTo>
                <a:lnTo>
                  <a:pt x="136" y="174"/>
                </a:lnTo>
                <a:lnTo>
                  <a:pt x="128" y="178"/>
                </a:lnTo>
                <a:lnTo>
                  <a:pt x="119" y="180"/>
                </a:lnTo>
                <a:lnTo>
                  <a:pt x="112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5" y="183"/>
                </a:lnTo>
                <a:lnTo>
                  <a:pt x="66" y="180"/>
                </a:lnTo>
                <a:lnTo>
                  <a:pt x="57" y="178"/>
                </a:lnTo>
                <a:lnTo>
                  <a:pt x="49" y="174"/>
                </a:lnTo>
                <a:lnTo>
                  <a:pt x="41" y="169"/>
                </a:lnTo>
                <a:lnTo>
                  <a:pt x="34" y="163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7"/>
                </a:lnTo>
                <a:lnTo>
                  <a:pt x="8" y="128"/>
                </a:lnTo>
                <a:lnTo>
                  <a:pt x="4" y="120"/>
                </a:lnTo>
                <a:lnTo>
                  <a:pt x="3" y="111"/>
                </a:lnTo>
                <a:lnTo>
                  <a:pt x="2" y="102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7">
            <a:extLst>
              <a:ext uri="{FF2B5EF4-FFF2-40B4-BE49-F238E27FC236}">
                <a16:creationId xmlns:a16="http://schemas.microsoft.com/office/drawing/2014/main" id="{3B2B694A-E190-4CAE-8704-A19117ACCEF0}"/>
              </a:ext>
            </a:extLst>
          </p:cNvPr>
          <p:cNvSpPr>
            <a:spLocks/>
          </p:cNvSpPr>
          <p:nvPr/>
        </p:nvSpPr>
        <p:spPr bwMode="auto">
          <a:xfrm>
            <a:off x="6265540" y="19659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4 h 185"/>
              <a:gd name="T4" fmla="*/ 6 w 183"/>
              <a:gd name="T5" fmla="*/ 57 h 185"/>
              <a:gd name="T6" fmla="*/ 15 w 183"/>
              <a:gd name="T7" fmla="*/ 41 h 185"/>
              <a:gd name="T8" fmla="*/ 27 w 183"/>
              <a:gd name="T9" fmla="*/ 28 h 185"/>
              <a:gd name="T10" fmla="*/ 40 w 183"/>
              <a:gd name="T11" fmla="*/ 17 h 185"/>
              <a:gd name="T12" fmla="*/ 56 w 183"/>
              <a:gd name="T13" fmla="*/ 8 h 185"/>
              <a:gd name="T14" fmla="*/ 73 w 183"/>
              <a:gd name="T15" fmla="*/ 3 h 185"/>
              <a:gd name="T16" fmla="*/ 92 w 183"/>
              <a:gd name="T17" fmla="*/ 0 h 185"/>
              <a:gd name="T18" fmla="*/ 101 w 183"/>
              <a:gd name="T19" fmla="*/ 1 h 185"/>
              <a:gd name="T20" fmla="*/ 119 w 183"/>
              <a:gd name="T21" fmla="*/ 5 h 185"/>
              <a:gd name="T22" fmla="*/ 136 w 183"/>
              <a:gd name="T23" fmla="*/ 12 h 185"/>
              <a:gd name="T24" fmla="*/ 150 w 183"/>
              <a:gd name="T25" fmla="*/ 22 h 185"/>
              <a:gd name="T26" fmla="*/ 163 w 183"/>
              <a:gd name="T27" fmla="*/ 35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2 h 185"/>
              <a:gd name="T38" fmla="*/ 177 w 183"/>
              <a:gd name="T39" fmla="*/ 128 h 185"/>
              <a:gd name="T40" fmla="*/ 168 w 183"/>
              <a:gd name="T41" fmla="*/ 145 h 185"/>
              <a:gd name="T42" fmla="*/ 156 w 183"/>
              <a:gd name="T43" fmla="*/ 158 h 185"/>
              <a:gd name="T44" fmla="*/ 143 w 183"/>
              <a:gd name="T45" fmla="*/ 169 h 185"/>
              <a:gd name="T46" fmla="*/ 127 w 183"/>
              <a:gd name="T47" fmla="*/ 178 h 185"/>
              <a:gd name="T48" fmla="*/ 110 w 183"/>
              <a:gd name="T49" fmla="*/ 183 h 185"/>
              <a:gd name="T50" fmla="*/ 92 w 183"/>
              <a:gd name="T51" fmla="*/ 185 h 185"/>
              <a:gd name="T52" fmla="*/ 82 w 183"/>
              <a:gd name="T53" fmla="*/ 185 h 185"/>
              <a:gd name="T54" fmla="*/ 64 w 183"/>
              <a:gd name="T55" fmla="*/ 181 h 185"/>
              <a:gd name="T56" fmla="*/ 47 w 183"/>
              <a:gd name="T57" fmla="*/ 174 h 185"/>
              <a:gd name="T58" fmla="*/ 33 w 183"/>
              <a:gd name="T59" fmla="*/ 164 h 185"/>
              <a:gd name="T60" fmla="*/ 20 w 183"/>
              <a:gd name="T61" fmla="*/ 151 h 185"/>
              <a:gd name="T62" fmla="*/ 10 w 183"/>
              <a:gd name="T63" fmla="*/ 137 h 185"/>
              <a:gd name="T64" fmla="*/ 4 w 183"/>
              <a:gd name="T65" fmla="*/ 121 h 185"/>
              <a:gd name="T66" fmla="*/ 0 w 183"/>
              <a:gd name="T67" fmla="*/ 103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7"/>
                </a:lnTo>
                <a:lnTo>
                  <a:pt x="10" y="49"/>
                </a:lnTo>
                <a:lnTo>
                  <a:pt x="15" y="41"/>
                </a:lnTo>
                <a:lnTo>
                  <a:pt x="20" y="35"/>
                </a:lnTo>
                <a:lnTo>
                  <a:pt x="27" y="28"/>
                </a:lnTo>
                <a:lnTo>
                  <a:pt x="33" y="22"/>
                </a:lnTo>
                <a:lnTo>
                  <a:pt x="40" y="17"/>
                </a:lnTo>
                <a:lnTo>
                  <a:pt x="47" y="12"/>
                </a:lnTo>
                <a:lnTo>
                  <a:pt x="56" y="8"/>
                </a:lnTo>
                <a:lnTo>
                  <a:pt x="64" y="5"/>
                </a:lnTo>
                <a:lnTo>
                  <a:pt x="73" y="3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3"/>
                </a:lnTo>
                <a:lnTo>
                  <a:pt x="119" y="5"/>
                </a:lnTo>
                <a:lnTo>
                  <a:pt x="127" y="8"/>
                </a:lnTo>
                <a:lnTo>
                  <a:pt x="136" y="12"/>
                </a:lnTo>
                <a:lnTo>
                  <a:pt x="143" y="17"/>
                </a:lnTo>
                <a:lnTo>
                  <a:pt x="150" y="22"/>
                </a:lnTo>
                <a:lnTo>
                  <a:pt x="156" y="28"/>
                </a:lnTo>
                <a:lnTo>
                  <a:pt x="163" y="35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3"/>
                </a:lnTo>
                <a:lnTo>
                  <a:pt x="182" y="112"/>
                </a:lnTo>
                <a:lnTo>
                  <a:pt x="179" y="121"/>
                </a:lnTo>
                <a:lnTo>
                  <a:pt x="177" y="128"/>
                </a:lnTo>
                <a:lnTo>
                  <a:pt x="173" y="137"/>
                </a:lnTo>
                <a:lnTo>
                  <a:pt x="168" y="145"/>
                </a:lnTo>
                <a:lnTo>
                  <a:pt x="163" y="151"/>
                </a:lnTo>
                <a:lnTo>
                  <a:pt x="156" y="158"/>
                </a:lnTo>
                <a:lnTo>
                  <a:pt x="150" y="164"/>
                </a:lnTo>
                <a:lnTo>
                  <a:pt x="143" y="169"/>
                </a:lnTo>
                <a:lnTo>
                  <a:pt x="136" y="174"/>
                </a:lnTo>
                <a:lnTo>
                  <a:pt x="127" y="178"/>
                </a:lnTo>
                <a:lnTo>
                  <a:pt x="119" y="181"/>
                </a:lnTo>
                <a:lnTo>
                  <a:pt x="110" y="183"/>
                </a:lnTo>
                <a:lnTo>
                  <a:pt x="101" y="185"/>
                </a:lnTo>
                <a:lnTo>
                  <a:pt x="92" y="185"/>
                </a:lnTo>
                <a:lnTo>
                  <a:pt x="92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6" y="178"/>
                </a:lnTo>
                <a:lnTo>
                  <a:pt x="47" y="174"/>
                </a:lnTo>
                <a:lnTo>
                  <a:pt x="40" y="169"/>
                </a:lnTo>
                <a:lnTo>
                  <a:pt x="33" y="164"/>
                </a:lnTo>
                <a:lnTo>
                  <a:pt x="27" y="158"/>
                </a:lnTo>
                <a:lnTo>
                  <a:pt x="20" y="151"/>
                </a:lnTo>
                <a:lnTo>
                  <a:pt x="15" y="145"/>
                </a:lnTo>
                <a:lnTo>
                  <a:pt x="10" y="137"/>
                </a:lnTo>
                <a:lnTo>
                  <a:pt x="6" y="128"/>
                </a:lnTo>
                <a:lnTo>
                  <a:pt x="4" y="121"/>
                </a:lnTo>
                <a:lnTo>
                  <a:pt x="1" y="112"/>
                </a:lnTo>
                <a:lnTo>
                  <a:pt x="0" y="103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8">
            <a:extLst>
              <a:ext uri="{FF2B5EF4-FFF2-40B4-BE49-F238E27FC236}">
                <a16:creationId xmlns:a16="http://schemas.microsoft.com/office/drawing/2014/main" id="{5477040D-8342-4D78-AAF6-A6D6D2CEC799}"/>
              </a:ext>
            </a:extLst>
          </p:cNvPr>
          <p:cNvSpPr>
            <a:spLocks/>
          </p:cNvSpPr>
          <p:nvPr/>
        </p:nvSpPr>
        <p:spPr bwMode="auto">
          <a:xfrm>
            <a:off x="6265540" y="19659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4 h 185"/>
              <a:gd name="T4" fmla="*/ 6 w 183"/>
              <a:gd name="T5" fmla="*/ 57 h 185"/>
              <a:gd name="T6" fmla="*/ 15 w 183"/>
              <a:gd name="T7" fmla="*/ 41 h 185"/>
              <a:gd name="T8" fmla="*/ 27 w 183"/>
              <a:gd name="T9" fmla="*/ 28 h 185"/>
              <a:gd name="T10" fmla="*/ 40 w 183"/>
              <a:gd name="T11" fmla="*/ 17 h 185"/>
              <a:gd name="T12" fmla="*/ 56 w 183"/>
              <a:gd name="T13" fmla="*/ 8 h 185"/>
              <a:gd name="T14" fmla="*/ 73 w 183"/>
              <a:gd name="T15" fmla="*/ 3 h 185"/>
              <a:gd name="T16" fmla="*/ 92 w 183"/>
              <a:gd name="T17" fmla="*/ 0 h 185"/>
              <a:gd name="T18" fmla="*/ 101 w 183"/>
              <a:gd name="T19" fmla="*/ 1 h 185"/>
              <a:gd name="T20" fmla="*/ 119 w 183"/>
              <a:gd name="T21" fmla="*/ 5 h 185"/>
              <a:gd name="T22" fmla="*/ 136 w 183"/>
              <a:gd name="T23" fmla="*/ 12 h 185"/>
              <a:gd name="T24" fmla="*/ 150 w 183"/>
              <a:gd name="T25" fmla="*/ 22 h 185"/>
              <a:gd name="T26" fmla="*/ 163 w 183"/>
              <a:gd name="T27" fmla="*/ 35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2 h 185"/>
              <a:gd name="T38" fmla="*/ 177 w 183"/>
              <a:gd name="T39" fmla="*/ 128 h 185"/>
              <a:gd name="T40" fmla="*/ 168 w 183"/>
              <a:gd name="T41" fmla="*/ 145 h 185"/>
              <a:gd name="T42" fmla="*/ 156 w 183"/>
              <a:gd name="T43" fmla="*/ 158 h 185"/>
              <a:gd name="T44" fmla="*/ 143 w 183"/>
              <a:gd name="T45" fmla="*/ 169 h 185"/>
              <a:gd name="T46" fmla="*/ 127 w 183"/>
              <a:gd name="T47" fmla="*/ 178 h 185"/>
              <a:gd name="T48" fmla="*/ 110 w 183"/>
              <a:gd name="T49" fmla="*/ 183 h 185"/>
              <a:gd name="T50" fmla="*/ 92 w 183"/>
              <a:gd name="T51" fmla="*/ 185 h 185"/>
              <a:gd name="T52" fmla="*/ 82 w 183"/>
              <a:gd name="T53" fmla="*/ 185 h 185"/>
              <a:gd name="T54" fmla="*/ 64 w 183"/>
              <a:gd name="T55" fmla="*/ 181 h 185"/>
              <a:gd name="T56" fmla="*/ 47 w 183"/>
              <a:gd name="T57" fmla="*/ 174 h 185"/>
              <a:gd name="T58" fmla="*/ 33 w 183"/>
              <a:gd name="T59" fmla="*/ 164 h 185"/>
              <a:gd name="T60" fmla="*/ 20 w 183"/>
              <a:gd name="T61" fmla="*/ 151 h 185"/>
              <a:gd name="T62" fmla="*/ 10 w 183"/>
              <a:gd name="T63" fmla="*/ 137 h 185"/>
              <a:gd name="T64" fmla="*/ 4 w 183"/>
              <a:gd name="T65" fmla="*/ 121 h 185"/>
              <a:gd name="T66" fmla="*/ 0 w 183"/>
              <a:gd name="T67" fmla="*/ 103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7"/>
                </a:lnTo>
                <a:lnTo>
                  <a:pt x="10" y="49"/>
                </a:lnTo>
                <a:lnTo>
                  <a:pt x="15" y="41"/>
                </a:lnTo>
                <a:lnTo>
                  <a:pt x="20" y="35"/>
                </a:lnTo>
                <a:lnTo>
                  <a:pt x="27" y="28"/>
                </a:lnTo>
                <a:lnTo>
                  <a:pt x="33" y="22"/>
                </a:lnTo>
                <a:lnTo>
                  <a:pt x="40" y="17"/>
                </a:lnTo>
                <a:lnTo>
                  <a:pt x="47" y="12"/>
                </a:lnTo>
                <a:lnTo>
                  <a:pt x="56" y="8"/>
                </a:lnTo>
                <a:lnTo>
                  <a:pt x="64" y="5"/>
                </a:lnTo>
                <a:lnTo>
                  <a:pt x="73" y="3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3"/>
                </a:lnTo>
                <a:lnTo>
                  <a:pt x="119" y="5"/>
                </a:lnTo>
                <a:lnTo>
                  <a:pt x="127" y="8"/>
                </a:lnTo>
                <a:lnTo>
                  <a:pt x="136" y="12"/>
                </a:lnTo>
                <a:lnTo>
                  <a:pt x="143" y="17"/>
                </a:lnTo>
                <a:lnTo>
                  <a:pt x="150" y="22"/>
                </a:lnTo>
                <a:lnTo>
                  <a:pt x="156" y="28"/>
                </a:lnTo>
                <a:lnTo>
                  <a:pt x="163" y="35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3"/>
                </a:lnTo>
                <a:lnTo>
                  <a:pt x="182" y="112"/>
                </a:lnTo>
                <a:lnTo>
                  <a:pt x="179" y="121"/>
                </a:lnTo>
                <a:lnTo>
                  <a:pt x="177" y="128"/>
                </a:lnTo>
                <a:lnTo>
                  <a:pt x="173" y="137"/>
                </a:lnTo>
                <a:lnTo>
                  <a:pt x="168" y="145"/>
                </a:lnTo>
                <a:lnTo>
                  <a:pt x="163" y="151"/>
                </a:lnTo>
                <a:lnTo>
                  <a:pt x="156" y="158"/>
                </a:lnTo>
                <a:lnTo>
                  <a:pt x="150" y="164"/>
                </a:lnTo>
                <a:lnTo>
                  <a:pt x="143" y="169"/>
                </a:lnTo>
                <a:lnTo>
                  <a:pt x="136" y="174"/>
                </a:lnTo>
                <a:lnTo>
                  <a:pt x="127" y="178"/>
                </a:lnTo>
                <a:lnTo>
                  <a:pt x="119" y="181"/>
                </a:lnTo>
                <a:lnTo>
                  <a:pt x="110" y="183"/>
                </a:lnTo>
                <a:lnTo>
                  <a:pt x="101" y="185"/>
                </a:lnTo>
                <a:lnTo>
                  <a:pt x="92" y="185"/>
                </a:lnTo>
                <a:lnTo>
                  <a:pt x="92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6" y="178"/>
                </a:lnTo>
                <a:lnTo>
                  <a:pt x="47" y="174"/>
                </a:lnTo>
                <a:lnTo>
                  <a:pt x="40" y="169"/>
                </a:lnTo>
                <a:lnTo>
                  <a:pt x="33" y="164"/>
                </a:lnTo>
                <a:lnTo>
                  <a:pt x="27" y="158"/>
                </a:lnTo>
                <a:lnTo>
                  <a:pt x="20" y="151"/>
                </a:lnTo>
                <a:lnTo>
                  <a:pt x="15" y="145"/>
                </a:lnTo>
                <a:lnTo>
                  <a:pt x="10" y="137"/>
                </a:lnTo>
                <a:lnTo>
                  <a:pt x="6" y="128"/>
                </a:lnTo>
                <a:lnTo>
                  <a:pt x="4" y="121"/>
                </a:lnTo>
                <a:lnTo>
                  <a:pt x="1" y="112"/>
                </a:lnTo>
                <a:lnTo>
                  <a:pt x="0" y="103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29">
            <a:extLst>
              <a:ext uri="{FF2B5EF4-FFF2-40B4-BE49-F238E27FC236}">
                <a16:creationId xmlns:a16="http://schemas.microsoft.com/office/drawing/2014/main" id="{29342B8A-8D60-4453-9DFB-6F0CC2C3DD33}"/>
              </a:ext>
            </a:extLst>
          </p:cNvPr>
          <p:cNvSpPr>
            <a:spLocks/>
          </p:cNvSpPr>
          <p:nvPr/>
        </p:nvSpPr>
        <p:spPr bwMode="auto">
          <a:xfrm>
            <a:off x="6265540" y="19659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4 h 185"/>
              <a:gd name="T4" fmla="*/ 6 w 183"/>
              <a:gd name="T5" fmla="*/ 57 h 185"/>
              <a:gd name="T6" fmla="*/ 15 w 183"/>
              <a:gd name="T7" fmla="*/ 41 h 185"/>
              <a:gd name="T8" fmla="*/ 27 w 183"/>
              <a:gd name="T9" fmla="*/ 28 h 185"/>
              <a:gd name="T10" fmla="*/ 40 w 183"/>
              <a:gd name="T11" fmla="*/ 17 h 185"/>
              <a:gd name="T12" fmla="*/ 56 w 183"/>
              <a:gd name="T13" fmla="*/ 8 h 185"/>
              <a:gd name="T14" fmla="*/ 73 w 183"/>
              <a:gd name="T15" fmla="*/ 3 h 185"/>
              <a:gd name="T16" fmla="*/ 92 w 183"/>
              <a:gd name="T17" fmla="*/ 0 h 185"/>
              <a:gd name="T18" fmla="*/ 101 w 183"/>
              <a:gd name="T19" fmla="*/ 1 h 185"/>
              <a:gd name="T20" fmla="*/ 119 w 183"/>
              <a:gd name="T21" fmla="*/ 5 h 185"/>
              <a:gd name="T22" fmla="*/ 136 w 183"/>
              <a:gd name="T23" fmla="*/ 12 h 185"/>
              <a:gd name="T24" fmla="*/ 150 w 183"/>
              <a:gd name="T25" fmla="*/ 22 h 185"/>
              <a:gd name="T26" fmla="*/ 163 w 183"/>
              <a:gd name="T27" fmla="*/ 35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2 h 185"/>
              <a:gd name="T38" fmla="*/ 177 w 183"/>
              <a:gd name="T39" fmla="*/ 128 h 185"/>
              <a:gd name="T40" fmla="*/ 168 w 183"/>
              <a:gd name="T41" fmla="*/ 145 h 185"/>
              <a:gd name="T42" fmla="*/ 156 w 183"/>
              <a:gd name="T43" fmla="*/ 158 h 185"/>
              <a:gd name="T44" fmla="*/ 143 w 183"/>
              <a:gd name="T45" fmla="*/ 169 h 185"/>
              <a:gd name="T46" fmla="*/ 127 w 183"/>
              <a:gd name="T47" fmla="*/ 178 h 185"/>
              <a:gd name="T48" fmla="*/ 110 w 183"/>
              <a:gd name="T49" fmla="*/ 183 h 185"/>
              <a:gd name="T50" fmla="*/ 92 w 183"/>
              <a:gd name="T51" fmla="*/ 185 h 185"/>
              <a:gd name="T52" fmla="*/ 82 w 183"/>
              <a:gd name="T53" fmla="*/ 185 h 185"/>
              <a:gd name="T54" fmla="*/ 64 w 183"/>
              <a:gd name="T55" fmla="*/ 181 h 185"/>
              <a:gd name="T56" fmla="*/ 47 w 183"/>
              <a:gd name="T57" fmla="*/ 174 h 185"/>
              <a:gd name="T58" fmla="*/ 33 w 183"/>
              <a:gd name="T59" fmla="*/ 164 h 185"/>
              <a:gd name="T60" fmla="*/ 20 w 183"/>
              <a:gd name="T61" fmla="*/ 151 h 185"/>
              <a:gd name="T62" fmla="*/ 10 w 183"/>
              <a:gd name="T63" fmla="*/ 137 h 185"/>
              <a:gd name="T64" fmla="*/ 4 w 183"/>
              <a:gd name="T65" fmla="*/ 121 h 185"/>
              <a:gd name="T66" fmla="*/ 0 w 183"/>
              <a:gd name="T67" fmla="*/ 103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7"/>
                </a:lnTo>
                <a:lnTo>
                  <a:pt x="10" y="49"/>
                </a:lnTo>
                <a:lnTo>
                  <a:pt x="15" y="41"/>
                </a:lnTo>
                <a:lnTo>
                  <a:pt x="20" y="35"/>
                </a:lnTo>
                <a:lnTo>
                  <a:pt x="27" y="28"/>
                </a:lnTo>
                <a:lnTo>
                  <a:pt x="33" y="22"/>
                </a:lnTo>
                <a:lnTo>
                  <a:pt x="40" y="17"/>
                </a:lnTo>
                <a:lnTo>
                  <a:pt x="47" y="12"/>
                </a:lnTo>
                <a:lnTo>
                  <a:pt x="56" y="8"/>
                </a:lnTo>
                <a:lnTo>
                  <a:pt x="64" y="5"/>
                </a:lnTo>
                <a:lnTo>
                  <a:pt x="73" y="3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3"/>
                </a:lnTo>
                <a:lnTo>
                  <a:pt x="119" y="5"/>
                </a:lnTo>
                <a:lnTo>
                  <a:pt x="127" y="8"/>
                </a:lnTo>
                <a:lnTo>
                  <a:pt x="136" y="12"/>
                </a:lnTo>
                <a:lnTo>
                  <a:pt x="143" y="17"/>
                </a:lnTo>
                <a:lnTo>
                  <a:pt x="150" y="22"/>
                </a:lnTo>
                <a:lnTo>
                  <a:pt x="156" y="28"/>
                </a:lnTo>
                <a:lnTo>
                  <a:pt x="163" y="35"/>
                </a:lnTo>
                <a:lnTo>
                  <a:pt x="168" y="41"/>
                </a:lnTo>
                <a:lnTo>
                  <a:pt x="173" y="49"/>
                </a:lnTo>
                <a:lnTo>
                  <a:pt x="177" y="57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3"/>
                </a:lnTo>
                <a:lnTo>
                  <a:pt x="182" y="112"/>
                </a:lnTo>
                <a:lnTo>
                  <a:pt x="179" y="121"/>
                </a:lnTo>
                <a:lnTo>
                  <a:pt x="177" y="128"/>
                </a:lnTo>
                <a:lnTo>
                  <a:pt x="173" y="137"/>
                </a:lnTo>
                <a:lnTo>
                  <a:pt x="168" y="145"/>
                </a:lnTo>
                <a:lnTo>
                  <a:pt x="163" y="151"/>
                </a:lnTo>
                <a:lnTo>
                  <a:pt x="156" y="158"/>
                </a:lnTo>
                <a:lnTo>
                  <a:pt x="150" y="164"/>
                </a:lnTo>
                <a:lnTo>
                  <a:pt x="143" y="169"/>
                </a:lnTo>
                <a:lnTo>
                  <a:pt x="136" y="174"/>
                </a:lnTo>
                <a:lnTo>
                  <a:pt x="127" y="178"/>
                </a:lnTo>
                <a:lnTo>
                  <a:pt x="119" y="181"/>
                </a:lnTo>
                <a:lnTo>
                  <a:pt x="110" y="183"/>
                </a:lnTo>
                <a:lnTo>
                  <a:pt x="101" y="185"/>
                </a:lnTo>
                <a:lnTo>
                  <a:pt x="92" y="185"/>
                </a:lnTo>
                <a:lnTo>
                  <a:pt x="92" y="185"/>
                </a:lnTo>
                <a:lnTo>
                  <a:pt x="82" y="185"/>
                </a:lnTo>
                <a:lnTo>
                  <a:pt x="73" y="183"/>
                </a:lnTo>
                <a:lnTo>
                  <a:pt x="64" y="181"/>
                </a:lnTo>
                <a:lnTo>
                  <a:pt x="56" y="178"/>
                </a:lnTo>
                <a:lnTo>
                  <a:pt x="47" y="174"/>
                </a:lnTo>
                <a:lnTo>
                  <a:pt x="40" y="169"/>
                </a:lnTo>
                <a:lnTo>
                  <a:pt x="33" y="164"/>
                </a:lnTo>
                <a:lnTo>
                  <a:pt x="27" y="158"/>
                </a:lnTo>
                <a:lnTo>
                  <a:pt x="20" y="151"/>
                </a:lnTo>
                <a:lnTo>
                  <a:pt x="15" y="145"/>
                </a:lnTo>
                <a:lnTo>
                  <a:pt x="10" y="137"/>
                </a:lnTo>
                <a:lnTo>
                  <a:pt x="6" y="128"/>
                </a:lnTo>
                <a:lnTo>
                  <a:pt x="4" y="121"/>
                </a:lnTo>
                <a:lnTo>
                  <a:pt x="1" y="112"/>
                </a:lnTo>
                <a:lnTo>
                  <a:pt x="0" y="103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0">
            <a:extLst>
              <a:ext uri="{FF2B5EF4-FFF2-40B4-BE49-F238E27FC236}">
                <a16:creationId xmlns:a16="http://schemas.microsoft.com/office/drawing/2014/main" id="{C8CB245D-3421-4B49-A299-AE58AD58FD7A}"/>
              </a:ext>
            </a:extLst>
          </p:cNvPr>
          <p:cNvSpPr>
            <a:spLocks/>
          </p:cNvSpPr>
          <p:nvPr/>
        </p:nvSpPr>
        <p:spPr bwMode="auto">
          <a:xfrm>
            <a:off x="4911402" y="2202449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5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0 h 184"/>
              <a:gd name="T20" fmla="*/ 119 w 183"/>
              <a:gd name="T21" fmla="*/ 4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3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0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2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3 h 184"/>
              <a:gd name="T58" fmla="*/ 33 w 183"/>
              <a:gd name="T59" fmla="*/ 162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19 h 184"/>
              <a:gd name="T66" fmla="*/ 0 w 183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5"/>
                </a:lnTo>
                <a:lnTo>
                  <a:pt x="47" y="11"/>
                </a:lnTo>
                <a:lnTo>
                  <a:pt x="56" y="7"/>
                </a:lnTo>
                <a:lnTo>
                  <a:pt x="64" y="4"/>
                </a:lnTo>
                <a:lnTo>
                  <a:pt x="73" y="2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5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2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2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2"/>
                </a:lnTo>
                <a:lnTo>
                  <a:pt x="64" y="180"/>
                </a:lnTo>
                <a:lnTo>
                  <a:pt x="56" y="176"/>
                </a:lnTo>
                <a:lnTo>
                  <a:pt x="47" y="173"/>
                </a:lnTo>
                <a:lnTo>
                  <a:pt x="40" y="169"/>
                </a:lnTo>
                <a:lnTo>
                  <a:pt x="33" y="162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1">
            <a:extLst>
              <a:ext uri="{FF2B5EF4-FFF2-40B4-BE49-F238E27FC236}">
                <a16:creationId xmlns:a16="http://schemas.microsoft.com/office/drawing/2014/main" id="{A580590F-93F0-42D9-A3A2-C8C224CD7F02}"/>
              </a:ext>
            </a:extLst>
          </p:cNvPr>
          <p:cNvSpPr>
            <a:spLocks/>
          </p:cNvSpPr>
          <p:nvPr/>
        </p:nvSpPr>
        <p:spPr bwMode="auto">
          <a:xfrm>
            <a:off x="4911402" y="2202449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5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0 h 184"/>
              <a:gd name="T20" fmla="*/ 119 w 183"/>
              <a:gd name="T21" fmla="*/ 4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3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0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2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3 h 184"/>
              <a:gd name="T58" fmla="*/ 33 w 183"/>
              <a:gd name="T59" fmla="*/ 162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19 h 184"/>
              <a:gd name="T66" fmla="*/ 0 w 183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5"/>
                </a:lnTo>
                <a:lnTo>
                  <a:pt x="47" y="11"/>
                </a:lnTo>
                <a:lnTo>
                  <a:pt x="56" y="7"/>
                </a:lnTo>
                <a:lnTo>
                  <a:pt x="64" y="4"/>
                </a:lnTo>
                <a:lnTo>
                  <a:pt x="73" y="2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5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2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2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2"/>
                </a:lnTo>
                <a:lnTo>
                  <a:pt x="64" y="180"/>
                </a:lnTo>
                <a:lnTo>
                  <a:pt x="56" y="176"/>
                </a:lnTo>
                <a:lnTo>
                  <a:pt x="47" y="173"/>
                </a:lnTo>
                <a:lnTo>
                  <a:pt x="40" y="169"/>
                </a:lnTo>
                <a:lnTo>
                  <a:pt x="33" y="162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2">
            <a:extLst>
              <a:ext uri="{FF2B5EF4-FFF2-40B4-BE49-F238E27FC236}">
                <a16:creationId xmlns:a16="http://schemas.microsoft.com/office/drawing/2014/main" id="{ECCFD5B8-42BF-47BA-B2CD-43979D1F8719}"/>
              </a:ext>
            </a:extLst>
          </p:cNvPr>
          <p:cNvSpPr>
            <a:spLocks/>
          </p:cNvSpPr>
          <p:nvPr/>
        </p:nvSpPr>
        <p:spPr bwMode="auto">
          <a:xfrm>
            <a:off x="4911402" y="2202449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5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0 h 184"/>
              <a:gd name="T20" fmla="*/ 119 w 183"/>
              <a:gd name="T21" fmla="*/ 4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3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0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2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3 h 184"/>
              <a:gd name="T58" fmla="*/ 33 w 183"/>
              <a:gd name="T59" fmla="*/ 162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19 h 184"/>
              <a:gd name="T66" fmla="*/ 0 w 183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5"/>
                </a:lnTo>
                <a:lnTo>
                  <a:pt x="47" y="11"/>
                </a:lnTo>
                <a:lnTo>
                  <a:pt x="56" y="7"/>
                </a:lnTo>
                <a:lnTo>
                  <a:pt x="64" y="4"/>
                </a:lnTo>
                <a:lnTo>
                  <a:pt x="73" y="2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5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2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2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2"/>
                </a:lnTo>
                <a:lnTo>
                  <a:pt x="64" y="180"/>
                </a:lnTo>
                <a:lnTo>
                  <a:pt x="56" y="176"/>
                </a:lnTo>
                <a:lnTo>
                  <a:pt x="47" y="173"/>
                </a:lnTo>
                <a:lnTo>
                  <a:pt x="40" y="169"/>
                </a:lnTo>
                <a:lnTo>
                  <a:pt x="33" y="162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3">
            <a:extLst>
              <a:ext uri="{FF2B5EF4-FFF2-40B4-BE49-F238E27FC236}">
                <a16:creationId xmlns:a16="http://schemas.microsoft.com/office/drawing/2014/main" id="{F83E5A84-319D-463A-BC99-26B6301A9661}"/>
              </a:ext>
            </a:extLst>
          </p:cNvPr>
          <p:cNvSpPr>
            <a:spLocks/>
          </p:cNvSpPr>
          <p:nvPr/>
        </p:nvSpPr>
        <p:spPr bwMode="auto">
          <a:xfrm>
            <a:off x="4027165" y="3239087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7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4 h 184"/>
              <a:gd name="T22" fmla="*/ 136 w 184"/>
              <a:gd name="T23" fmla="*/ 11 h 184"/>
              <a:gd name="T24" fmla="*/ 151 w 184"/>
              <a:gd name="T25" fmla="*/ 22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3 h 184"/>
              <a:gd name="T58" fmla="*/ 33 w 184"/>
              <a:gd name="T59" fmla="*/ 164 h 184"/>
              <a:gd name="T60" fmla="*/ 20 w 184"/>
              <a:gd name="T61" fmla="*/ 151 h 184"/>
              <a:gd name="T62" fmla="*/ 11 w 184"/>
              <a:gd name="T63" fmla="*/ 136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2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4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2"/>
                </a:lnTo>
                <a:lnTo>
                  <a:pt x="157" y="27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6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4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3"/>
                </a:lnTo>
                <a:lnTo>
                  <a:pt x="41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4">
            <a:extLst>
              <a:ext uri="{FF2B5EF4-FFF2-40B4-BE49-F238E27FC236}">
                <a16:creationId xmlns:a16="http://schemas.microsoft.com/office/drawing/2014/main" id="{D3903074-D453-4010-B36A-C86E5A0DDA0C}"/>
              </a:ext>
            </a:extLst>
          </p:cNvPr>
          <p:cNvSpPr>
            <a:spLocks/>
          </p:cNvSpPr>
          <p:nvPr/>
        </p:nvSpPr>
        <p:spPr bwMode="auto">
          <a:xfrm>
            <a:off x="4027165" y="3239087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7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4 h 184"/>
              <a:gd name="T22" fmla="*/ 136 w 184"/>
              <a:gd name="T23" fmla="*/ 11 h 184"/>
              <a:gd name="T24" fmla="*/ 151 w 184"/>
              <a:gd name="T25" fmla="*/ 22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3 h 184"/>
              <a:gd name="T58" fmla="*/ 33 w 184"/>
              <a:gd name="T59" fmla="*/ 164 h 184"/>
              <a:gd name="T60" fmla="*/ 20 w 184"/>
              <a:gd name="T61" fmla="*/ 151 h 184"/>
              <a:gd name="T62" fmla="*/ 11 w 184"/>
              <a:gd name="T63" fmla="*/ 136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2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4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2"/>
                </a:lnTo>
                <a:lnTo>
                  <a:pt x="157" y="27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6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4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3"/>
                </a:lnTo>
                <a:lnTo>
                  <a:pt x="41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Freeform 35">
            <a:extLst>
              <a:ext uri="{FF2B5EF4-FFF2-40B4-BE49-F238E27FC236}">
                <a16:creationId xmlns:a16="http://schemas.microsoft.com/office/drawing/2014/main" id="{24784579-774A-4822-B107-40F0BA9A4A8A}"/>
              </a:ext>
            </a:extLst>
          </p:cNvPr>
          <p:cNvSpPr>
            <a:spLocks/>
          </p:cNvSpPr>
          <p:nvPr/>
        </p:nvSpPr>
        <p:spPr bwMode="auto">
          <a:xfrm>
            <a:off x="4027165" y="3239087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7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4 h 184"/>
              <a:gd name="T22" fmla="*/ 136 w 184"/>
              <a:gd name="T23" fmla="*/ 11 h 184"/>
              <a:gd name="T24" fmla="*/ 151 w 184"/>
              <a:gd name="T25" fmla="*/ 22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3 h 184"/>
              <a:gd name="T58" fmla="*/ 33 w 184"/>
              <a:gd name="T59" fmla="*/ 164 h 184"/>
              <a:gd name="T60" fmla="*/ 20 w 184"/>
              <a:gd name="T61" fmla="*/ 151 h 184"/>
              <a:gd name="T62" fmla="*/ 11 w 184"/>
              <a:gd name="T63" fmla="*/ 136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2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4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2"/>
                </a:lnTo>
                <a:lnTo>
                  <a:pt x="157" y="27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6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4"/>
                </a:lnTo>
                <a:lnTo>
                  <a:pt x="143" y="169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3"/>
                </a:lnTo>
                <a:lnTo>
                  <a:pt x="41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6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Freeform 36">
            <a:extLst>
              <a:ext uri="{FF2B5EF4-FFF2-40B4-BE49-F238E27FC236}">
                <a16:creationId xmlns:a16="http://schemas.microsoft.com/office/drawing/2014/main" id="{F6E0E94F-3A65-4CB0-9361-43E1E61BCCF7}"/>
              </a:ext>
            </a:extLst>
          </p:cNvPr>
          <p:cNvSpPr>
            <a:spLocks/>
          </p:cNvSpPr>
          <p:nvPr/>
        </p:nvSpPr>
        <p:spPr bwMode="auto">
          <a:xfrm>
            <a:off x="4027165" y="4593224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6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3 h 184"/>
              <a:gd name="T22" fmla="*/ 136 w 184"/>
              <a:gd name="T23" fmla="*/ 11 h 184"/>
              <a:gd name="T24" fmla="*/ 151 w 184"/>
              <a:gd name="T25" fmla="*/ 21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2 h 184"/>
              <a:gd name="T58" fmla="*/ 33 w 184"/>
              <a:gd name="T59" fmla="*/ 163 h 184"/>
              <a:gd name="T60" fmla="*/ 20 w 184"/>
              <a:gd name="T61" fmla="*/ 151 h 184"/>
              <a:gd name="T62" fmla="*/ 11 w 184"/>
              <a:gd name="T63" fmla="*/ 135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6"/>
                </a:lnTo>
                <a:lnTo>
                  <a:pt x="33" y="21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3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3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1"/>
                </a:lnTo>
                <a:lnTo>
                  <a:pt x="157" y="26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5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3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2"/>
                </a:lnTo>
                <a:lnTo>
                  <a:pt x="41" y="169"/>
                </a:lnTo>
                <a:lnTo>
                  <a:pt x="33" y="163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5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Freeform 37">
            <a:extLst>
              <a:ext uri="{FF2B5EF4-FFF2-40B4-BE49-F238E27FC236}">
                <a16:creationId xmlns:a16="http://schemas.microsoft.com/office/drawing/2014/main" id="{B2062433-DEE7-4670-B73D-FA7838915DB4}"/>
              </a:ext>
            </a:extLst>
          </p:cNvPr>
          <p:cNvSpPr>
            <a:spLocks/>
          </p:cNvSpPr>
          <p:nvPr/>
        </p:nvSpPr>
        <p:spPr bwMode="auto">
          <a:xfrm>
            <a:off x="4027165" y="4593224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6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3 h 184"/>
              <a:gd name="T22" fmla="*/ 136 w 184"/>
              <a:gd name="T23" fmla="*/ 11 h 184"/>
              <a:gd name="T24" fmla="*/ 151 w 184"/>
              <a:gd name="T25" fmla="*/ 21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2 h 184"/>
              <a:gd name="T58" fmla="*/ 33 w 184"/>
              <a:gd name="T59" fmla="*/ 163 h 184"/>
              <a:gd name="T60" fmla="*/ 20 w 184"/>
              <a:gd name="T61" fmla="*/ 151 h 184"/>
              <a:gd name="T62" fmla="*/ 11 w 184"/>
              <a:gd name="T63" fmla="*/ 135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6"/>
                </a:lnTo>
                <a:lnTo>
                  <a:pt x="33" y="21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3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3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1"/>
                </a:lnTo>
                <a:lnTo>
                  <a:pt x="157" y="26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5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3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2"/>
                </a:lnTo>
                <a:lnTo>
                  <a:pt x="41" y="169"/>
                </a:lnTo>
                <a:lnTo>
                  <a:pt x="33" y="163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5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Freeform 38">
            <a:extLst>
              <a:ext uri="{FF2B5EF4-FFF2-40B4-BE49-F238E27FC236}">
                <a16:creationId xmlns:a16="http://schemas.microsoft.com/office/drawing/2014/main" id="{9A53D81D-0E48-49B5-B2FE-730D9E5F7835}"/>
              </a:ext>
            </a:extLst>
          </p:cNvPr>
          <p:cNvSpPr>
            <a:spLocks/>
          </p:cNvSpPr>
          <p:nvPr/>
        </p:nvSpPr>
        <p:spPr bwMode="auto">
          <a:xfrm>
            <a:off x="4027165" y="4593224"/>
            <a:ext cx="292100" cy="292100"/>
          </a:xfrm>
          <a:custGeom>
            <a:avLst/>
            <a:gdLst>
              <a:gd name="T0" fmla="*/ 0 w 184"/>
              <a:gd name="T1" fmla="*/ 92 h 184"/>
              <a:gd name="T2" fmla="*/ 1 w 184"/>
              <a:gd name="T3" fmla="*/ 74 h 184"/>
              <a:gd name="T4" fmla="*/ 7 w 184"/>
              <a:gd name="T5" fmla="*/ 56 h 184"/>
              <a:gd name="T6" fmla="*/ 15 w 184"/>
              <a:gd name="T7" fmla="*/ 41 h 184"/>
              <a:gd name="T8" fmla="*/ 27 w 184"/>
              <a:gd name="T9" fmla="*/ 26 h 184"/>
              <a:gd name="T10" fmla="*/ 41 w 184"/>
              <a:gd name="T11" fmla="*/ 16 h 184"/>
              <a:gd name="T12" fmla="*/ 56 w 184"/>
              <a:gd name="T13" fmla="*/ 7 h 184"/>
              <a:gd name="T14" fmla="*/ 73 w 184"/>
              <a:gd name="T15" fmla="*/ 2 h 184"/>
              <a:gd name="T16" fmla="*/ 92 w 184"/>
              <a:gd name="T17" fmla="*/ 0 h 184"/>
              <a:gd name="T18" fmla="*/ 101 w 184"/>
              <a:gd name="T19" fmla="*/ 1 h 184"/>
              <a:gd name="T20" fmla="*/ 119 w 184"/>
              <a:gd name="T21" fmla="*/ 3 h 184"/>
              <a:gd name="T22" fmla="*/ 136 w 184"/>
              <a:gd name="T23" fmla="*/ 11 h 184"/>
              <a:gd name="T24" fmla="*/ 151 w 184"/>
              <a:gd name="T25" fmla="*/ 21 h 184"/>
              <a:gd name="T26" fmla="*/ 162 w 184"/>
              <a:gd name="T27" fmla="*/ 33 h 184"/>
              <a:gd name="T28" fmla="*/ 173 w 184"/>
              <a:gd name="T29" fmla="*/ 48 h 184"/>
              <a:gd name="T30" fmla="*/ 180 w 184"/>
              <a:gd name="T31" fmla="*/ 65 h 184"/>
              <a:gd name="T32" fmla="*/ 183 w 184"/>
              <a:gd name="T33" fmla="*/ 83 h 184"/>
              <a:gd name="T34" fmla="*/ 184 w 184"/>
              <a:gd name="T35" fmla="*/ 92 h 184"/>
              <a:gd name="T36" fmla="*/ 182 w 184"/>
              <a:gd name="T37" fmla="*/ 111 h 184"/>
              <a:gd name="T38" fmla="*/ 176 w 184"/>
              <a:gd name="T39" fmla="*/ 128 h 184"/>
              <a:gd name="T40" fmla="*/ 169 w 184"/>
              <a:gd name="T41" fmla="*/ 143 h 184"/>
              <a:gd name="T42" fmla="*/ 157 w 184"/>
              <a:gd name="T43" fmla="*/ 157 h 184"/>
              <a:gd name="T44" fmla="*/ 143 w 184"/>
              <a:gd name="T45" fmla="*/ 169 h 184"/>
              <a:gd name="T46" fmla="*/ 128 w 184"/>
              <a:gd name="T47" fmla="*/ 176 h 184"/>
              <a:gd name="T48" fmla="*/ 110 w 184"/>
              <a:gd name="T49" fmla="*/ 183 h 184"/>
              <a:gd name="T50" fmla="*/ 92 w 184"/>
              <a:gd name="T51" fmla="*/ 184 h 184"/>
              <a:gd name="T52" fmla="*/ 83 w 184"/>
              <a:gd name="T53" fmla="*/ 184 h 184"/>
              <a:gd name="T54" fmla="*/ 65 w 184"/>
              <a:gd name="T55" fmla="*/ 180 h 184"/>
              <a:gd name="T56" fmla="*/ 48 w 184"/>
              <a:gd name="T57" fmla="*/ 172 h 184"/>
              <a:gd name="T58" fmla="*/ 33 w 184"/>
              <a:gd name="T59" fmla="*/ 163 h 184"/>
              <a:gd name="T60" fmla="*/ 20 w 184"/>
              <a:gd name="T61" fmla="*/ 151 h 184"/>
              <a:gd name="T62" fmla="*/ 11 w 184"/>
              <a:gd name="T63" fmla="*/ 135 h 184"/>
              <a:gd name="T64" fmla="*/ 4 w 184"/>
              <a:gd name="T65" fmla="*/ 119 h 184"/>
              <a:gd name="T66" fmla="*/ 0 w 184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4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7" y="56"/>
                </a:lnTo>
                <a:lnTo>
                  <a:pt x="11" y="48"/>
                </a:lnTo>
                <a:lnTo>
                  <a:pt x="15" y="41"/>
                </a:lnTo>
                <a:lnTo>
                  <a:pt x="20" y="33"/>
                </a:lnTo>
                <a:lnTo>
                  <a:pt x="27" y="26"/>
                </a:lnTo>
                <a:lnTo>
                  <a:pt x="33" y="21"/>
                </a:lnTo>
                <a:lnTo>
                  <a:pt x="41" y="16"/>
                </a:lnTo>
                <a:lnTo>
                  <a:pt x="48" y="11"/>
                </a:lnTo>
                <a:lnTo>
                  <a:pt x="56" y="7"/>
                </a:lnTo>
                <a:lnTo>
                  <a:pt x="65" y="3"/>
                </a:lnTo>
                <a:lnTo>
                  <a:pt x="73" y="2"/>
                </a:lnTo>
                <a:lnTo>
                  <a:pt x="83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3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1" y="21"/>
                </a:lnTo>
                <a:lnTo>
                  <a:pt x="157" y="26"/>
                </a:lnTo>
                <a:lnTo>
                  <a:pt x="162" y="33"/>
                </a:lnTo>
                <a:lnTo>
                  <a:pt x="169" y="41"/>
                </a:lnTo>
                <a:lnTo>
                  <a:pt x="173" y="48"/>
                </a:lnTo>
                <a:lnTo>
                  <a:pt x="176" y="56"/>
                </a:lnTo>
                <a:lnTo>
                  <a:pt x="180" y="65"/>
                </a:lnTo>
                <a:lnTo>
                  <a:pt x="182" y="74"/>
                </a:lnTo>
                <a:lnTo>
                  <a:pt x="183" y="83"/>
                </a:lnTo>
                <a:lnTo>
                  <a:pt x="184" y="92"/>
                </a:lnTo>
                <a:lnTo>
                  <a:pt x="184" y="92"/>
                </a:lnTo>
                <a:lnTo>
                  <a:pt x="183" y="101"/>
                </a:lnTo>
                <a:lnTo>
                  <a:pt x="182" y="111"/>
                </a:lnTo>
                <a:lnTo>
                  <a:pt x="180" y="119"/>
                </a:lnTo>
                <a:lnTo>
                  <a:pt x="176" y="128"/>
                </a:lnTo>
                <a:lnTo>
                  <a:pt x="173" y="135"/>
                </a:lnTo>
                <a:lnTo>
                  <a:pt x="169" y="143"/>
                </a:lnTo>
                <a:lnTo>
                  <a:pt x="162" y="151"/>
                </a:lnTo>
                <a:lnTo>
                  <a:pt x="157" y="157"/>
                </a:lnTo>
                <a:lnTo>
                  <a:pt x="151" y="163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3" y="184"/>
                </a:lnTo>
                <a:lnTo>
                  <a:pt x="73" y="183"/>
                </a:lnTo>
                <a:lnTo>
                  <a:pt x="65" y="180"/>
                </a:lnTo>
                <a:lnTo>
                  <a:pt x="56" y="176"/>
                </a:lnTo>
                <a:lnTo>
                  <a:pt x="48" y="172"/>
                </a:lnTo>
                <a:lnTo>
                  <a:pt x="41" y="169"/>
                </a:lnTo>
                <a:lnTo>
                  <a:pt x="33" y="163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1" y="135"/>
                </a:lnTo>
                <a:lnTo>
                  <a:pt x="7" y="128"/>
                </a:lnTo>
                <a:lnTo>
                  <a:pt x="4" y="119"/>
                </a:lnTo>
                <a:lnTo>
                  <a:pt x="1" y="111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Freeform 39">
            <a:extLst>
              <a:ext uri="{FF2B5EF4-FFF2-40B4-BE49-F238E27FC236}">
                <a16:creationId xmlns:a16="http://schemas.microsoft.com/office/drawing/2014/main" id="{F12C385A-EE65-47D2-A1FF-C596421F8DEE}"/>
              </a:ext>
            </a:extLst>
          </p:cNvPr>
          <p:cNvSpPr>
            <a:spLocks/>
          </p:cNvSpPr>
          <p:nvPr/>
        </p:nvSpPr>
        <p:spPr bwMode="auto">
          <a:xfrm>
            <a:off x="4911402" y="5629862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6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1 h 184"/>
              <a:gd name="T20" fmla="*/ 119 w 183"/>
              <a:gd name="T21" fmla="*/ 5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4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1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3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2 h 184"/>
              <a:gd name="T58" fmla="*/ 33 w 183"/>
              <a:gd name="T59" fmla="*/ 164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20 h 184"/>
              <a:gd name="T66" fmla="*/ 0 w 183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4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1"/>
                </a:lnTo>
                <a:lnTo>
                  <a:pt x="56" y="7"/>
                </a:lnTo>
                <a:lnTo>
                  <a:pt x="64" y="5"/>
                </a:lnTo>
                <a:lnTo>
                  <a:pt x="73" y="2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4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2"/>
                </a:lnTo>
                <a:lnTo>
                  <a:pt x="182" y="111"/>
                </a:lnTo>
                <a:lnTo>
                  <a:pt x="179" y="120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4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3"/>
                </a:lnTo>
                <a:lnTo>
                  <a:pt x="64" y="180"/>
                </a:lnTo>
                <a:lnTo>
                  <a:pt x="56" y="176"/>
                </a:lnTo>
                <a:lnTo>
                  <a:pt x="47" y="172"/>
                </a:lnTo>
                <a:lnTo>
                  <a:pt x="40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20"/>
                </a:lnTo>
                <a:lnTo>
                  <a:pt x="1" y="111"/>
                </a:lnTo>
                <a:lnTo>
                  <a:pt x="0" y="102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Freeform 40">
            <a:extLst>
              <a:ext uri="{FF2B5EF4-FFF2-40B4-BE49-F238E27FC236}">
                <a16:creationId xmlns:a16="http://schemas.microsoft.com/office/drawing/2014/main" id="{2915A678-2FB9-494F-87A0-C1D3A2F4501A}"/>
              </a:ext>
            </a:extLst>
          </p:cNvPr>
          <p:cNvSpPr>
            <a:spLocks/>
          </p:cNvSpPr>
          <p:nvPr/>
        </p:nvSpPr>
        <p:spPr bwMode="auto">
          <a:xfrm>
            <a:off x="4911402" y="5629862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6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1 h 184"/>
              <a:gd name="T20" fmla="*/ 119 w 183"/>
              <a:gd name="T21" fmla="*/ 5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4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1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3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2 h 184"/>
              <a:gd name="T58" fmla="*/ 33 w 183"/>
              <a:gd name="T59" fmla="*/ 164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20 h 184"/>
              <a:gd name="T66" fmla="*/ 0 w 183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4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1"/>
                </a:lnTo>
                <a:lnTo>
                  <a:pt x="56" y="7"/>
                </a:lnTo>
                <a:lnTo>
                  <a:pt x="64" y="5"/>
                </a:lnTo>
                <a:lnTo>
                  <a:pt x="73" y="2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4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2"/>
                </a:lnTo>
                <a:lnTo>
                  <a:pt x="182" y="111"/>
                </a:lnTo>
                <a:lnTo>
                  <a:pt x="179" y="120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4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3"/>
                </a:lnTo>
                <a:lnTo>
                  <a:pt x="64" y="180"/>
                </a:lnTo>
                <a:lnTo>
                  <a:pt x="56" y="176"/>
                </a:lnTo>
                <a:lnTo>
                  <a:pt x="47" y="172"/>
                </a:lnTo>
                <a:lnTo>
                  <a:pt x="40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20"/>
                </a:lnTo>
                <a:lnTo>
                  <a:pt x="1" y="111"/>
                </a:lnTo>
                <a:lnTo>
                  <a:pt x="0" y="102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Freeform 41">
            <a:extLst>
              <a:ext uri="{FF2B5EF4-FFF2-40B4-BE49-F238E27FC236}">
                <a16:creationId xmlns:a16="http://schemas.microsoft.com/office/drawing/2014/main" id="{2992FAAC-4E69-485C-824F-6449A42597B7}"/>
              </a:ext>
            </a:extLst>
          </p:cNvPr>
          <p:cNvSpPr>
            <a:spLocks/>
          </p:cNvSpPr>
          <p:nvPr/>
        </p:nvSpPr>
        <p:spPr bwMode="auto">
          <a:xfrm>
            <a:off x="4911402" y="5629862"/>
            <a:ext cx="290513" cy="292100"/>
          </a:xfrm>
          <a:custGeom>
            <a:avLst/>
            <a:gdLst>
              <a:gd name="T0" fmla="*/ 0 w 183"/>
              <a:gd name="T1" fmla="*/ 92 h 184"/>
              <a:gd name="T2" fmla="*/ 1 w 183"/>
              <a:gd name="T3" fmla="*/ 74 h 184"/>
              <a:gd name="T4" fmla="*/ 6 w 183"/>
              <a:gd name="T5" fmla="*/ 56 h 184"/>
              <a:gd name="T6" fmla="*/ 15 w 183"/>
              <a:gd name="T7" fmla="*/ 41 h 184"/>
              <a:gd name="T8" fmla="*/ 27 w 183"/>
              <a:gd name="T9" fmla="*/ 27 h 184"/>
              <a:gd name="T10" fmla="*/ 40 w 183"/>
              <a:gd name="T11" fmla="*/ 16 h 184"/>
              <a:gd name="T12" fmla="*/ 56 w 183"/>
              <a:gd name="T13" fmla="*/ 7 h 184"/>
              <a:gd name="T14" fmla="*/ 73 w 183"/>
              <a:gd name="T15" fmla="*/ 2 h 184"/>
              <a:gd name="T16" fmla="*/ 92 w 183"/>
              <a:gd name="T17" fmla="*/ 0 h 184"/>
              <a:gd name="T18" fmla="*/ 101 w 183"/>
              <a:gd name="T19" fmla="*/ 1 h 184"/>
              <a:gd name="T20" fmla="*/ 119 w 183"/>
              <a:gd name="T21" fmla="*/ 5 h 184"/>
              <a:gd name="T22" fmla="*/ 136 w 183"/>
              <a:gd name="T23" fmla="*/ 11 h 184"/>
              <a:gd name="T24" fmla="*/ 150 w 183"/>
              <a:gd name="T25" fmla="*/ 21 h 184"/>
              <a:gd name="T26" fmla="*/ 163 w 183"/>
              <a:gd name="T27" fmla="*/ 34 h 184"/>
              <a:gd name="T28" fmla="*/ 173 w 183"/>
              <a:gd name="T29" fmla="*/ 48 h 184"/>
              <a:gd name="T30" fmla="*/ 179 w 183"/>
              <a:gd name="T31" fmla="*/ 65 h 184"/>
              <a:gd name="T32" fmla="*/ 183 w 183"/>
              <a:gd name="T33" fmla="*/ 83 h 184"/>
              <a:gd name="T34" fmla="*/ 183 w 183"/>
              <a:gd name="T35" fmla="*/ 92 h 184"/>
              <a:gd name="T36" fmla="*/ 182 w 183"/>
              <a:gd name="T37" fmla="*/ 111 h 184"/>
              <a:gd name="T38" fmla="*/ 177 w 183"/>
              <a:gd name="T39" fmla="*/ 128 h 184"/>
              <a:gd name="T40" fmla="*/ 168 w 183"/>
              <a:gd name="T41" fmla="*/ 143 h 184"/>
              <a:gd name="T42" fmla="*/ 156 w 183"/>
              <a:gd name="T43" fmla="*/ 157 h 184"/>
              <a:gd name="T44" fmla="*/ 143 w 183"/>
              <a:gd name="T45" fmla="*/ 169 h 184"/>
              <a:gd name="T46" fmla="*/ 128 w 183"/>
              <a:gd name="T47" fmla="*/ 176 h 184"/>
              <a:gd name="T48" fmla="*/ 110 w 183"/>
              <a:gd name="T49" fmla="*/ 183 h 184"/>
              <a:gd name="T50" fmla="*/ 92 w 183"/>
              <a:gd name="T51" fmla="*/ 184 h 184"/>
              <a:gd name="T52" fmla="*/ 82 w 183"/>
              <a:gd name="T53" fmla="*/ 184 h 184"/>
              <a:gd name="T54" fmla="*/ 64 w 183"/>
              <a:gd name="T55" fmla="*/ 180 h 184"/>
              <a:gd name="T56" fmla="*/ 47 w 183"/>
              <a:gd name="T57" fmla="*/ 172 h 184"/>
              <a:gd name="T58" fmla="*/ 33 w 183"/>
              <a:gd name="T59" fmla="*/ 164 h 184"/>
              <a:gd name="T60" fmla="*/ 20 w 183"/>
              <a:gd name="T61" fmla="*/ 151 h 184"/>
              <a:gd name="T62" fmla="*/ 10 w 183"/>
              <a:gd name="T63" fmla="*/ 135 h 184"/>
              <a:gd name="T64" fmla="*/ 4 w 183"/>
              <a:gd name="T65" fmla="*/ 120 h 184"/>
              <a:gd name="T66" fmla="*/ 0 w 183"/>
              <a:gd name="T67" fmla="*/ 102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4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4"/>
                </a:lnTo>
                <a:lnTo>
                  <a:pt x="4" y="65"/>
                </a:lnTo>
                <a:lnTo>
                  <a:pt x="6" y="56"/>
                </a:lnTo>
                <a:lnTo>
                  <a:pt x="10" y="48"/>
                </a:lnTo>
                <a:lnTo>
                  <a:pt x="15" y="41"/>
                </a:lnTo>
                <a:lnTo>
                  <a:pt x="20" y="34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1"/>
                </a:lnTo>
                <a:lnTo>
                  <a:pt x="56" y="7"/>
                </a:lnTo>
                <a:lnTo>
                  <a:pt x="64" y="5"/>
                </a:lnTo>
                <a:lnTo>
                  <a:pt x="73" y="2"/>
                </a:lnTo>
                <a:lnTo>
                  <a:pt x="82" y="1"/>
                </a:lnTo>
                <a:lnTo>
                  <a:pt x="92" y="0"/>
                </a:lnTo>
                <a:lnTo>
                  <a:pt x="92" y="0"/>
                </a:lnTo>
                <a:lnTo>
                  <a:pt x="101" y="1"/>
                </a:lnTo>
                <a:lnTo>
                  <a:pt x="110" y="2"/>
                </a:lnTo>
                <a:lnTo>
                  <a:pt x="119" y="5"/>
                </a:lnTo>
                <a:lnTo>
                  <a:pt x="128" y="7"/>
                </a:lnTo>
                <a:lnTo>
                  <a:pt x="136" y="11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4"/>
                </a:lnTo>
                <a:lnTo>
                  <a:pt x="168" y="41"/>
                </a:lnTo>
                <a:lnTo>
                  <a:pt x="173" y="48"/>
                </a:lnTo>
                <a:lnTo>
                  <a:pt x="177" y="56"/>
                </a:lnTo>
                <a:lnTo>
                  <a:pt x="179" y="65"/>
                </a:lnTo>
                <a:lnTo>
                  <a:pt x="182" y="74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2"/>
                </a:lnTo>
                <a:lnTo>
                  <a:pt x="182" y="111"/>
                </a:lnTo>
                <a:lnTo>
                  <a:pt x="179" y="120"/>
                </a:lnTo>
                <a:lnTo>
                  <a:pt x="177" y="128"/>
                </a:lnTo>
                <a:lnTo>
                  <a:pt x="173" y="135"/>
                </a:lnTo>
                <a:lnTo>
                  <a:pt x="168" y="143"/>
                </a:lnTo>
                <a:lnTo>
                  <a:pt x="163" y="151"/>
                </a:lnTo>
                <a:lnTo>
                  <a:pt x="156" y="157"/>
                </a:lnTo>
                <a:lnTo>
                  <a:pt x="150" y="164"/>
                </a:lnTo>
                <a:lnTo>
                  <a:pt x="143" y="169"/>
                </a:lnTo>
                <a:lnTo>
                  <a:pt x="136" y="172"/>
                </a:lnTo>
                <a:lnTo>
                  <a:pt x="128" y="176"/>
                </a:lnTo>
                <a:lnTo>
                  <a:pt x="119" y="180"/>
                </a:lnTo>
                <a:lnTo>
                  <a:pt x="110" y="183"/>
                </a:lnTo>
                <a:lnTo>
                  <a:pt x="101" y="184"/>
                </a:lnTo>
                <a:lnTo>
                  <a:pt x="92" y="184"/>
                </a:lnTo>
                <a:lnTo>
                  <a:pt x="92" y="184"/>
                </a:lnTo>
                <a:lnTo>
                  <a:pt x="82" y="184"/>
                </a:lnTo>
                <a:lnTo>
                  <a:pt x="73" y="183"/>
                </a:lnTo>
                <a:lnTo>
                  <a:pt x="64" y="180"/>
                </a:lnTo>
                <a:lnTo>
                  <a:pt x="56" y="176"/>
                </a:lnTo>
                <a:lnTo>
                  <a:pt x="47" y="172"/>
                </a:lnTo>
                <a:lnTo>
                  <a:pt x="40" y="169"/>
                </a:lnTo>
                <a:lnTo>
                  <a:pt x="33" y="164"/>
                </a:lnTo>
                <a:lnTo>
                  <a:pt x="27" y="157"/>
                </a:lnTo>
                <a:lnTo>
                  <a:pt x="20" y="151"/>
                </a:lnTo>
                <a:lnTo>
                  <a:pt x="15" y="143"/>
                </a:lnTo>
                <a:lnTo>
                  <a:pt x="10" y="135"/>
                </a:lnTo>
                <a:lnTo>
                  <a:pt x="6" y="128"/>
                </a:lnTo>
                <a:lnTo>
                  <a:pt x="4" y="120"/>
                </a:lnTo>
                <a:lnTo>
                  <a:pt x="1" y="111"/>
                </a:lnTo>
                <a:lnTo>
                  <a:pt x="0" y="102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Freeform 42">
            <a:extLst>
              <a:ext uri="{FF2B5EF4-FFF2-40B4-BE49-F238E27FC236}">
                <a16:creationId xmlns:a16="http://schemas.microsoft.com/office/drawing/2014/main" id="{7F6F682A-D290-4A50-B839-B586C9C4319F}"/>
              </a:ext>
            </a:extLst>
          </p:cNvPr>
          <p:cNvSpPr>
            <a:spLocks/>
          </p:cNvSpPr>
          <p:nvPr/>
        </p:nvSpPr>
        <p:spPr bwMode="auto">
          <a:xfrm>
            <a:off x="6265540" y="58648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3 h 185"/>
              <a:gd name="T4" fmla="*/ 6 w 183"/>
              <a:gd name="T5" fmla="*/ 56 h 185"/>
              <a:gd name="T6" fmla="*/ 15 w 183"/>
              <a:gd name="T7" fmla="*/ 41 h 185"/>
              <a:gd name="T8" fmla="*/ 27 w 183"/>
              <a:gd name="T9" fmla="*/ 27 h 185"/>
              <a:gd name="T10" fmla="*/ 40 w 183"/>
              <a:gd name="T11" fmla="*/ 16 h 185"/>
              <a:gd name="T12" fmla="*/ 56 w 183"/>
              <a:gd name="T13" fmla="*/ 8 h 185"/>
              <a:gd name="T14" fmla="*/ 73 w 183"/>
              <a:gd name="T15" fmla="*/ 1 h 185"/>
              <a:gd name="T16" fmla="*/ 92 w 183"/>
              <a:gd name="T17" fmla="*/ 0 h 185"/>
              <a:gd name="T18" fmla="*/ 101 w 183"/>
              <a:gd name="T19" fmla="*/ 0 h 185"/>
              <a:gd name="T20" fmla="*/ 119 w 183"/>
              <a:gd name="T21" fmla="*/ 4 h 185"/>
              <a:gd name="T22" fmla="*/ 136 w 183"/>
              <a:gd name="T23" fmla="*/ 12 h 185"/>
              <a:gd name="T24" fmla="*/ 150 w 183"/>
              <a:gd name="T25" fmla="*/ 21 h 185"/>
              <a:gd name="T26" fmla="*/ 163 w 183"/>
              <a:gd name="T27" fmla="*/ 33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0 h 185"/>
              <a:gd name="T38" fmla="*/ 177 w 183"/>
              <a:gd name="T39" fmla="*/ 128 h 185"/>
              <a:gd name="T40" fmla="*/ 168 w 183"/>
              <a:gd name="T41" fmla="*/ 144 h 185"/>
              <a:gd name="T42" fmla="*/ 156 w 183"/>
              <a:gd name="T43" fmla="*/ 158 h 185"/>
              <a:gd name="T44" fmla="*/ 143 w 183"/>
              <a:gd name="T45" fmla="*/ 168 h 185"/>
              <a:gd name="T46" fmla="*/ 127 w 183"/>
              <a:gd name="T47" fmla="*/ 177 h 185"/>
              <a:gd name="T48" fmla="*/ 110 w 183"/>
              <a:gd name="T49" fmla="*/ 182 h 185"/>
              <a:gd name="T50" fmla="*/ 92 w 183"/>
              <a:gd name="T51" fmla="*/ 185 h 185"/>
              <a:gd name="T52" fmla="*/ 82 w 183"/>
              <a:gd name="T53" fmla="*/ 183 h 185"/>
              <a:gd name="T54" fmla="*/ 64 w 183"/>
              <a:gd name="T55" fmla="*/ 181 h 185"/>
              <a:gd name="T56" fmla="*/ 47 w 183"/>
              <a:gd name="T57" fmla="*/ 173 h 185"/>
              <a:gd name="T58" fmla="*/ 33 w 183"/>
              <a:gd name="T59" fmla="*/ 163 h 185"/>
              <a:gd name="T60" fmla="*/ 20 w 183"/>
              <a:gd name="T61" fmla="*/ 151 h 185"/>
              <a:gd name="T62" fmla="*/ 10 w 183"/>
              <a:gd name="T63" fmla="*/ 136 h 185"/>
              <a:gd name="T64" fmla="*/ 4 w 183"/>
              <a:gd name="T65" fmla="*/ 119 h 185"/>
              <a:gd name="T66" fmla="*/ 0 w 183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3"/>
                </a:lnTo>
                <a:lnTo>
                  <a:pt x="4" y="65"/>
                </a:lnTo>
                <a:lnTo>
                  <a:pt x="6" y="56"/>
                </a:lnTo>
                <a:lnTo>
                  <a:pt x="10" y="49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2"/>
                </a:lnTo>
                <a:lnTo>
                  <a:pt x="56" y="8"/>
                </a:lnTo>
                <a:lnTo>
                  <a:pt x="64" y="4"/>
                </a:lnTo>
                <a:lnTo>
                  <a:pt x="73" y="1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1"/>
                </a:lnTo>
                <a:lnTo>
                  <a:pt x="119" y="4"/>
                </a:lnTo>
                <a:lnTo>
                  <a:pt x="127" y="8"/>
                </a:lnTo>
                <a:lnTo>
                  <a:pt x="136" y="12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6"/>
                </a:lnTo>
                <a:lnTo>
                  <a:pt x="179" y="65"/>
                </a:lnTo>
                <a:lnTo>
                  <a:pt x="182" y="73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6" y="158"/>
                </a:lnTo>
                <a:lnTo>
                  <a:pt x="150" y="163"/>
                </a:lnTo>
                <a:lnTo>
                  <a:pt x="143" y="168"/>
                </a:lnTo>
                <a:lnTo>
                  <a:pt x="136" y="173"/>
                </a:lnTo>
                <a:lnTo>
                  <a:pt x="127" y="177"/>
                </a:lnTo>
                <a:lnTo>
                  <a:pt x="119" y="181"/>
                </a:lnTo>
                <a:lnTo>
                  <a:pt x="110" y="182"/>
                </a:lnTo>
                <a:lnTo>
                  <a:pt x="101" y="183"/>
                </a:lnTo>
                <a:lnTo>
                  <a:pt x="92" y="185"/>
                </a:lnTo>
                <a:lnTo>
                  <a:pt x="92" y="185"/>
                </a:lnTo>
                <a:lnTo>
                  <a:pt x="82" y="183"/>
                </a:lnTo>
                <a:lnTo>
                  <a:pt x="73" y="182"/>
                </a:lnTo>
                <a:lnTo>
                  <a:pt x="64" y="181"/>
                </a:lnTo>
                <a:lnTo>
                  <a:pt x="56" y="177"/>
                </a:lnTo>
                <a:lnTo>
                  <a:pt x="47" y="173"/>
                </a:lnTo>
                <a:lnTo>
                  <a:pt x="40" y="168"/>
                </a:lnTo>
                <a:lnTo>
                  <a:pt x="33" y="163"/>
                </a:lnTo>
                <a:lnTo>
                  <a:pt x="27" y="158"/>
                </a:lnTo>
                <a:lnTo>
                  <a:pt x="20" y="151"/>
                </a:lnTo>
                <a:lnTo>
                  <a:pt x="15" y="144"/>
                </a:lnTo>
                <a:lnTo>
                  <a:pt x="10" y="136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Freeform 43">
            <a:extLst>
              <a:ext uri="{FF2B5EF4-FFF2-40B4-BE49-F238E27FC236}">
                <a16:creationId xmlns:a16="http://schemas.microsoft.com/office/drawing/2014/main" id="{CD39B91E-30D2-4202-98EE-9CCC5070A2F7}"/>
              </a:ext>
            </a:extLst>
          </p:cNvPr>
          <p:cNvSpPr>
            <a:spLocks/>
          </p:cNvSpPr>
          <p:nvPr/>
        </p:nvSpPr>
        <p:spPr bwMode="auto">
          <a:xfrm>
            <a:off x="6265540" y="58648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3 h 185"/>
              <a:gd name="T4" fmla="*/ 6 w 183"/>
              <a:gd name="T5" fmla="*/ 56 h 185"/>
              <a:gd name="T6" fmla="*/ 15 w 183"/>
              <a:gd name="T7" fmla="*/ 41 h 185"/>
              <a:gd name="T8" fmla="*/ 27 w 183"/>
              <a:gd name="T9" fmla="*/ 27 h 185"/>
              <a:gd name="T10" fmla="*/ 40 w 183"/>
              <a:gd name="T11" fmla="*/ 16 h 185"/>
              <a:gd name="T12" fmla="*/ 56 w 183"/>
              <a:gd name="T13" fmla="*/ 8 h 185"/>
              <a:gd name="T14" fmla="*/ 73 w 183"/>
              <a:gd name="T15" fmla="*/ 1 h 185"/>
              <a:gd name="T16" fmla="*/ 92 w 183"/>
              <a:gd name="T17" fmla="*/ 0 h 185"/>
              <a:gd name="T18" fmla="*/ 101 w 183"/>
              <a:gd name="T19" fmla="*/ 0 h 185"/>
              <a:gd name="T20" fmla="*/ 119 w 183"/>
              <a:gd name="T21" fmla="*/ 4 h 185"/>
              <a:gd name="T22" fmla="*/ 136 w 183"/>
              <a:gd name="T23" fmla="*/ 12 h 185"/>
              <a:gd name="T24" fmla="*/ 150 w 183"/>
              <a:gd name="T25" fmla="*/ 21 h 185"/>
              <a:gd name="T26" fmla="*/ 163 w 183"/>
              <a:gd name="T27" fmla="*/ 33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0 h 185"/>
              <a:gd name="T38" fmla="*/ 177 w 183"/>
              <a:gd name="T39" fmla="*/ 128 h 185"/>
              <a:gd name="T40" fmla="*/ 168 w 183"/>
              <a:gd name="T41" fmla="*/ 144 h 185"/>
              <a:gd name="T42" fmla="*/ 156 w 183"/>
              <a:gd name="T43" fmla="*/ 158 h 185"/>
              <a:gd name="T44" fmla="*/ 143 w 183"/>
              <a:gd name="T45" fmla="*/ 168 h 185"/>
              <a:gd name="T46" fmla="*/ 127 w 183"/>
              <a:gd name="T47" fmla="*/ 177 h 185"/>
              <a:gd name="T48" fmla="*/ 110 w 183"/>
              <a:gd name="T49" fmla="*/ 182 h 185"/>
              <a:gd name="T50" fmla="*/ 92 w 183"/>
              <a:gd name="T51" fmla="*/ 185 h 185"/>
              <a:gd name="T52" fmla="*/ 82 w 183"/>
              <a:gd name="T53" fmla="*/ 183 h 185"/>
              <a:gd name="T54" fmla="*/ 64 w 183"/>
              <a:gd name="T55" fmla="*/ 181 h 185"/>
              <a:gd name="T56" fmla="*/ 47 w 183"/>
              <a:gd name="T57" fmla="*/ 173 h 185"/>
              <a:gd name="T58" fmla="*/ 33 w 183"/>
              <a:gd name="T59" fmla="*/ 163 h 185"/>
              <a:gd name="T60" fmla="*/ 20 w 183"/>
              <a:gd name="T61" fmla="*/ 151 h 185"/>
              <a:gd name="T62" fmla="*/ 10 w 183"/>
              <a:gd name="T63" fmla="*/ 136 h 185"/>
              <a:gd name="T64" fmla="*/ 4 w 183"/>
              <a:gd name="T65" fmla="*/ 119 h 185"/>
              <a:gd name="T66" fmla="*/ 0 w 183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3"/>
                </a:lnTo>
                <a:lnTo>
                  <a:pt x="4" y="65"/>
                </a:lnTo>
                <a:lnTo>
                  <a:pt x="6" y="56"/>
                </a:lnTo>
                <a:lnTo>
                  <a:pt x="10" y="49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2"/>
                </a:lnTo>
                <a:lnTo>
                  <a:pt x="56" y="8"/>
                </a:lnTo>
                <a:lnTo>
                  <a:pt x="64" y="4"/>
                </a:lnTo>
                <a:lnTo>
                  <a:pt x="73" y="1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1"/>
                </a:lnTo>
                <a:lnTo>
                  <a:pt x="119" y="4"/>
                </a:lnTo>
                <a:lnTo>
                  <a:pt x="127" y="8"/>
                </a:lnTo>
                <a:lnTo>
                  <a:pt x="136" y="12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6"/>
                </a:lnTo>
                <a:lnTo>
                  <a:pt x="179" y="65"/>
                </a:lnTo>
                <a:lnTo>
                  <a:pt x="182" y="73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6" y="158"/>
                </a:lnTo>
                <a:lnTo>
                  <a:pt x="150" y="163"/>
                </a:lnTo>
                <a:lnTo>
                  <a:pt x="143" y="168"/>
                </a:lnTo>
                <a:lnTo>
                  <a:pt x="136" y="173"/>
                </a:lnTo>
                <a:lnTo>
                  <a:pt x="127" y="177"/>
                </a:lnTo>
                <a:lnTo>
                  <a:pt x="119" y="181"/>
                </a:lnTo>
                <a:lnTo>
                  <a:pt x="110" y="182"/>
                </a:lnTo>
                <a:lnTo>
                  <a:pt x="101" y="183"/>
                </a:lnTo>
                <a:lnTo>
                  <a:pt x="92" y="185"/>
                </a:lnTo>
                <a:lnTo>
                  <a:pt x="92" y="185"/>
                </a:lnTo>
                <a:lnTo>
                  <a:pt x="82" y="183"/>
                </a:lnTo>
                <a:lnTo>
                  <a:pt x="73" y="182"/>
                </a:lnTo>
                <a:lnTo>
                  <a:pt x="64" y="181"/>
                </a:lnTo>
                <a:lnTo>
                  <a:pt x="56" y="177"/>
                </a:lnTo>
                <a:lnTo>
                  <a:pt x="47" y="173"/>
                </a:lnTo>
                <a:lnTo>
                  <a:pt x="40" y="168"/>
                </a:lnTo>
                <a:lnTo>
                  <a:pt x="33" y="163"/>
                </a:lnTo>
                <a:lnTo>
                  <a:pt x="27" y="158"/>
                </a:lnTo>
                <a:lnTo>
                  <a:pt x="20" y="151"/>
                </a:lnTo>
                <a:lnTo>
                  <a:pt x="15" y="144"/>
                </a:lnTo>
                <a:lnTo>
                  <a:pt x="10" y="136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Freeform 44">
            <a:extLst>
              <a:ext uri="{FF2B5EF4-FFF2-40B4-BE49-F238E27FC236}">
                <a16:creationId xmlns:a16="http://schemas.microsoft.com/office/drawing/2014/main" id="{E3D3D695-0C4B-49C7-A3CE-6CC22663686F}"/>
              </a:ext>
            </a:extLst>
          </p:cNvPr>
          <p:cNvSpPr>
            <a:spLocks/>
          </p:cNvSpPr>
          <p:nvPr/>
        </p:nvSpPr>
        <p:spPr bwMode="auto">
          <a:xfrm>
            <a:off x="6265540" y="5864812"/>
            <a:ext cx="290513" cy="293688"/>
          </a:xfrm>
          <a:custGeom>
            <a:avLst/>
            <a:gdLst>
              <a:gd name="T0" fmla="*/ 0 w 183"/>
              <a:gd name="T1" fmla="*/ 92 h 185"/>
              <a:gd name="T2" fmla="*/ 1 w 183"/>
              <a:gd name="T3" fmla="*/ 73 h 185"/>
              <a:gd name="T4" fmla="*/ 6 w 183"/>
              <a:gd name="T5" fmla="*/ 56 h 185"/>
              <a:gd name="T6" fmla="*/ 15 w 183"/>
              <a:gd name="T7" fmla="*/ 41 h 185"/>
              <a:gd name="T8" fmla="*/ 27 w 183"/>
              <a:gd name="T9" fmla="*/ 27 h 185"/>
              <a:gd name="T10" fmla="*/ 40 w 183"/>
              <a:gd name="T11" fmla="*/ 16 h 185"/>
              <a:gd name="T12" fmla="*/ 56 w 183"/>
              <a:gd name="T13" fmla="*/ 8 h 185"/>
              <a:gd name="T14" fmla="*/ 73 w 183"/>
              <a:gd name="T15" fmla="*/ 1 h 185"/>
              <a:gd name="T16" fmla="*/ 92 w 183"/>
              <a:gd name="T17" fmla="*/ 0 h 185"/>
              <a:gd name="T18" fmla="*/ 101 w 183"/>
              <a:gd name="T19" fmla="*/ 0 h 185"/>
              <a:gd name="T20" fmla="*/ 119 w 183"/>
              <a:gd name="T21" fmla="*/ 4 h 185"/>
              <a:gd name="T22" fmla="*/ 136 w 183"/>
              <a:gd name="T23" fmla="*/ 12 h 185"/>
              <a:gd name="T24" fmla="*/ 150 w 183"/>
              <a:gd name="T25" fmla="*/ 21 h 185"/>
              <a:gd name="T26" fmla="*/ 163 w 183"/>
              <a:gd name="T27" fmla="*/ 33 h 185"/>
              <a:gd name="T28" fmla="*/ 173 w 183"/>
              <a:gd name="T29" fmla="*/ 49 h 185"/>
              <a:gd name="T30" fmla="*/ 179 w 183"/>
              <a:gd name="T31" fmla="*/ 65 h 185"/>
              <a:gd name="T32" fmla="*/ 183 w 183"/>
              <a:gd name="T33" fmla="*/ 83 h 185"/>
              <a:gd name="T34" fmla="*/ 183 w 183"/>
              <a:gd name="T35" fmla="*/ 92 h 185"/>
              <a:gd name="T36" fmla="*/ 182 w 183"/>
              <a:gd name="T37" fmla="*/ 110 h 185"/>
              <a:gd name="T38" fmla="*/ 177 w 183"/>
              <a:gd name="T39" fmla="*/ 128 h 185"/>
              <a:gd name="T40" fmla="*/ 168 w 183"/>
              <a:gd name="T41" fmla="*/ 144 h 185"/>
              <a:gd name="T42" fmla="*/ 156 w 183"/>
              <a:gd name="T43" fmla="*/ 158 h 185"/>
              <a:gd name="T44" fmla="*/ 143 w 183"/>
              <a:gd name="T45" fmla="*/ 168 h 185"/>
              <a:gd name="T46" fmla="*/ 127 w 183"/>
              <a:gd name="T47" fmla="*/ 177 h 185"/>
              <a:gd name="T48" fmla="*/ 110 w 183"/>
              <a:gd name="T49" fmla="*/ 182 h 185"/>
              <a:gd name="T50" fmla="*/ 92 w 183"/>
              <a:gd name="T51" fmla="*/ 185 h 185"/>
              <a:gd name="T52" fmla="*/ 82 w 183"/>
              <a:gd name="T53" fmla="*/ 183 h 185"/>
              <a:gd name="T54" fmla="*/ 64 w 183"/>
              <a:gd name="T55" fmla="*/ 181 h 185"/>
              <a:gd name="T56" fmla="*/ 47 w 183"/>
              <a:gd name="T57" fmla="*/ 173 h 185"/>
              <a:gd name="T58" fmla="*/ 33 w 183"/>
              <a:gd name="T59" fmla="*/ 163 h 185"/>
              <a:gd name="T60" fmla="*/ 20 w 183"/>
              <a:gd name="T61" fmla="*/ 151 h 185"/>
              <a:gd name="T62" fmla="*/ 10 w 183"/>
              <a:gd name="T63" fmla="*/ 136 h 185"/>
              <a:gd name="T64" fmla="*/ 4 w 183"/>
              <a:gd name="T65" fmla="*/ 119 h 185"/>
              <a:gd name="T66" fmla="*/ 0 w 183"/>
              <a:gd name="T67" fmla="*/ 101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3" h="185">
                <a:moveTo>
                  <a:pt x="0" y="92"/>
                </a:moveTo>
                <a:lnTo>
                  <a:pt x="0" y="92"/>
                </a:lnTo>
                <a:lnTo>
                  <a:pt x="0" y="83"/>
                </a:lnTo>
                <a:lnTo>
                  <a:pt x="1" y="73"/>
                </a:lnTo>
                <a:lnTo>
                  <a:pt x="4" y="65"/>
                </a:lnTo>
                <a:lnTo>
                  <a:pt x="6" y="56"/>
                </a:lnTo>
                <a:lnTo>
                  <a:pt x="10" y="49"/>
                </a:lnTo>
                <a:lnTo>
                  <a:pt x="15" y="41"/>
                </a:lnTo>
                <a:lnTo>
                  <a:pt x="20" y="33"/>
                </a:lnTo>
                <a:lnTo>
                  <a:pt x="27" y="27"/>
                </a:lnTo>
                <a:lnTo>
                  <a:pt x="33" y="21"/>
                </a:lnTo>
                <a:lnTo>
                  <a:pt x="40" y="16"/>
                </a:lnTo>
                <a:lnTo>
                  <a:pt x="47" y="12"/>
                </a:lnTo>
                <a:lnTo>
                  <a:pt x="56" y="8"/>
                </a:lnTo>
                <a:lnTo>
                  <a:pt x="64" y="4"/>
                </a:lnTo>
                <a:lnTo>
                  <a:pt x="73" y="1"/>
                </a:lnTo>
                <a:lnTo>
                  <a:pt x="82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0" y="1"/>
                </a:lnTo>
                <a:lnTo>
                  <a:pt x="119" y="4"/>
                </a:lnTo>
                <a:lnTo>
                  <a:pt x="127" y="8"/>
                </a:lnTo>
                <a:lnTo>
                  <a:pt x="136" y="12"/>
                </a:lnTo>
                <a:lnTo>
                  <a:pt x="143" y="16"/>
                </a:lnTo>
                <a:lnTo>
                  <a:pt x="150" y="21"/>
                </a:lnTo>
                <a:lnTo>
                  <a:pt x="156" y="27"/>
                </a:lnTo>
                <a:lnTo>
                  <a:pt x="163" y="33"/>
                </a:lnTo>
                <a:lnTo>
                  <a:pt x="168" y="41"/>
                </a:lnTo>
                <a:lnTo>
                  <a:pt x="173" y="49"/>
                </a:lnTo>
                <a:lnTo>
                  <a:pt x="177" y="56"/>
                </a:lnTo>
                <a:lnTo>
                  <a:pt x="179" y="65"/>
                </a:lnTo>
                <a:lnTo>
                  <a:pt x="182" y="73"/>
                </a:lnTo>
                <a:lnTo>
                  <a:pt x="183" y="83"/>
                </a:lnTo>
                <a:lnTo>
                  <a:pt x="183" y="92"/>
                </a:lnTo>
                <a:lnTo>
                  <a:pt x="183" y="92"/>
                </a:lnTo>
                <a:lnTo>
                  <a:pt x="183" y="101"/>
                </a:lnTo>
                <a:lnTo>
                  <a:pt x="182" y="110"/>
                </a:lnTo>
                <a:lnTo>
                  <a:pt x="179" y="119"/>
                </a:lnTo>
                <a:lnTo>
                  <a:pt x="177" y="128"/>
                </a:lnTo>
                <a:lnTo>
                  <a:pt x="173" y="136"/>
                </a:lnTo>
                <a:lnTo>
                  <a:pt x="168" y="144"/>
                </a:lnTo>
                <a:lnTo>
                  <a:pt x="163" y="151"/>
                </a:lnTo>
                <a:lnTo>
                  <a:pt x="156" y="158"/>
                </a:lnTo>
                <a:lnTo>
                  <a:pt x="150" y="163"/>
                </a:lnTo>
                <a:lnTo>
                  <a:pt x="143" y="168"/>
                </a:lnTo>
                <a:lnTo>
                  <a:pt x="136" y="173"/>
                </a:lnTo>
                <a:lnTo>
                  <a:pt x="127" y="177"/>
                </a:lnTo>
                <a:lnTo>
                  <a:pt x="119" y="181"/>
                </a:lnTo>
                <a:lnTo>
                  <a:pt x="110" y="182"/>
                </a:lnTo>
                <a:lnTo>
                  <a:pt x="101" y="183"/>
                </a:lnTo>
                <a:lnTo>
                  <a:pt x="92" y="185"/>
                </a:lnTo>
                <a:lnTo>
                  <a:pt x="92" y="185"/>
                </a:lnTo>
                <a:lnTo>
                  <a:pt x="82" y="183"/>
                </a:lnTo>
                <a:lnTo>
                  <a:pt x="73" y="182"/>
                </a:lnTo>
                <a:lnTo>
                  <a:pt x="64" y="181"/>
                </a:lnTo>
                <a:lnTo>
                  <a:pt x="56" y="177"/>
                </a:lnTo>
                <a:lnTo>
                  <a:pt x="47" y="173"/>
                </a:lnTo>
                <a:lnTo>
                  <a:pt x="40" y="168"/>
                </a:lnTo>
                <a:lnTo>
                  <a:pt x="33" y="163"/>
                </a:lnTo>
                <a:lnTo>
                  <a:pt x="27" y="158"/>
                </a:lnTo>
                <a:lnTo>
                  <a:pt x="20" y="151"/>
                </a:lnTo>
                <a:lnTo>
                  <a:pt x="15" y="144"/>
                </a:lnTo>
                <a:lnTo>
                  <a:pt x="10" y="136"/>
                </a:lnTo>
                <a:lnTo>
                  <a:pt x="6" y="128"/>
                </a:lnTo>
                <a:lnTo>
                  <a:pt x="4" y="119"/>
                </a:lnTo>
                <a:lnTo>
                  <a:pt x="1" y="110"/>
                </a:lnTo>
                <a:lnTo>
                  <a:pt x="0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Freeform 45">
            <a:extLst>
              <a:ext uri="{FF2B5EF4-FFF2-40B4-BE49-F238E27FC236}">
                <a16:creationId xmlns:a16="http://schemas.microsoft.com/office/drawing/2014/main" id="{BD830EE4-C2BC-43B3-A6B4-3615E57794A6}"/>
              </a:ext>
            </a:extLst>
          </p:cNvPr>
          <p:cNvSpPr>
            <a:spLocks/>
          </p:cNvSpPr>
          <p:nvPr/>
        </p:nvSpPr>
        <p:spPr bwMode="auto">
          <a:xfrm>
            <a:off x="7454577" y="5188537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3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7 h 184"/>
              <a:gd name="T10" fmla="*/ 41 w 185"/>
              <a:gd name="T11" fmla="*/ 15 h 184"/>
              <a:gd name="T12" fmla="*/ 57 w 185"/>
              <a:gd name="T13" fmla="*/ 7 h 184"/>
              <a:gd name="T14" fmla="*/ 75 w 185"/>
              <a:gd name="T15" fmla="*/ 1 h 184"/>
              <a:gd name="T16" fmla="*/ 92 w 185"/>
              <a:gd name="T17" fmla="*/ 0 h 184"/>
              <a:gd name="T18" fmla="*/ 101 w 185"/>
              <a:gd name="T19" fmla="*/ 0 h 184"/>
              <a:gd name="T20" fmla="*/ 119 w 185"/>
              <a:gd name="T21" fmla="*/ 4 h 184"/>
              <a:gd name="T22" fmla="*/ 136 w 185"/>
              <a:gd name="T23" fmla="*/ 11 h 184"/>
              <a:gd name="T24" fmla="*/ 151 w 185"/>
              <a:gd name="T25" fmla="*/ 20 h 184"/>
              <a:gd name="T26" fmla="*/ 164 w 185"/>
              <a:gd name="T27" fmla="*/ 33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0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7 h 184"/>
              <a:gd name="T46" fmla="*/ 128 w 185"/>
              <a:gd name="T47" fmla="*/ 176 h 184"/>
              <a:gd name="T48" fmla="*/ 112 w 185"/>
              <a:gd name="T49" fmla="*/ 182 h 184"/>
              <a:gd name="T50" fmla="*/ 92 w 185"/>
              <a:gd name="T51" fmla="*/ 184 h 184"/>
              <a:gd name="T52" fmla="*/ 83 w 185"/>
              <a:gd name="T53" fmla="*/ 183 h 184"/>
              <a:gd name="T54" fmla="*/ 66 w 185"/>
              <a:gd name="T55" fmla="*/ 180 h 184"/>
              <a:gd name="T56" fmla="*/ 49 w 185"/>
              <a:gd name="T57" fmla="*/ 173 h 184"/>
              <a:gd name="T58" fmla="*/ 34 w 185"/>
              <a:gd name="T59" fmla="*/ 162 h 184"/>
              <a:gd name="T60" fmla="*/ 22 w 185"/>
              <a:gd name="T61" fmla="*/ 151 h 184"/>
              <a:gd name="T62" fmla="*/ 12 w 185"/>
              <a:gd name="T63" fmla="*/ 135 h 184"/>
              <a:gd name="T64" fmla="*/ 4 w 185"/>
              <a:gd name="T65" fmla="*/ 119 h 184"/>
              <a:gd name="T66" fmla="*/ 2 w 185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3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3"/>
                </a:lnTo>
                <a:lnTo>
                  <a:pt x="27" y="27"/>
                </a:lnTo>
                <a:lnTo>
                  <a:pt x="34" y="20"/>
                </a:lnTo>
                <a:lnTo>
                  <a:pt x="41" y="15"/>
                </a:lnTo>
                <a:lnTo>
                  <a:pt x="49" y="11"/>
                </a:lnTo>
                <a:lnTo>
                  <a:pt x="57" y="7"/>
                </a:lnTo>
                <a:lnTo>
                  <a:pt x="66" y="4"/>
                </a:lnTo>
                <a:lnTo>
                  <a:pt x="75" y="1"/>
                </a:lnTo>
                <a:lnTo>
                  <a:pt x="83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2" y="1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4" y="15"/>
                </a:lnTo>
                <a:lnTo>
                  <a:pt x="151" y="20"/>
                </a:lnTo>
                <a:lnTo>
                  <a:pt x="158" y="27"/>
                </a:lnTo>
                <a:lnTo>
                  <a:pt x="164" y="33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3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1"/>
                </a:lnTo>
                <a:lnTo>
                  <a:pt x="183" y="110"/>
                </a:lnTo>
                <a:lnTo>
                  <a:pt x="181" y="119"/>
                </a:lnTo>
                <a:lnTo>
                  <a:pt x="177" y="128"/>
                </a:lnTo>
                <a:lnTo>
                  <a:pt x="173" y="135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2"/>
                </a:lnTo>
                <a:lnTo>
                  <a:pt x="144" y="167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2" y="182"/>
                </a:lnTo>
                <a:lnTo>
                  <a:pt x="101" y="183"/>
                </a:lnTo>
                <a:lnTo>
                  <a:pt x="92" y="184"/>
                </a:lnTo>
                <a:lnTo>
                  <a:pt x="92" y="184"/>
                </a:lnTo>
                <a:lnTo>
                  <a:pt x="83" y="183"/>
                </a:lnTo>
                <a:lnTo>
                  <a:pt x="75" y="182"/>
                </a:lnTo>
                <a:lnTo>
                  <a:pt x="66" y="180"/>
                </a:lnTo>
                <a:lnTo>
                  <a:pt x="57" y="176"/>
                </a:lnTo>
                <a:lnTo>
                  <a:pt x="49" y="173"/>
                </a:lnTo>
                <a:lnTo>
                  <a:pt x="41" y="167"/>
                </a:lnTo>
                <a:lnTo>
                  <a:pt x="34" y="162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5"/>
                </a:lnTo>
                <a:lnTo>
                  <a:pt x="8" y="128"/>
                </a:lnTo>
                <a:lnTo>
                  <a:pt x="4" y="119"/>
                </a:lnTo>
                <a:lnTo>
                  <a:pt x="3" y="110"/>
                </a:lnTo>
                <a:lnTo>
                  <a:pt x="2" y="101"/>
                </a:lnTo>
                <a:lnTo>
                  <a:pt x="0" y="92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Freeform 46">
            <a:extLst>
              <a:ext uri="{FF2B5EF4-FFF2-40B4-BE49-F238E27FC236}">
                <a16:creationId xmlns:a16="http://schemas.microsoft.com/office/drawing/2014/main" id="{D2F21B08-8915-4DE0-B327-392ED0E51CCE}"/>
              </a:ext>
            </a:extLst>
          </p:cNvPr>
          <p:cNvSpPr>
            <a:spLocks/>
          </p:cNvSpPr>
          <p:nvPr/>
        </p:nvSpPr>
        <p:spPr bwMode="auto">
          <a:xfrm>
            <a:off x="7454577" y="5188537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3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7 h 184"/>
              <a:gd name="T10" fmla="*/ 41 w 185"/>
              <a:gd name="T11" fmla="*/ 15 h 184"/>
              <a:gd name="T12" fmla="*/ 57 w 185"/>
              <a:gd name="T13" fmla="*/ 7 h 184"/>
              <a:gd name="T14" fmla="*/ 75 w 185"/>
              <a:gd name="T15" fmla="*/ 1 h 184"/>
              <a:gd name="T16" fmla="*/ 92 w 185"/>
              <a:gd name="T17" fmla="*/ 0 h 184"/>
              <a:gd name="T18" fmla="*/ 101 w 185"/>
              <a:gd name="T19" fmla="*/ 0 h 184"/>
              <a:gd name="T20" fmla="*/ 119 w 185"/>
              <a:gd name="T21" fmla="*/ 4 h 184"/>
              <a:gd name="T22" fmla="*/ 136 w 185"/>
              <a:gd name="T23" fmla="*/ 11 h 184"/>
              <a:gd name="T24" fmla="*/ 151 w 185"/>
              <a:gd name="T25" fmla="*/ 20 h 184"/>
              <a:gd name="T26" fmla="*/ 164 w 185"/>
              <a:gd name="T27" fmla="*/ 33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0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7 h 184"/>
              <a:gd name="T46" fmla="*/ 128 w 185"/>
              <a:gd name="T47" fmla="*/ 176 h 184"/>
              <a:gd name="T48" fmla="*/ 112 w 185"/>
              <a:gd name="T49" fmla="*/ 182 h 184"/>
              <a:gd name="T50" fmla="*/ 92 w 185"/>
              <a:gd name="T51" fmla="*/ 184 h 184"/>
              <a:gd name="T52" fmla="*/ 83 w 185"/>
              <a:gd name="T53" fmla="*/ 183 h 184"/>
              <a:gd name="T54" fmla="*/ 66 w 185"/>
              <a:gd name="T55" fmla="*/ 180 h 184"/>
              <a:gd name="T56" fmla="*/ 49 w 185"/>
              <a:gd name="T57" fmla="*/ 173 h 184"/>
              <a:gd name="T58" fmla="*/ 34 w 185"/>
              <a:gd name="T59" fmla="*/ 162 h 184"/>
              <a:gd name="T60" fmla="*/ 22 w 185"/>
              <a:gd name="T61" fmla="*/ 151 h 184"/>
              <a:gd name="T62" fmla="*/ 12 w 185"/>
              <a:gd name="T63" fmla="*/ 135 h 184"/>
              <a:gd name="T64" fmla="*/ 4 w 185"/>
              <a:gd name="T65" fmla="*/ 119 h 184"/>
              <a:gd name="T66" fmla="*/ 2 w 185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3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3"/>
                </a:lnTo>
                <a:lnTo>
                  <a:pt x="27" y="27"/>
                </a:lnTo>
                <a:lnTo>
                  <a:pt x="34" y="20"/>
                </a:lnTo>
                <a:lnTo>
                  <a:pt x="41" y="15"/>
                </a:lnTo>
                <a:lnTo>
                  <a:pt x="49" y="11"/>
                </a:lnTo>
                <a:lnTo>
                  <a:pt x="57" y="7"/>
                </a:lnTo>
                <a:lnTo>
                  <a:pt x="66" y="4"/>
                </a:lnTo>
                <a:lnTo>
                  <a:pt x="75" y="1"/>
                </a:lnTo>
                <a:lnTo>
                  <a:pt x="83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2" y="1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4" y="15"/>
                </a:lnTo>
                <a:lnTo>
                  <a:pt x="151" y="20"/>
                </a:lnTo>
                <a:lnTo>
                  <a:pt x="158" y="27"/>
                </a:lnTo>
                <a:lnTo>
                  <a:pt x="164" y="33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3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1"/>
                </a:lnTo>
                <a:lnTo>
                  <a:pt x="183" y="110"/>
                </a:lnTo>
                <a:lnTo>
                  <a:pt x="181" y="119"/>
                </a:lnTo>
                <a:lnTo>
                  <a:pt x="177" y="128"/>
                </a:lnTo>
                <a:lnTo>
                  <a:pt x="173" y="135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2"/>
                </a:lnTo>
                <a:lnTo>
                  <a:pt x="144" y="167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2" y="182"/>
                </a:lnTo>
                <a:lnTo>
                  <a:pt x="101" y="183"/>
                </a:lnTo>
                <a:lnTo>
                  <a:pt x="92" y="184"/>
                </a:lnTo>
                <a:lnTo>
                  <a:pt x="92" y="184"/>
                </a:lnTo>
                <a:lnTo>
                  <a:pt x="83" y="183"/>
                </a:lnTo>
                <a:lnTo>
                  <a:pt x="75" y="182"/>
                </a:lnTo>
                <a:lnTo>
                  <a:pt x="66" y="180"/>
                </a:lnTo>
                <a:lnTo>
                  <a:pt x="57" y="176"/>
                </a:lnTo>
                <a:lnTo>
                  <a:pt x="49" y="173"/>
                </a:lnTo>
                <a:lnTo>
                  <a:pt x="41" y="167"/>
                </a:lnTo>
                <a:lnTo>
                  <a:pt x="34" y="162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5"/>
                </a:lnTo>
                <a:lnTo>
                  <a:pt x="8" y="128"/>
                </a:lnTo>
                <a:lnTo>
                  <a:pt x="4" y="119"/>
                </a:lnTo>
                <a:lnTo>
                  <a:pt x="3" y="110"/>
                </a:lnTo>
                <a:lnTo>
                  <a:pt x="2" y="101"/>
                </a:lnTo>
                <a:lnTo>
                  <a:pt x="0" y="92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Freeform 47">
            <a:extLst>
              <a:ext uri="{FF2B5EF4-FFF2-40B4-BE49-F238E27FC236}">
                <a16:creationId xmlns:a16="http://schemas.microsoft.com/office/drawing/2014/main" id="{504DA29C-37D0-40D5-861F-D27BEF69A801}"/>
              </a:ext>
            </a:extLst>
          </p:cNvPr>
          <p:cNvSpPr>
            <a:spLocks/>
          </p:cNvSpPr>
          <p:nvPr/>
        </p:nvSpPr>
        <p:spPr bwMode="auto">
          <a:xfrm>
            <a:off x="7454577" y="5188537"/>
            <a:ext cx="293688" cy="292100"/>
          </a:xfrm>
          <a:custGeom>
            <a:avLst/>
            <a:gdLst>
              <a:gd name="T0" fmla="*/ 0 w 185"/>
              <a:gd name="T1" fmla="*/ 92 h 184"/>
              <a:gd name="T2" fmla="*/ 3 w 185"/>
              <a:gd name="T3" fmla="*/ 73 h 184"/>
              <a:gd name="T4" fmla="*/ 8 w 185"/>
              <a:gd name="T5" fmla="*/ 56 h 184"/>
              <a:gd name="T6" fmla="*/ 17 w 185"/>
              <a:gd name="T7" fmla="*/ 41 h 184"/>
              <a:gd name="T8" fmla="*/ 27 w 185"/>
              <a:gd name="T9" fmla="*/ 27 h 184"/>
              <a:gd name="T10" fmla="*/ 41 w 185"/>
              <a:gd name="T11" fmla="*/ 15 h 184"/>
              <a:gd name="T12" fmla="*/ 57 w 185"/>
              <a:gd name="T13" fmla="*/ 7 h 184"/>
              <a:gd name="T14" fmla="*/ 75 w 185"/>
              <a:gd name="T15" fmla="*/ 1 h 184"/>
              <a:gd name="T16" fmla="*/ 92 w 185"/>
              <a:gd name="T17" fmla="*/ 0 h 184"/>
              <a:gd name="T18" fmla="*/ 101 w 185"/>
              <a:gd name="T19" fmla="*/ 0 h 184"/>
              <a:gd name="T20" fmla="*/ 119 w 185"/>
              <a:gd name="T21" fmla="*/ 4 h 184"/>
              <a:gd name="T22" fmla="*/ 136 w 185"/>
              <a:gd name="T23" fmla="*/ 11 h 184"/>
              <a:gd name="T24" fmla="*/ 151 w 185"/>
              <a:gd name="T25" fmla="*/ 20 h 184"/>
              <a:gd name="T26" fmla="*/ 164 w 185"/>
              <a:gd name="T27" fmla="*/ 33 h 184"/>
              <a:gd name="T28" fmla="*/ 173 w 185"/>
              <a:gd name="T29" fmla="*/ 48 h 184"/>
              <a:gd name="T30" fmla="*/ 181 w 185"/>
              <a:gd name="T31" fmla="*/ 65 h 184"/>
              <a:gd name="T32" fmla="*/ 185 w 185"/>
              <a:gd name="T33" fmla="*/ 83 h 184"/>
              <a:gd name="T34" fmla="*/ 185 w 185"/>
              <a:gd name="T35" fmla="*/ 92 h 184"/>
              <a:gd name="T36" fmla="*/ 183 w 185"/>
              <a:gd name="T37" fmla="*/ 110 h 184"/>
              <a:gd name="T38" fmla="*/ 177 w 185"/>
              <a:gd name="T39" fmla="*/ 128 h 184"/>
              <a:gd name="T40" fmla="*/ 169 w 185"/>
              <a:gd name="T41" fmla="*/ 143 h 184"/>
              <a:gd name="T42" fmla="*/ 158 w 185"/>
              <a:gd name="T43" fmla="*/ 157 h 184"/>
              <a:gd name="T44" fmla="*/ 144 w 185"/>
              <a:gd name="T45" fmla="*/ 167 h 184"/>
              <a:gd name="T46" fmla="*/ 128 w 185"/>
              <a:gd name="T47" fmla="*/ 176 h 184"/>
              <a:gd name="T48" fmla="*/ 112 w 185"/>
              <a:gd name="T49" fmla="*/ 182 h 184"/>
              <a:gd name="T50" fmla="*/ 92 w 185"/>
              <a:gd name="T51" fmla="*/ 184 h 184"/>
              <a:gd name="T52" fmla="*/ 83 w 185"/>
              <a:gd name="T53" fmla="*/ 183 h 184"/>
              <a:gd name="T54" fmla="*/ 66 w 185"/>
              <a:gd name="T55" fmla="*/ 180 h 184"/>
              <a:gd name="T56" fmla="*/ 49 w 185"/>
              <a:gd name="T57" fmla="*/ 173 h 184"/>
              <a:gd name="T58" fmla="*/ 34 w 185"/>
              <a:gd name="T59" fmla="*/ 162 h 184"/>
              <a:gd name="T60" fmla="*/ 22 w 185"/>
              <a:gd name="T61" fmla="*/ 151 h 184"/>
              <a:gd name="T62" fmla="*/ 12 w 185"/>
              <a:gd name="T63" fmla="*/ 135 h 184"/>
              <a:gd name="T64" fmla="*/ 4 w 185"/>
              <a:gd name="T65" fmla="*/ 119 h 184"/>
              <a:gd name="T66" fmla="*/ 2 w 185"/>
              <a:gd name="T67" fmla="*/ 101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</a:cxnLst>
            <a:rect l="0" t="0" r="r" b="b"/>
            <a:pathLst>
              <a:path w="185" h="184">
                <a:moveTo>
                  <a:pt x="0" y="92"/>
                </a:moveTo>
                <a:lnTo>
                  <a:pt x="0" y="92"/>
                </a:lnTo>
                <a:lnTo>
                  <a:pt x="2" y="83"/>
                </a:lnTo>
                <a:lnTo>
                  <a:pt x="3" y="73"/>
                </a:lnTo>
                <a:lnTo>
                  <a:pt x="4" y="65"/>
                </a:lnTo>
                <a:lnTo>
                  <a:pt x="8" y="56"/>
                </a:lnTo>
                <a:lnTo>
                  <a:pt x="12" y="48"/>
                </a:lnTo>
                <a:lnTo>
                  <a:pt x="17" y="41"/>
                </a:lnTo>
                <a:lnTo>
                  <a:pt x="22" y="33"/>
                </a:lnTo>
                <a:lnTo>
                  <a:pt x="27" y="27"/>
                </a:lnTo>
                <a:lnTo>
                  <a:pt x="34" y="20"/>
                </a:lnTo>
                <a:lnTo>
                  <a:pt x="41" y="15"/>
                </a:lnTo>
                <a:lnTo>
                  <a:pt x="49" y="11"/>
                </a:lnTo>
                <a:lnTo>
                  <a:pt x="57" y="7"/>
                </a:lnTo>
                <a:lnTo>
                  <a:pt x="66" y="4"/>
                </a:lnTo>
                <a:lnTo>
                  <a:pt x="75" y="1"/>
                </a:lnTo>
                <a:lnTo>
                  <a:pt x="83" y="0"/>
                </a:lnTo>
                <a:lnTo>
                  <a:pt x="92" y="0"/>
                </a:lnTo>
                <a:lnTo>
                  <a:pt x="92" y="0"/>
                </a:lnTo>
                <a:lnTo>
                  <a:pt x="101" y="0"/>
                </a:lnTo>
                <a:lnTo>
                  <a:pt x="112" y="1"/>
                </a:lnTo>
                <a:lnTo>
                  <a:pt x="119" y="4"/>
                </a:lnTo>
                <a:lnTo>
                  <a:pt x="128" y="7"/>
                </a:lnTo>
                <a:lnTo>
                  <a:pt x="136" y="11"/>
                </a:lnTo>
                <a:lnTo>
                  <a:pt x="144" y="15"/>
                </a:lnTo>
                <a:lnTo>
                  <a:pt x="151" y="20"/>
                </a:lnTo>
                <a:lnTo>
                  <a:pt x="158" y="27"/>
                </a:lnTo>
                <a:lnTo>
                  <a:pt x="164" y="33"/>
                </a:lnTo>
                <a:lnTo>
                  <a:pt x="169" y="41"/>
                </a:lnTo>
                <a:lnTo>
                  <a:pt x="173" y="48"/>
                </a:lnTo>
                <a:lnTo>
                  <a:pt x="177" y="56"/>
                </a:lnTo>
                <a:lnTo>
                  <a:pt x="181" y="65"/>
                </a:lnTo>
                <a:lnTo>
                  <a:pt x="183" y="73"/>
                </a:lnTo>
                <a:lnTo>
                  <a:pt x="185" y="83"/>
                </a:lnTo>
                <a:lnTo>
                  <a:pt x="185" y="92"/>
                </a:lnTo>
                <a:lnTo>
                  <a:pt x="185" y="92"/>
                </a:lnTo>
                <a:lnTo>
                  <a:pt x="185" y="101"/>
                </a:lnTo>
                <a:lnTo>
                  <a:pt x="183" y="110"/>
                </a:lnTo>
                <a:lnTo>
                  <a:pt x="181" y="119"/>
                </a:lnTo>
                <a:lnTo>
                  <a:pt x="177" y="128"/>
                </a:lnTo>
                <a:lnTo>
                  <a:pt x="173" y="135"/>
                </a:lnTo>
                <a:lnTo>
                  <a:pt x="169" y="143"/>
                </a:lnTo>
                <a:lnTo>
                  <a:pt x="164" y="151"/>
                </a:lnTo>
                <a:lnTo>
                  <a:pt x="158" y="157"/>
                </a:lnTo>
                <a:lnTo>
                  <a:pt x="151" y="162"/>
                </a:lnTo>
                <a:lnTo>
                  <a:pt x="144" y="167"/>
                </a:lnTo>
                <a:lnTo>
                  <a:pt x="136" y="173"/>
                </a:lnTo>
                <a:lnTo>
                  <a:pt x="128" y="176"/>
                </a:lnTo>
                <a:lnTo>
                  <a:pt x="119" y="180"/>
                </a:lnTo>
                <a:lnTo>
                  <a:pt x="112" y="182"/>
                </a:lnTo>
                <a:lnTo>
                  <a:pt x="101" y="183"/>
                </a:lnTo>
                <a:lnTo>
                  <a:pt x="92" y="184"/>
                </a:lnTo>
                <a:lnTo>
                  <a:pt x="92" y="184"/>
                </a:lnTo>
                <a:lnTo>
                  <a:pt x="83" y="183"/>
                </a:lnTo>
                <a:lnTo>
                  <a:pt x="75" y="182"/>
                </a:lnTo>
                <a:lnTo>
                  <a:pt x="66" y="180"/>
                </a:lnTo>
                <a:lnTo>
                  <a:pt x="57" y="176"/>
                </a:lnTo>
                <a:lnTo>
                  <a:pt x="49" y="173"/>
                </a:lnTo>
                <a:lnTo>
                  <a:pt x="41" y="167"/>
                </a:lnTo>
                <a:lnTo>
                  <a:pt x="34" y="162"/>
                </a:lnTo>
                <a:lnTo>
                  <a:pt x="27" y="157"/>
                </a:lnTo>
                <a:lnTo>
                  <a:pt x="22" y="151"/>
                </a:lnTo>
                <a:lnTo>
                  <a:pt x="17" y="143"/>
                </a:lnTo>
                <a:lnTo>
                  <a:pt x="12" y="135"/>
                </a:lnTo>
                <a:lnTo>
                  <a:pt x="8" y="128"/>
                </a:lnTo>
                <a:lnTo>
                  <a:pt x="4" y="119"/>
                </a:lnTo>
                <a:lnTo>
                  <a:pt x="3" y="110"/>
                </a:lnTo>
                <a:lnTo>
                  <a:pt x="2" y="101"/>
                </a:lnTo>
                <a:lnTo>
                  <a:pt x="0" y="92"/>
                </a:lnTo>
              </a:path>
            </a:pathLst>
          </a:cu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48">
            <a:extLst>
              <a:ext uri="{FF2B5EF4-FFF2-40B4-BE49-F238E27FC236}">
                <a16:creationId xmlns:a16="http://schemas.microsoft.com/office/drawing/2014/main" id="{4D5E145E-BDF8-4F45-84B7-8A415A346C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95633" y="4024383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53" name="Rectangle 49">
            <a:extLst>
              <a:ext uri="{FF2B5EF4-FFF2-40B4-BE49-F238E27FC236}">
                <a16:creationId xmlns:a16="http://schemas.microsoft.com/office/drawing/2014/main" id="{6914BA8D-DB2A-4D29-BD7A-3A3AF9CD1E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74488" y="2533721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4" name="Rectangle 50">
            <a:extLst>
              <a:ext uri="{FF2B5EF4-FFF2-40B4-BE49-F238E27FC236}">
                <a16:creationId xmlns:a16="http://schemas.microsoft.com/office/drawing/2014/main" id="{644DB75F-66FB-489B-8AF5-9D1D53A26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1720895"/>
            <a:ext cx="9778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→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5" name="Rectangle 51">
            <a:extLst>
              <a:ext uri="{FF2B5EF4-FFF2-40B4-BE49-F238E27FC236}">
                <a16:creationId xmlns:a16="http://schemas.microsoft.com/office/drawing/2014/main" id="{E7BA13BC-22C6-46A9-8059-FAEB8F9EC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99059" y="1965654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6" name="Rectangle 52">
            <a:extLst>
              <a:ext uri="{FF2B5EF4-FFF2-40B4-BE49-F238E27FC236}">
                <a16:creationId xmlns:a16="http://schemas.microsoft.com/office/drawing/2014/main" id="{F5045ED9-F0E3-4E83-9BA6-008A1C6E17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9777" y="3278781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57" name="Rectangle 53">
            <a:extLst>
              <a:ext uri="{FF2B5EF4-FFF2-40B4-BE49-F238E27FC236}">
                <a16:creationId xmlns:a16="http://schemas.microsoft.com/office/drawing/2014/main" id="{D32587AF-980E-4B53-9F74-28EBBC7362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1655" y="4763087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58" name="Rectangle 54">
            <a:extLst>
              <a:ext uri="{FF2B5EF4-FFF2-40B4-BE49-F238E27FC236}">
                <a16:creationId xmlns:a16="http://schemas.microsoft.com/office/drawing/2014/main" id="{69DF8D96-59F6-40AE-A101-E91BC93B53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0043" y="5945517"/>
            <a:ext cx="9698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59" name="Rectangle 55">
            <a:extLst>
              <a:ext uri="{FF2B5EF4-FFF2-40B4-BE49-F238E27FC236}">
                <a16:creationId xmlns:a16="http://schemas.microsoft.com/office/drawing/2014/main" id="{3B0B2F73-1CA0-4A00-9B2A-EAE45C7FF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6000" y="6151633"/>
            <a:ext cx="7950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-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DM1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60" name="Rectangle 56">
            <a:extLst>
              <a:ext uri="{FF2B5EF4-FFF2-40B4-BE49-F238E27FC236}">
                <a16:creationId xmlns:a16="http://schemas.microsoft.com/office/drawing/2014/main" id="{2093889B-608C-4C31-B08C-414D3C074A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6713" y="5473235"/>
            <a:ext cx="72295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</p:spTree>
    <p:extLst>
      <p:ext uri="{BB962C8B-B14F-4D97-AF65-F5344CB8AC3E}">
        <p14:creationId xmlns:p14="http://schemas.microsoft.com/office/powerpoint/2010/main" val="2722850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3D3AD3ED-4052-42B4-AFDF-5A4B81D2B1C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4750" y="3357563"/>
            <a:ext cx="2508250" cy="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BE940312-3815-44FF-BB35-0391489974B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76813" y="2438400"/>
            <a:ext cx="2128838" cy="8794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FFD85E1B-D638-4176-84EF-1B11B45BF7C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353050" y="2470150"/>
            <a:ext cx="1774825" cy="17732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25F1AFAA-4C9F-4254-90AF-DBB578A9DF1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54588" y="2071688"/>
            <a:ext cx="1212850" cy="1214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4B8893F3-624D-4607-8BC6-CD1C43C993A1}"/>
              </a:ext>
            </a:extLst>
          </p:cNvPr>
          <p:cNvSpPr>
            <a:spLocks noChangeShapeType="1"/>
          </p:cNvSpPr>
          <p:nvPr/>
        </p:nvSpPr>
        <p:spPr bwMode="auto">
          <a:xfrm>
            <a:off x="6238875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E42A20EF-0507-4845-BFDE-653275427E88}"/>
              </a:ext>
            </a:extLst>
          </p:cNvPr>
          <p:cNvSpPr>
            <a:spLocks noChangeShapeType="1"/>
          </p:cNvSpPr>
          <p:nvPr/>
        </p:nvSpPr>
        <p:spPr bwMode="auto">
          <a:xfrm>
            <a:off x="6278563" y="2093913"/>
            <a:ext cx="881063" cy="21272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BEC4025B-A9BA-46EF-8403-794FBA16DB29}"/>
              </a:ext>
            </a:extLst>
          </p:cNvPr>
          <p:cNvSpPr>
            <a:spLocks noChangeShapeType="1"/>
          </p:cNvSpPr>
          <p:nvPr/>
        </p:nvSpPr>
        <p:spPr bwMode="auto">
          <a:xfrm>
            <a:off x="5318125" y="2492375"/>
            <a:ext cx="881063" cy="21272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CDFDDBCB-5838-4CB6-972E-571C2488A05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2838" y="3449638"/>
            <a:ext cx="319088" cy="77152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18118DE5-7800-47F8-B174-713F1977C3D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4588" y="3430588"/>
            <a:ext cx="1212850" cy="12112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5">
            <a:extLst>
              <a:ext uri="{FF2B5EF4-FFF2-40B4-BE49-F238E27FC236}">
                <a16:creationId xmlns:a16="http://schemas.microsoft.com/office/drawing/2014/main" id="{21BF7266-7100-4ABB-A0CB-2F22199A2D2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76813" y="3395663"/>
            <a:ext cx="2128838" cy="8826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6">
            <a:extLst>
              <a:ext uri="{FF2B5EF4-FFF2-40B4-BE49-F238E27FC236}">
                <a16:creationId xmlns:a16="http://schemas.microsoft.com/office/drawing/2014/main" id="{E37D23B9-ACE6-49B8-8E3A-3B33D1E75E5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334125" y="4356100"/>
            <a:ext cx="771525" cy="3175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4FEE9992-3F85-4645-AC31-A8233473035B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57642AB0-FF0C-4994-A308-581872963CA2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E5974213-EF4D-4DF2-B8BD-5E150CA79DF0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4E3A2D86-0478-4D41-B80E-BFCF9C4AB708}"/>
              </a:ext>
            </a:extLst>
          </p:cNvPr>
          <p:cNvSpPr>
            <a:spLocks/>
          </p:cNvSpPr>
          <p:nvPr/>
        </p:nvSpPr>
        <p:spPr bwMode="auto">
          <a:xfrm>
            <a:off x="7097713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21">
            <a:extLst>
              <a:ext uri="{FF2B5EF4-FFF2-40B4-BE49-F238E27FC236}">
                <a16:creationId xmlns:a16="http://schemas.microsoft.com/office/drawing/2014/main" id="{D8DB849D-0E17-4A86-B13B-585113604321}"/>
              </a:ext>
            </a:extLst>
          </p:cNvPr>
          <p:cNvSpPr>
            <a:spLocks/>
          </p:cNvSpPr>
          <p:nvPr/>
        </p:nvSpPr>
        <p:spPr bwMode="auto">
          <a:xfrm>
            <a:off x="7097713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2E9C4E34-3F9B-465B-AD8C-A5BA992E1DE3}"/>
              </a:ext>
            </a:extLst>
          </p:cNvPr>
          <p:cNvSpPr>
            <a:spLocks/>
          </p:cNvSpPr>
          <p:nvPr/>
        </p:nvSpPr>
        <p:spPr bwMode="auto">
          <a:xfrm>
            <a:off x="7097713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3">
            <a:extLst>
              <a:ext uri="{FF2B5EF4-FFF2-40B4-BE49-F238E27FC236}">
                <a16:creationId xmlns:a16="http://schemas.microsoft.com/office/drawing/2014/main" id="{D08EBE3A-D658-49E4-9628-0BBF4C54A9B2}"/>
              </a:ext>
            </a:extLst>
          </p:cNvPr>
          <p:cNvSpPr>
            <a:spLocks/>
          </p:cNvSpPr>
          <p:nvPr/>
        </p:nvSpPr>
        <p:spPr bwMode="auto">
          <a:xfrm>
            <a:off x="613727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5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2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4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4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2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5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8"/>
                </a:lnTo>
                <a:lnTo>
                  <a:pt x="117" y="99"/>
                </a:lnTo>
                <a:lnTo>
                  <a:pt x="110" y="108"/>
                </a:lnTo>
                <a:lnTo>
                  <a:pt x="100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B4AD1789-84D0-48FF-8E61-88473346880F}"/>
              </a:ext>
            </a:extLst>
          </p:cNvPr>
          <p:cNvSpPr>
            <a:spLocks/>
          </p:cNvSpPr>
          <p:nvPr/>
        </p:nvSpPr>
        <p:spPr bwMode="auto">
          <a:xfrm>
            <a:off x="613727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5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2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4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4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2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5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8"/>
                </a:lnTo>
                <a:lnTo>
                  <a:pt x="117" y="99"/>
                </a:lnTo>
                <a:lnTo>
                  <a:pt x="110" y="108"/>
                </a:lnTo>
                <a:lnTo>
                  <a:pt x="100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1EE0B9AD-C92D-4DB5-B008-ECCC8095D9EE}"/>
              </a:ext>
            </a:extLst>
          </p:cNvPr>
          <p:cNvSpPr>
            <a:spLocks/>
          </p:cNvSpPr>
          <p:nvPr/>
        </p:nvSpPr>
        <p:spPr bwMode="auto">
          <a:xfrm>
            <a:off x="613727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5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2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4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4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2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5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8"/>
                </a:lnTo>
                <a:lnTo>
                  <a:pt x="117" y="99"/>
                </a:lnTo>
                <a:lnTo>
                  <a:pt x="110" y="108"/>
                </a:lnTo>
                <a:lnTo>
                  <a:pt x="100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E56D9D12-153F-4D24-962C-72B46E018F02}"/>
              </a:ext>
            </a:extLst>
          </p:cNvPr>
          <p:cNvSpPr>
            <a:spLocks/>
          </p:cNvSpPr>
          <p:nvPr/>
        </p:nvSpPr>
        <p:spPr bwMode="auto">
          <a:xfrm>
            <a:off x="5178425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8 h 129"/>
              <a:gd name="T32" fmla="*/ 123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8"/>
                </a:lnTo>
                <a:lnTo>
                  <a:pt x="123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FE889901-8326-4149-B211-EEADC92FD199}"/>
              </a:ext>
            </a:extLst>
          </p:cNvPr>
          <p:cNvSpPr>
            <a:spLocks/>
          </p:cNvSpPr>
          <p:nvPr/>
        </p:nvSpPr>
        <p:spPr bwMode="auto">
          <a:xfrm>
            <a:off x="5178425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8 h 129"/>
              <a:gd name="T32" fmla="*/ 123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8"/>
                </a:lnTo>
                <a:lnTo>
                  <a:pt x="123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4DAB40AE-B36B-4FE0-8250-D4A8CED38E2E}"/>
              </a:ext>
            </a:extLst>
          </p:cNvPr>
          <p:cNvSpPr>
            <a:spLocks/>
          </p:cNvSpPr>
          <p:nvPr/>
        </p:nvSpPr>
        <p:spPr bwMode="auto">
          <a:xfrm>
            <a:off x="5178425" y="22955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39 h 129"/>
              <a:gd name="T8" fmla="*/ 11 w 127"/>
              <a:gd name="T9" fmla="*/ 28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8 h 129"/>
              <a:gd name="T32" fmla="*/ 123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8"/>
                </a:lnTo>
                <a:lnTo>
                  <a:pt x="123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873566B6-0A70-4DB4-A946-E6F7B7EE2A6C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DB576F4B-EF05-4217-9D71-07439D7434B7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EBE4EAA5-F342-470E-B395-4D1C5BF2F072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AA45C06A-8D03-4CDC-90B0-B1C3BE9733CE}"/>
              </a:ext>
            </a:extLst>
          </p:cNvPr>
          <p:cNvSpPr>
            <a:spLocks/>
          </p:cNvSpPr>
          <p:nvPr/>
        </p:nvSpPr>
        <p:spPr bwMode="auto">
          <a:xfrm>
            <a:off x="5178425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9 h 129"/>
              <a:gd name="T32" fmla="*/ 123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9"/>
                </a:lnTo>
                <a:lnTo>
                  <a:pt x="123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3">
            <a:extLst>
              <a:ext uri="{FF2B5EF4-FFF2-40B4-BE49-F238E27FC236}">
                <a16:creationId xmlns:a16="http://schemas.microsoft.com/office/drawing/2014/main" id="{79E75509-3A0A-4082-9C56-5F8472EBC19A}"/>
              </a:ext>
            </a:extLst>
          </p:cNvPr>
          <p:cNvSpPr>
            <a:spLocks/>
          </p:cNvSpPr>
          <p:nvPr/>
        </p:nvSpPr>
        <p:spPr bwMode="auto">
          <a:xfrm>
            <a:off x="5178425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9 h 129"/>
              <a:gd name="T32" fmla="*/ 123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9"/>
                </a:lnTo>
                <a:lnTo>
                  <a:pt x="123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4">
            <a:extLst>
              <a:ext uri="{FF2B5EF4-FFF2-40B4-BE49-F238E27FC236}">
                <a16:creationId xmlns:a16="http://schemas.microsoft.com/office/drawing/2014/main" id="{474A408C-C8DA-4ECC-81CE-4D57A9D129AE}"/>
              </a:ext>
            </a:extLst>
          </p:cNvPr>
          <p:cNvSpPr>
            <a:spLocks/>
          </p:cNvSpPr>
          <p:nvPr/>
        </p:nvSpPr>
        <p:spPr bwMode="auto">
          <a:xfrm>
            <a:off x="5178425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2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9 w 127"/>
              <a:gd name="T13" fmla="*/ 11 h 129"/>
              <a:gd name="T14" fmla="*/ 40 w 127"/>
              <a:gd name="T15" fmla="*/ 7 h 129"/>
              <a:gd name="T16" fmla="*/ 51 w 127"/>
              <a:gd name="T17" fmla="*/ 2 h 129"/>
              <a:gd name="T18" fmla="*/ 65 w 127"/>
              <a:gd name="T19" fmla="*/ 0 h 129"/>
              <a:gd name="T20" fmla="*/ 65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9 w 127"/>
              <a:gd name="T29" fmla="*/ 19 h 129"/>
              <a:gd name="T30" fmla="*/ 116 w 127"/>
              <a:gd name="T31" fmla="*/ 29 h 129"/>
              <a:gd name="T32" fmla="*/ 123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3 w 127"/>
              <a:gd name="T43" fmla="*/ 90 h 129"/>
              <a:gd name="T44" fmla="*/ 116 w 127"/>
              <a:gd name="T45" fmla="*/ 101 h 129"/>
              <a:gd name="T46" fmla="*/ 109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5 w 127"/>
              <a:gd name="T55" fmla="*/ 129 h 129"/>
              <a:gd name="T56" fmla="*/ 65 w 127"/>
              <a:gd name="T57" fmla="*/ 129 h 129"/>
              <a:gd name="T58" fmla="*/ 51 w 127"/>
              <a:gd name="T59" fmla="*/ 127 h 129"/>
              <a:gd name="T60" fmla="*/ 40 w 127"/>
              <a:gd name="T61" fmla="*/ 124 h 129"/>
              <a:gd name="T62" fmla="*/ 29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2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2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9" y="11"/>
                </a:lnTo>
                <a:lnTo>
                  <a:pt x="40" y="7"/>
                </a:lnTo>
                <a:lnTo>
                  <a:pt x="51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9" y="19"/>
                </a:lnTo>
                <a:lnTo>
                  <a:pt x="116" y="29"/>
                </a:lnTo>
                <a:lnTo>
                  <a:pt x="123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3" y="90"/>
                </a:lnTo>
                <a:lnTo>
                  <a:pt x="116" y="101"/>
                </a:lnTo>
                <a:lnTo>
                  <a:pt x="109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1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2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5">
            <a:extLst>
              <a:ext uri="{FF2B5EF4-FFF2-40B4-BE49-F238E27FC236}">
                <a16:creationId xmlns:a16="http://schemas.microsoft.com/office/drawing/2014/main" id="{03962483-A0A3-446C-953C-B8C883E432E8}"/>
              </a:ext>
            </a:extLst>
          </p:cNvPr>
          <p:cNvSpPr>
            <a:spLocks/>
          </p:cNvSpPr>
          <p:nvPr/>
        </p:nvSpPr>
        <p:spPr bwMode="auto">
          <a:xfrm>
            <a:off x="613727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5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2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2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5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Freeform 36">
            <a:extLst>
              <a:ext uri="{FF2B5EF4-FFF2-40B4-BE49-F238E27FC236}">
                <a16:creationId xmlns:a16="http://schemas.microsoft.com/office/drawing/2014/main" id="{087301AA-1A4C-4DF9-B47B-6713697108A4}"/>
              </a:ext>
            </a:extLst>
          </p:cNvPr>
          <p:cNvSpPr>
            <a:spLocks/>
          </p:cNvSpPr>
          <p:nvPr/>
        </p:nvSpPr>
        <p:spPr bwMode="auto">
          <a:xfrm>
            <a:off x="613727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5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2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2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5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Freeform 37">
            <a:extLst>
              <a:ext uri="{FF2B5EF4-FFF2-40B4-BE49-F238E27FC236}">
                <a16:creationId xmlns:a16="http://schemas.microsoft.com/office/drawing/2014/main" id="{B314AB3E-C039-4E27-9168-D0BA67B52748}"/>
              </a:ext>
            </a:extLst>
          </p:cNvPr>
          <p:cNvSpPr>
            <a:spLocks/>
          </p:cNvSpPr>
          <p:nvPr/>
        </p:nvSpPr>
        <p:spPr bwMode="auto">
          <a:xfrm>
            <a:off x="613727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5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2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2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5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Freeform 38">
            <a:extLst>
              <a:ext uri="{FF2B5EF4-FFF2-40B4-BE49-F238E27FC236}">
                <a16:creationId xmlns:a16="http://schemas.microsoft.com/office/drawing/2014/main" id="{39884325-14FE-4E16-9EB0-10A51D2DA86E}"/>
              </a:ext>
            </a:extLst>
          </p:cNvPr>
          <p:cNvSpPr>
            <a:spLocks/>
          </p:cNvSpPr>
          <p:nvPr/>
        </p:nvSpPr>
        <p:spPr bwMode="auto">
          <a:xfrm>
            <a:off x="7097713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9 h 129"/>
              <a:gd name="T32" fmla="*/ 122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9"/>
                </a:lnTo>
                <a:lnTo>
                  <a:pt x="122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Freeform 39">
            <a:extLst>
              <a:ext uri="{FF2B5EF4-FFF2-40B4-BE49-F238E27FC236}">
                <a16:creationId xmlns:a16="http://schemas.microsoft.com/office/drawing/2014/main" id="{65DD49C5-2DB4-4A01-BAF7-BB33C884825A}"/>
              </a:ext>
            </a:extLst>
          </p:cNvPr>
          <p:cNvSpPr>
            <a:spLocks/>
          </p:cNvSpPr>
          <p:nvPr/>
        </p:nvSpPr>
        <p:spPr bwMode="auto">
          <a:xfrm>
            <a:off x="7097713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9 h 129"/>
              <a:gd name="T32" fmla="*/ 122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9"/>
                </a:lnTo>
                <a:lnTo>
                  <a:pt x="122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Freeform 40">
            <a:extLst>
              <a:ext uri="{FF2B5EF4-FFF2-40B4-BE49-F238E27FC236}">
                <a16:creationId xmlns:a16="http://schemas.microsoft.com/office/drawing/2014/main" id="{1C93A0B7-F0BF-465D-9BC4-DB9E92362567}"/>
              </a:ext>
            </a:extLst>
          </p:cNvPr>
          <p:cNvSpPr>
            <a:spLocks/>
          </p:cNvSpPr>
          <p:nvPr/>
        </p:nvSpPr>
        <p:spPr bwMode="auto">
          <a:xfrm>
            <a:off x="7097713" y="421322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1 w 127"/>
              <a:gd name="T5" fmla="*/ 52 h 129"/>
              <a:gd name="T6" fmla="*/ 5 w 127"/>
              <a:gd name="T7" fmla="*/ 40 h 129"/>
              <a:gd name="T8" fmla="*/ 11 w 127"/>
              <a:gd name="T9" fmla="*/ 29 h 129"/>
              <a:gd name="T10" fmla="*/ 19 w 127"/>
              <a:gd name="T11" fmla="*/ 19 h 129"/>
              <a:gd name="T12" fmla="*/ 28 w 127"/>
              <a:gd name="T13" fmla="*/ 11 h 129"/>
              <a:gd name="T14" fmla="*/ 39 w 127"/>
              <a:gd name="T15" fmla="*/ 7 h 129"/>
              <a:gd name="T16" fmla="*/ 50 w 127"/>
              <a:gd name="T17" fmla="*/ 2 h 129"/>
              <a:gd name="T18" fmla="*/ 64 w 127"/>
              <a:gd name="T19" fmla="*/ 0 h 129"/>
              <a:gd name="T20" fmla="*/ 64 w 127"/>
              <a:gd name="T21" fmla="*/ 0 h 129"/>
              <a:gd name="T22" fmla="*/ 77 w 127"/>
              <a:gd name="T23" fmla="*/ 2 h 129"/>
              <a:gd name="T24" fmla="*/ 88 w 127"/>
              <a:gd name="T25" fmla="*/ 7 h 129"/>
              <a:gd name="T26" fmla="*/ 99 w 127"/>
              <a:gd name="T27" fmla="*/ 11 h 129"/>
              <a:gd name="T28" fmla="*/ 108 w 127"/>
              <a:gd name="T29" fmla="*/ 19 h 129"/>
              <a:gd name="T30" fmla="*/ 116 w 127"/>
              <a:gd name="T31" fmla="*/ 29 h 129"/>
              <a:gd name="T32" fmla="*/ 122 w 127"/>
              <a:gd name="T33" fmla="*/ 40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9 w 127"/>
              <a:gd name="T49" fmla="*/ 118 h 129"/>
              <a:gd name="T50" fmla="*/ 88 w 127"/>
              <a:gd name="T51" fmla="*/ 124 h 129"/>
              <a:gd name="T52" fmla="*/ 77 w 127"/>
              <a:gd name="T53" fmla="*/ 127 h 129"/>
              <a:gd name="T54" fmla="*/ 64 w 127"/>
              <a:gd name="T55" fmla="*/ 129 h 129"/>
              <a:gd name="T56" fmla="*/ 64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9 w 127"/>
              <a:gd name="T65" fmla="*/ 110 h 129"/>
              <a:gd name="T66" fmla="*/ 11 w 127"/>
              <a:gd name="T67" fmla="*/ 101 h 129"/>
              <a:gd name="T68" fmla="*/ 5 w 127"/>
              <a:gd name="T69" fmla="*/ 90 h 129"/>
              <a:gd name="T70" fmla="*/ 1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5" y="40"/>
                </a:lnTo>
                <a:lnTo>
                  <a:pt x="11" y="29"/>
                </a:lnTo>
                <a:lnTo>
                  <a:pt x="19" y="19"/>
                </a:lnTo>
                <a:lnTo>
                  <a:pt x="28" y="11"/>
                </a:lnTo>
                <a:lnTo>
                  <a:pt x="39" y="7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8" y="7"/>
                </a:lnTo>
                <a:lnTo>
                  <a:pt x="99" y="11"/>
                </a:lnTo>
                <a:lnTo>
                  <a:pt x="108" y="19"/>
                </a:lnTo>
                <a:lnTo>
                  <a:pt x="116" y="29"/>
                </a:lnTo>
                <a:lnTo>
                  <a:pt x="122" y="40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9" y="118"/>
                </a:lnTo>
                <a:lnTo>
                  <a:pt x="88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1"/>
                </a:lnTo>
                <a:lnTo>
                  <a:pt x="5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7A20F951-A4F5-444E-B2B9-3AF841061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45401" y="3255963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81091761-8F7C-464F-A706-3AAA75B451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0378" y="2122230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AFDB34A0-4E71-4C49-AD0B-C6E15EEE85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9462" y="1680111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7" name="Rectangle 44">
            <a:extLst>
              <a:ext uri="{FF2B5EF4-FFF2-40B4-BE49-F238E27FC236}">
                <a16:creationId xmlns:a16="http://schemas.microsoft.com/office/drawing/2014/main" id="{19A7E5D3-B4C1-408C-9374-70F97F0CB2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3593" y="2168674"/>
            <a:ext cx="10419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zmb+T-DM1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8" name="Rectangle 45">
            <a:extLst>
              <a:ext uri="{FF2B5EF4-FFF2-40B4-BE49-F238E27FC236}">
                <a16:creationId xmlns:a16="http://schemas.microsoft.com/office/drawing/2014/main" id="{007324A3-3261-4743-BE03-32F2DF6291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3643" y="3261258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9" name="Rectangle 46">
            <a:extLst>
              <a:ext uri="{FF2B5EF4-FFF2-40B4-BE49-F238E27FC236}">
                <a16:creationId xmlns:a16="http://schemas.microsoft.com/office/drawing/2014/main" id="{16B13300-113A-4D02-9650-F34F305A46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5528" y="4437462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0" name="Rectangle 47">
            <a:extLst>
              <a:ext uri="{FF2B5EF4-FFF2-40B4-BE49-F238E27FC236}">
                <a16:creationId xmlns:a16="http://schemas.microsoft.com/office/drawing/2014/main" id="{F30DF764-DD87-4637-BA54-59590CF0BF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29117" y="4828824"/>
            <a:ext cx="9698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8E391658-314D-4870-891D-89811237A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9090" y="4434959"/>
            <a:ext cx="72295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1C19684A-9266-4EA9-A6DB-D309F48DB0DF}"/>
              </a:ext>
            </a:extLst>
          </p:cNvPr>
          <p:cNvSpPr txBox="1"/>
          <p:nvPr/>
        </p:nvSpPr>
        <p:spPr>
          <a:xfrm>
            <a:off x="2983894" y="12723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5677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443EF496-A4B8-4D98-B124-0D3285FDA5E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4750" y="3357563"/>
            <a:ext cx="2508250" cy="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AC29E36D-6012-442E-AEDB-8BB8A253EC7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67288" y="2057400"/>
            <a:ext cx="1866900" cy="12430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5526A5C6-6161-43E1-AF77-EB35EAFB038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607050" y="2092325"/>
            <a:ext cx="1263650" cy="252888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0CAE7013-6C16-4275-9100-4C60CE51C172}"/>
              </a:ext>
            </a:extLst>
          </p:cNvPr>
          <p:cNvSpPr>
            <a:spLocks noChangeShapeType="1"/>
          </p:cNvSpPr>
          <p:nvPr/>
        </p:nvSpPr>
        <p:spPr bwMode="auto">
          <a:xfrm>
            <a:off x="6918325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C23AD0C8-4C94-4596-89E3-B49CD6A1A5E8}"/>
              </a:ext>
            </a:extLst>
          </p:cNvPr>
          <p:cNvSpPr>
            <a:spLocks noChangeShapeType="1"/>
          </p:cNvSpPr>
          <p:nvPr/>
        </p:nvSpPr>
        <p:spPr bwMode="auto">
          <a:xfrm>
            <a:off x="5562600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19EFF984-CFC5-4DEA-9FC7-62D9C74A384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7600" y="3448050"/>
            <a:ext cx="587375" cy="11731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4B61E1B8-DE29-4FBC-B971-C156D1ADE6B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7288" y="3413125"/>
            <a:ext cx="1866900" cy="12430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51DA0FAF-7A86-4AF1-BC4B-9C83BC9A8388}"/>
              </a:ext>
            </a:extLst>
          </p:cNvPr>
          <p:cNvSpPr>
            <a:spLocks noChangeShapeType="1"/>
          </p:cNvSpPr>
          <p:nvPr/>
        </p:nvSpPr>
        <p:spPr bwMode="auto">
          <a:xfrm>
            <a:off x="5661025" y="4713288"/>
            <a:ext cx="1155700" cy="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14">
            <a:extLst>
              <a:ext uri="{FF2B5EF4-FFF2-40B4-BE49-F238E27FC236}">
                <a16:creationId xmlns:a16="http://schemas.microsoft.com/office/drawing/2014/main" id="{667A10E8-0704-4E7E-96E2-1EDCDF49FC25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15">
            <a:extLst>
              <a:ext uri="{FF2B5EF4-FFF2-40B4-BE49-F238E27FC236}">
                <a16:creationId xmlns:a16="http://schemas.microsoft.com/office/drawing/2014/main" id="{94A01F92-A4FE-4233-96A2-91661A403BAE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6A7DA520-3490-476A-88A1-E3385BC6E361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A6A14CF6-9A9C-4FE0-857C-7B419031ECE1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2C1F8179-C2CE-4419-970A-EB8B42DDCCEF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A95E4528-38CE-467B-9EC3-AEB6C8FC636F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1B7FC5BC-A08E-49EF-9477-237C51265F83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21">
            <a:extLst>
              <a:ext uri="{FF2B5EF4-FFF2-40B4-BE49-F238E27FC236}">
                <a16:creationId xmlns:a16="http://schemas.microsoft.com/office/drawing/2014/main" id="{AB10D0AC-67A6-4781-B404-9208CC2785B7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A8CD854C-ABDA-458F-9F58-B15A7049A29C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3">
            <a:extLst>
              <a:ext uri="{FF2B5EF4-FFF2-40B4-BE49-F238E27FC236}">
                <a16:creationId xmlns:a16="http://schemas.microsoft.com/office/drawing/2014/main" id="{943F4C2F-7F04-4460-BE57-5B47F5F5B792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4172CED3-2D84-4CE0-A828-4BA5DCBA359B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9A27BBB5-6C2D-4AC0-813E-556A3F2C7D91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F2C4CB51-166D-42F6-B0EA-263347ED8DEC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37E6C837-0927-49C7-9D36-E6986E37276E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B7B7FBD6-AD75-434F-A212-3DFC310F3B6F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A0905433-E1C8-4B45-AC9F-D3170B9B0427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A2B1A21E-3176-4D1A-B7DD-1DE5122BCC6D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D1085F35-F40A-4430-A4CA-08288E2CA004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2">
            <a:extLst>
              <a:ext uri="{FF2B5EF4-FFF2-40B4-BE49-F238E27FC236}">
                <a16:creationId xmlns:a16="http://schemas.microsoft.com/office/drawing/2014/main" id="{DCAFF7E2-1ED8-4FF6-93E8-E4EB356C55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9064" y="3279517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36" name="Rectangle 33">
            <a:extLst>
              <a:ext uri="{FF2B5EF4-FFF2-40B4-BE49-F238E27FC236}">
                <a16:creationId xmlns:a16="http://schemas.microsoft.com/office/drawing/2014/main" id="{68DE567C-61B5-4CD1-9630-E040CDF77F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5740" y="1686997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37" name="Rectangle 34">
            <a:extLst>
              <a:ext uri="{FF2B5EF4-FFF2-40B4-BE49-F238E27FC236}">
                <a16:creationId xmlns:a16="http://schemas.microsoft.com/office/drawing/2014/main" id="{43486DD1-B629-4515-A9A0-1ECA3FB95E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8770" y="1692144"/>
            <a:ext cx="10419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zmb+T-DM1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A6A74742-0165-4853-9B15-447AA76A20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43593" y="3276085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29F991FC-9AD6-4CA8-96D7-AFBEE4B2B9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964" y="4848225"/>
            <a:ext cx="9698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504FE93E-059D-4DAA-BA3F-5BE75FBD3B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55740" y="4843464"/>
            <a:ext cx="72295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B615B57-EAFB-4CCE-8894-7E5788174DF6}"/>
              </a:ext>
            </a:extLst>
          </p:cNvPr>
          <p:cNvSpPr txBox="1"/>
          <p:nvPr/>
        </p:nvSpPr>
        <p:spPr>
          <a:xfrm>
            <a:off x="3015426" y="13176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8754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0A90D2E3-8A82-4EEA-BAEA-4541CC512E9A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7405688" y="2714625"/>
            <a:ext cx="161925" cy="5461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41BDEEFF-45E1-44B6-AA9E-7D640D174B8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3163" y="3370263"/>
            <a:ext cx="2513013" cy="358775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8F05BA14-C939-4B0F-9293-260FE37ACEE6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864350" y="2176463"/>
            <a:ext cx="434975" cy="3730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713A3A7B-DEBE-4085-B796-46E6E200DD85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107113" y="2041525"/>
            <a:ext cx="1176338" cy="5334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0152E4EA-1FA0-4304-BB0A-14DAFD70C23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75225" y="2659063"/>
            <a:ext cx="2308225" cy="1042988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0C49B733-B36F-46D5-BA6D-6F93AFB0E9C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380038" y="2684463"/>
            <a:ext cx="1919288" cy="16414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D04D77D4-7B4B-46EF-8271-122E65F24B18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115050" y="2014538"/>
            <a:ext cx="571500" cy="825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089E9812-4981-4F2D-9815-BBB9518B890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59350" y="2176463"/>
            <a:ext cx="1749425" cy="150018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41753D72-913D-48E1-88B4-7555E5C03C7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37125" y="2087563"/>
            <a:ext cx="1020763" cy="157162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5">
            <a:extLst>
              <a:ext uri="{FF2B5EF4-FFF2-40B4-BE49-F238E27FC236}">
                <a16:creationId xmlns:a16="http://schemas.microsoft.com/office/drawing/2014/main" id="{73201E79-93F9-404A-B4E0-DBCACA284D8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13313" y="2420938"/>
            <a:ext cx="363538" cy="12255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6">
            <a:extLst>
              <a:ext uri="{FF2B5EF4-FFF2-40B4-BE49-F238E27FC236}">
                <a16:creationId xmlns:a16="http://schemas.microsoft.com/office/drawing/2014/main" id="{E93EDD3E-D254-4CA2-B275-EA99498AD6AF}"/>
              </a:ext>
            </a:extLst>
          </p:cNvPr>
          <p:cNvSpPr>
            <a:spLocks noChangeShapeType="1"/>
          </p:cNvSpPr>
          <p:nvPr/>
        </p:nvSpPr>
        <p:spPr bwMode="auto">
          <a:xfrm>
            <a:off x="5360988" y="2408238"/>
            <a:ext cx="1370013" cy="210978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Line 17">
            <a:extLst>
              <a:ext uri="{FF2B5EF4-FFF2-40B4-BE49-F238E27FC236}">
                <a16:creationId xmlns:a16="http://schemas.microsoft.com/office/drawing/2014/main" id="{6D027250-1FE8-4853-8ED4-2E98175BC742}"/>
              </a:ext>
            </a:extLst>
          </p:cNvPr>
          <p:cNvSpPr>
            <a:spLocks noChangeShapeType="1"/>
          </p:cNvSpPr>
          <p:nvPr/>
        </p:nvSpPr>
        <p:spPr bwMode="auto">
          <a:xfrm>
            <a:off x="5380038" y="2387600"/>
            <a:ext cx="1919288" cy="16446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Line 18">
            <a:extLst>
              <a:ext uri="{FF2B5EF4-FFF2-40B4-BE49-F238E27FC236}">
                <a16:creationId xmlns:a16="http://schemas.microsoft.com/office/drawing/2014/main" id="{62E55549-F423-4321-A22D-15F4EC5A5E51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9350" y="3036888"/>
            <a:ext cx="1749425" cy="150018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Line 19">
            <a:extLst>
              <a:ext uri="{FF2B5EF4-FFF2-40B4-BE49-F238E27FC236}">
                <a16:creationId xmlns:a16="http://schemas.microsoft.com/office/drawing/2014/main" id="{9A9CC450-FD3A-4587-B7BE-87EA89ED7C6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7125" y="3827463"/>
            <a:ext cx="311150" cy="4810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20">
            <a:extLst>
              <a:ext uri="{FF2B5EF4-FFF2-40B4-BE49-F238E27FC236}">
                <a16:creationId xmlns:a16="http://schemas.microsoft.com/office/drawing/2014/main" id="{5F378DCB-9DF9-426A-9720-D60561BC6578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9350" y="3808413"/>
            <a:ext cx="977900" cy="8382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ine 21">
            <a:extLst>
              <a:ext uri="{FF2B5EF4-FFF2-40B4-BE49-F238E27FC236}">
                <a16:creationId xmlns:a16="http://schemas.microsoft.com/office/drawing/2014/main" id="{3E85EC8A-D300-416C-95FA-CA99AC29F47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75225" y="3786188"/>
            <a:ext cx="1719263" cy="77628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Line 22">
            <a:extLst>
              <a:ext uri="{FF2B5EF4-FFF2-40B4-BE49-F238E27FC236}">
                <a16:creationId xmlns:a16="http://schemas.microsoft.com/office/drawing/2014/main" id="{FF995D63-0FE1-45EC-8169-1E0ED52C311E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3163" y="3759200"/>
            <a:ext cx="2290763" cy="325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Line 23">
            <a:extLst>
              <a:ext uri="{FF2B5EF4-FFF2-40B4-BE49-F238E27FC236}">
                <a16:creationId xmlns:a16="http://schemas.microsoft.com/office/drawing/2014/main" id="{DA6DC851-60A1-4D29-9BC2-71A88C98BFF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864350" y="4164013"/>
            <a:ext cx="434975" cy="3730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BD07DB49-222A-4D8A-9C67-26EC3DF37D34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48BCB175-A82F-4FFD-94CD-19B1B548ED40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3CD39F14-3801-4CA7-845C-E494ABCD847D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AF255DB6-8835-45AE-9A98-9C6B072916FF}"/>
              </a:ext>
            </a:extLst>
          </p:cNvPr>
          <p:cNvSpPr>
            <a:spLocks/>
          </p:cNvSpPr>
          <p:nvPr/>
        </p:nvSpPr>
        <p:spPr bwMode="auto">
          <a:xfrm>
            <a:off x="7273925" y="2514600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4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357E0B79-4A0E-4BD8-8D12-49DE42C3B39A}"/>
              </a:ext>
            </a:extLst>
          </p:cNvPr>
          <p:cNvSpPr>
            <a:spLocks/>
          </p:cNvSpPr>
          <p:nvPr/>
        </p:nvSpPr>
        <p:spPr bwMode="auto">
          <a:xfrm>
            <a:off x="7273925" y="2514600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4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8DC9D6AB-57F6-49ED-945C-F7B1200D58DC}"/>
              </a:ext>
            </a:extLst>
          </p:cNvPr>
          <p:cNvSpPr>
            <a:spLocks/>
          </p:cNvSpPr>
          <p:nvPr/>
        </p:nvSpPr>
        <p:spPr bwMode="auto">
          <a:xfrm>
            <a:off x="7273925" y="2514600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4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CA01CA85-BE67-4B29-8ED9-B3185AE7B3FA}"/>
              </a:ext>
            </a:extLst>
          </p:cNvPr>
          <p:cNvSpPr>
            <a:spLocks/>
          </p:cNvSpPr>
          <p:nvPr/>
        </p:nvSpPr>
        <p:spPr bwMode="auto">
          <a:xfrm>
            <a:off x="6684963" y="20097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6E3AA070-C4CB-44E1-B6C9-BF69CD246B86}"/>
              </a:ext>
            </a:extLst>
          </p:cNvPr>
          <p:cNvSpPr>
            <a:spLocks/>
          </p:cNvSpPr>
          <p:nvPr/>
        </p:nvSpPr>
        <p:spPr bwMode="auto">
          <a:xfrm>
            <a:off x="6684963" y="20097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12967F5E-7F66-4878-AFF2-388B137274AA}"/>
              </a:ext>
            </a:extLst>
          </p:cNvPr>
          <p:cNvSpPr>
            <a:spLocks/>
          </p:cNvSpPr>
          <p:nvPr/>
        </p:nvSpPr>
        <p:spPr bwMode="auto">
          <a:xfrm>
            <a:off x="6684963" y="20097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3">
            <a:extLst>
              <a:ext uri="{FF2B5EF4-FFF2-40B4-BE49-F238E27FC236}">
                <a16:creationId xmlns:a16="http://schemas.microsoft.com/office/drawing/2014/main" id="{8BA394B5-383D-4A90-BEA9-D2F23EFEFB00}"/>
              </a:ext>
            </a:extLst>
          </p:cNvPr>
          <p:cNvSpPr>
            <a:spLocks/>
          </p:cNvSpPr>
          <p:nvPr/>
        </p:nvSpPr>
        <p:spPr bwMode="auto">
          <a:xfrm>
            <a:off x="5913438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4">
            <a:extLst>
              <a:ext uri="{FF2B5EF4-FFF2-40B4-BE49-F238E27FC236}">
                <a16:creationId xmlns:a16="http://schemas.microsoft.com/office/drawing/2014/main" id="{D6F3E1FA-5062-4682-95BF-E3FE29DF8D88}"/>
              </a:ext>
            </a:extLst>
          </p:cNvPr>
          <p:cNvSpPr>
            <a:spLocks/>
          </p:cNvSpPr>
          <p:nvPr/>
        </p:nvSpPr>
        <p:spPr bwMode="auto">
          <a:xfrm>
            <a:off x="5913438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5">
            <a:extLst>
              <a:ext uri="{FF2B5EF4-FFF2-40B4-BE49-F238E27FC236}">
                <a16:creationId xmlns:a16="http://schemas.microsoft.com/office/drawing/2014/main" id="{6AEC6253-4F74-45DA-8BD9-160E5BFBF0E6}"/>
              </a:ext>
            </a:extLst>
          </p:cNvPr>
          <p:cNvSpPr>
            <a:spLocks/>
          </p:cNvSpPr>
          <p:nvPr/>
        </p:nvSpPr>
        <p:spPr bwMode="auto">
          <a:xfrm>
            <a:off x="5913438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Freeform 36">
            <a:extLst>
              <a:ext uri="{FF2B5EF4-FFF2-40B4-BE49-F238E27FC236}">
                <a16:creationId xmlns:a16="http://schemas.microsoft.com/office/drawing/2014/main" id="{F42305A8-EDF5-473D-BB7E-F3BEFA952ECD}"/>
              </a:ext>
            </a:extLst>
          </p:cNvPr>
          <p:cNvSpPr>
            <a:spLocks/>
          </p:cNvSpPr>
          <p:nvPr/>
        </p:nvSpPr>
        <p:spPr bwMode="auto">
          <a:xfrm>
            <a:off x="5203825" y="2220913"/>
            <a:ext cx="201613" cy="201613"/>
          </a:xfrm>
          <a:custGeom>
            <a:avLst/>
            <a:gdLst>
              <a:gd name="T0" fmla="*/ 0 w 127"/>
              <a:gd name="T1" fmla="*/ 63 h 127"/>
              <a:gd name="T2" fmla="*/ 0 w 127"/>
              <a:gd name="T3" fmla="*/ 63 h 127"/>
              <a:gd name="T4" fmla="*/ 0 w 127"/>
              <a:gd name="T5" fmla="*/ 50 h 127"/>
              <a:gd name="T6" fmla="*/ 5 w 127"/>
              <a:gd name="T7" fmla="*/ 39 h 127"/>
              <a:gd name="T8" fmla="*/ 11 w 127"/>
              <a:gd name="T9" fmla="*/ 28 h 127"/>
              <a:gd name="T10" fmla="*/ 19 w 127"/>
              <a:gd name="T11" fmla="*/ 19 h 127"/>
              <a:gd name="T12" fmla="*/ 28 w 127"/>
              <a:gd name="T13" fmla="*/ 11 h 127"/>
              <a:gd name="T14" fmla="*/ 39 w 127"/>
              <a:gd name="T15" fmla="*/ 5 h 127"/>
              <a:gd name="T16" fmla="*/ 50 w 127"/>
              <a:gd name="T17" fmla="*/ 0 h 127"/>
              <a:gd name="T18" fmla="*/ 63 w 127"/>
              <a:gd name="T19" fmla="*/ 0 h 127"/>
              <a:gd name="T20" fmla="*/ 63 w 127"/>
              <a:gd name="T21" fmla="*/ 0 h 127"/>
              <a:gd name="T22" fmla="*/ 77 w 127"/>
              <a:gd name="T23" fmla="*/ 0 h 127"/>
              <a:gd name="T24" fmla="*/ 88 w 127"/>
              <a:gd name="T25" fmla="*/ 5 h 127"/>
              <a:gd name="T26" fmla="*/ 99 w 127"/>
              <a:gd name="T27" fmla="*/ 11 h 127"/>
              <a:gd name="T28" fmla="*/ 108 w 127"/>
              <a:gd name="T29" fmla="*/ 19 h 127"/>
              <a:gd name="T30" fmla="*/ 116 w 127"/>
              <a:gd name="T31" fmla="*/ 28 h 127"/>
              <a:gd name="T32" fmla="*/ 122 w 127"/>
              <a:gd name="T33" fmla="*/ 39 h 127"/>
              <a:gd name="T34" fmla="*/ 125 w 127"/>
              <a:gd name="T35" fmla="*/ 50 h 127"/>
              <a:gd name="T36" fmla="*/ 127 w 127"/>
              <a:gd name="T37" fmla="*/ 63 h 127"/>
              <a:gd name="T38" fmla="*/ 127 w 127"/>
              <a:gd name="T39" fmla="*/ 63 h 127"/>
              <a:gd name="T40" fmla="*/ 125 w 127"/>
              <a:gd name="T41" fmla="*/ 77 h 127"/>
              <a:gd name="T42" fmla="*/ 122 w 127"/>
              <a:gd name="T43" fmla="*/ 88 h 127"/>
              <a:gd name="T44" fmla="*/ 116 w 127"/>
              <a:gd name="T45" fmla="*/ 99 h 127"/>
              <a:gd name="T46" fmla="*/ 108 w 127"/>
              <a:gd name="T47" fmla="*/ 108 h 127"/>
              <a:gd name="T48" fmla="*/ 99 w 127"/>
              <a:gd name="T49" fmla="*/ 116 h 127"/>
              <a:gd name="T50" fmla="*/ 88 w 127"/>
              <a:gd name="T51" fmla="*/ 122 h 127"/>
              <a:gd name="T52" fmla="*/ 77 w 127"/>
              <a:gd name="T53" fmla="*/ 126 h 127"/>
              <a:gd name="T54" fmla="*/ 63 w 127"/>
              <a:gd name="T55" fmla="*/ 127 h 127"/>
              <a:gd name="T56" fmla="*/ 63 w 127"/>
              <a:gd name="T57" fmla="*/ 127 h 127"/>
              <a:gd name="T58" fmla="*/ 50 w 127"/>
              <a:gd name="T59" fmla="*/ 126 h 127"/>
              <a:gd name="T60" fmla="*/ 39 w 127"/>
              <a:gd name="T61" fmla="*/ 122 h 127"/>
              <a:gd name="T62" fmla="*/ 28 w 127"/>
              <a:gd name="T63" fmla="*/ 116 h 127"/>
              <a:gd name="T64" fmla="*/ 19 w 127"/>
              <a:gd name="T65" fmla="*/ 108 h 127"/>
              <a:gd name="T66" fmla="*/ 11 w 127"/>
              <a:gd name="T67" fmla="*/ 99 h 127"/>
              <a:gd name="T68" fmla="*/ 5 w 127"/>
              <a:gd name="T69" fmla="*/ 88 h 127"/>
              <a:gd name="T70" fmla="*/ 0 w 127"/>
              <a:gd name="T71" fmla="*/ 77 h 127"/>
              <a:gd name="T72" fmla="*/ 0 w 127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7">
                <a:moveTo>
                  <a:pt x="0" y="63"/>
                </a:moveTo>
                <a:lnTo>
                  <a:pt x="0" y="63"/>
                </a:lnTo>
                <a:lnTo>
                  <a:pt x="0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3" y="0"/>
                </a:lnTo>
                <a:lnTo>
                  <a:pt x="63" y="0"/>
                </a:lnTo>
                <a:lnTo>
                  <a:pt x="77" y="0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0"/>
                </a:lnTo>
                <a:lnTo>
                  <a:pt x="127" y="63"/>
                </a:lnTo>
                <a:lnTo>
                  <a:pt x="127" y="63"/>
                </a:lnTo>
                <a:lnTo>
                  <a:pt x="125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9" y="116"/>
                </a:lnTo>
                <a:lnTo>
                  <a:pt x="88" y="122"/>
                </a:lnTo>
                <a:lnTo>
                  <a:pt x="77" y="126"/>
                </a:lnTo>
                <a:lnTo>
                  <a:pt x="63" y="127"/>
                </a:lnTo>
                <a:lnTo>
                  <a:pt x="63" y="127"/>
                </a:lnTo>
                <a:lnTo>
                  <a:pt x="50" y="126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0" y="77"/>
                </a:lnTo>
                <a:lnTo>
                  <a:pt x="0" y="63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Freeform 37">
            <a:extLst>
              <a:ext uri="{FF2B5EF4-FFF2-40B4-BE49-F238E27FC236}">
                <a16:creationId xmlns:a16="http://schemas.microsoft.com/office/drawing/2014/main" id="{CA12D3CA-CE49-4034-882A-9BACE830E7D5}"/>
              </a:ext>
            </a:extLst>
          </p:cNvPr>
          <p:cNvSpPr>
            <a:spLocks/>
          </p:cNvSpPr>
          <p:nvPr/>
        </p:nvSpPr>
        <p:spPr bwMode="auto">
          <a:xfrm>
            <a:off x="5203825" y="2220913"/>
            <a:ext cx="201613" cy="201613"/>
          </a:xfrm>
          <a:custGeom>
            <a:avLst/>
            <a:gdLst>
              <a:gd name="T0" fmla="*/ 0 w 127"/>
              <a:gd name="T1" fmla="*/ 63 h 127"/>
              <a:gd name="T2" fmla="*/ 0 w 127"/>
              <a:gd name="T3" fmla="*/ 63 h 127"/>
              <a:gd name="T4" fmla="*/ 0 w 127"/>
              <a:gd name="T5" fmla="*/ 50 h 127"/>
              <a:gd name="T6" fmla="*/ 5 w 127"/>
              <a:gd name="T7" fmla="*/ 39 h 127"/>
              <a:gd name="T8" fmla="*/ 11 w 127"/>
              <a:gd name="T9" fmla="*/ 28 h 127"/>
              <a:gd name="T10" fmla="*/ 19 w 127"/>
              <a:gd name="T11" fmla="*/ 19 h 127"/>
              <a:gd name="T12" fmla="*/ 28 w 127"/>
              <a:gd name="T13" fmla="*/ 11 h 127"/>
              <a:gd name="T14" fmla="*/ 39 w 127"/>
              <a:gd name="T15" fmla="*/ 5 h 127"/>
              <a:gd name="T16" fmla="*/ 50 w 127"/>
              <a:gd name="T17" fmla="*/ 0 h 127"/>
              <a:gd name="T18" fmla="*/ 63 w 127"/>
              <a:gd name="T19" fmla="*/ 0 h 127"/>
              <a:gd name="T20" fmla="*/ 63 w 127"/>
              <a:gd name="T21" fmla="*/ 0 h 127"/>
              <a:gd name="T22" fmla="*/ 77 w 127"/>
              <a:gd name="T23" fmla="*/ 0 h 127"/>
              <a:gd name="T24" fmla="*/ 88 w 127"/>
              <a:gd name="T25" fmla="*/ 5 h 127"/>
              <a:gd name="T26" fmla="*/ 99 w 127"/>
              <a:gd name="T27" fmla="*/ 11 h 127"/>
              <a:gd name="T28" fmla="*/ 108 w 127"/>
              <a:gd name="T29" fmla="*/ 19 h 127"/>
              <a:gd name="T30" fmla="*/ 116 w 127"/>
              <a:gd name="T31" fmla="*/ 28 h 127"/>
              <a:gd name="T32" fmla="*/ 122 w 127"/>
              <a:gd name="T33" fmla="*/ 39 h 127"/>
              <a:gd name="T34" fmla="*/ 125 w 127"/>
              <a:gd name="T35" fmla="*/ 50 h 127"/>
              <a:gd name="T36" fmla="*/ 127 w 127"/>
              <a:gd name="T37" fmla="*/ 63 h 127"/>
              <a:gd name="T38" fmla="*/ 127 w 127"/>
              <a:gd name="T39" fmla="*/ 63 h 127"/>
              <a:gd name="T40" fmla="*/ 125 w 127"/>
              <a:gd name="T41" fmla="*/ 77 h 127"/>
              <a:gd name="T42" fmla="*/ 122 w 127"/>
              <a:gd name="T43" fmla="*/ 88 h 127"/>
              <a:gd name="T44" fmla="*/ 116 w 127"/>
              <a:gd name="T45" fmla="*/ 99 h 127"/>
              <a:gd name="T46" fmla="*/ 108 w 127"/>
              <a:gd name="T47" fmla="*/ 108 h 127"/>
              <a:gd name="T48" fmla="*/ 99 w 127"/>
              <a:gd name="T49" fmla="*/ 116 h 127"/>
              <a:gd name="T50" fmla="*/ 88 w 127"/>
              <a:gd name="T51" fmla="*/ 122 h 127"/>
              <a:gd name="T52" fmla="*/ 77 w 127"/>
              <a:gd name="T53" fmla="*/ 126 h 127"/>
              <a:gd name="T54" fmla="*/ 63 w 127"/>
              <a:gd name="T55" fmla="*/ 127 h 127"/>
              <a:gd name="T56" fmla="*/ 63 w 127"/>
              <a:gd name="T57" fmla="*/ 127 h 127"/>
              <a:gd name="T58" fmla="*/ 50 w 127"/>
              <a:gd name="T59" fmla="*/ 126 h 127"/>
              <a:gd name="T60" fmla="*/ 39 w 127"/>
              <a:gd name="T61" fmla="*/ 122 h 127"/>
              <a:gd name="T62" fmla="*/ 28 w 127"/>
              <a:gd name="T63" fmla="*/ 116 h 127"/>
              <a:gd name="T64" fmla="*/ 19 w 127"/>
              <a:gd name="T65" fmla="*/ 108 h 127"/>
              <a:gd name="T66" fmla="*/ 11 w 127"/>
              <a:gd name="T67" fmla="*/ 99 h 127"/>
              <a:gd name="T68" fmla="*/ 5 w 127"/>
              <a:gd name="T69" fmla="*/ 88 h 127"/>
              <a:gd name="T70" fmla="*/ 0 w 127"/>
              <a:gd name="T71" fmla="*/ 77 h 127"/>
              <a:gd name="T72" fmla="*/ 0 w 127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7">
                <a:moveTo>
                  <a:pt x="0" y="63"/>
                </a:moveTo>
                <a:lnTo>
                  <a:pt x="0" y="63"/>
                </a:lnTo>
                <a:lnTo>
                  <a:pt x="0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3" y="0"/>
                </a:lnTo>
                <a:lnTo>
                  <a:pt x="63" y="0"/>
                </a:lnTo>
                <a:lnTo>
                  <a:pt x="77" y="0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0"/>
                </a:lnTo>
                <a:lnTo>
                  <a:pt x="127" y="63"/>
                </a:lnTo>
                <a:lnTo>
                  <a:pt x="127" y="63"/>
                </a:lnTo>
                <a:lnTo>
                  <a:pt x="125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9" y="116"/>
                </a:lnTo>
                <a:lnTo>
                  <a:pt x="88" y="122"/>
                </a:lnTo>
                <a:lnTo>
                  <a:pt x="77" y="126"/>
                </a:lnTo>
                <a:lnTo>
                  <a:pt x="63" y="127"/>
                </a:lnTo>
                <a:lnTo>
                  <a:pt x="63" y="127"/>
                </a:lnTo>
                <a:lnTo>
                  <a:pt x="50" y="126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0" y="77"/>
                </a:lnTo>
                <a:lnTo>
                  <a:pt x="0" y="63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Freeform 38">
            <a:extLst>
              <a:ext uri="{FF2B5EF4-FFF2-40B4-BE49-F238E27FC236}">
                <a16:creationId xmlns:a16="http://schemas.microsoft.com/office/drawing/2014/main" id="{E727F6CE-3A82-447E-A373-24DDDBAF477C}"/>
              </a:ext>
            </a:extLst>
          </p:cNvPr>
          <p:cNvSpPr>
            <a:spLocks/>
          </p:cNvSpPr>
          <p:nvPr/>
        </p:nvSpPr>
        <p:spPr bwMode="auto">
          <a:xfrm>
            <a:off x="5203825" y="2220913"/>
            <a:ext cx="201613" cy="201613"/>
          </a:xfrm>
          <a:custGeom>
            <a:avLst/>
            <a:gdLst>
              <a:gd name="T0" fmla="*/ 0 w 127"/>
              <a:gd name="T1" fmla="*/ 63 h 127"/>
              <a:gd name="T2" fmla="*/ 0 w 127"/>
              <a:gd name="T3" fmla="*/ 63 h 127"/>
              <a:gd name="T4" fmla="*/ 0 w 127"/>
              <a:gd name="T5" fmla="*/ 50 h 127"/>
              <a:gd name="T6" fmla="*/ 5 w 127"/>
              <a:gd name="T7" fmla="*/ 39 h 127"/>
              <a:gd name="T8" fmla="*/ 11 w 127"/>
              <a:gd name="T9" fmla="*/ 28 h 127"/>
              <a:gd name="T10" fmla="*/ 19 w 127"/>
              <a:gd name="T11" fmla="*/ 19 h 127"/>
              <a:gd name="T12" fmla="*/ 28 w 127"/>
              <a:gd name="T13" fmla="*/ 11 h 127"/>
              <a:gd name="T14" fmla="*/ 39 w 127"/>
              <a:gd name="T15" fmla="*/ 5 h 127"/>
              <a:gd name="T16" fmla="*/ 50 w 127"/>
              <a:gd name="T17" fmla="*/ 0 h 127"/>
              <a:gd name="T18" fmla="*/ 63 w 127"/>
              <a:gd name="T19" fmla="*/ 0 h 127"/>
              <a:gd name="T20" fmla="*/ 63 w 127"/>
              <a:gd name="T21" fmla="*/ 0 h 127"/>
              <a:gd name="T22" fmla="*/ 77 w 127"/>
              <a:gd name="T23" fmla="*/ 0 h 127"/>
              <a:gd name="T24" fmla="*/ 88 w 127"/>
              <a:gd name="T25" fmla="*/ 5 h 127"/>
              <a:gd name="T26" fmla="*/ 99 w 127"/>
              <a:gd name="T27" fmla="*/ 11 h 127"/>
              <a:gd name="T28" fmla="*/ 108 w 127"/>
              <a:gd name="T29" fmla="*/ 19 h 127"/>
              <a:gd name="T30" fmla="*/ 116 w 127"/>
              <a:gd name="T31" fmla="*/ 28 h 127"/>
              <a:gd name="T32" fmla="*/ 122 w 127"/>
              <a:gd name="T33" fmla="*/ 39 h 127"/>
              <a:gd name="T34" fmla="*/ 125 w 127"/>
              <a:gd name="T35" fmla="*/ 50 h 127"/>
              <a:gd name="T36" fmla="*/ 127 w 127"/>
              <a:gd name="T37" fmla="*/ 63 h 127"/>
              <a:gd name="T38" fmla="*/ 127 w 127"/>
              <a:gd name="T39" fmla="*/ 63 h 127"/>
              <a:gd name="T40" fmla="*/ 125 w 127"/>
              <a:gd name="T41" fmla="*/ 77 h 127"/>
              <a:gd name="T42" fmla="*/ 122 w 127"/>
              <a:gd name="T43" fmla="*/ 88 h 127"/>
              <a:gd name="T44" fmla="*/ 116 w 127"/>
              <a:gd name="T45" fmla="*/ 99 h 127"/>
              <a:gd name="T46" fmla="*/ 108 w 127"/>
              <a:gd name="T47" fmla="*/ 108 h 127"/>
              <a:gd name="T48" fmla="*/ 99 w 127"/>
              <a:gd name="T49" fmla="*/ 116 h 127"/>
              <a:gd name="T50" fmla="*/ 88 w 127"/>
              <a:gd name="T51" fmla="*/ 122 h 127"/>
              <a:gd name="T52" fmla="*/ 77 w 127"/>
              <a:gd name="T53" fmla="*/ 126 h 127"/>
              <a:gd name="T54" fmla="*/ 63 w 127"/>
              <a:gd name="T55" fmla="*/ 127 h 127"/>
              <a:gd name="T56" fmla="*/ 63 w 127"/>
              <a:gd name="T57" fmla="*/ 127 h 127"/>
              <a:gd name="T58" fmla="*/ 50 w 127"/>
              <a:gd name="T59" fmla="*/ 126 h 127"/>
              <a:gd name="T60" fmla="*/ 39 w 127"/>
              <a:gd name="T61" fmla="*/ 122 h 127"/>
              <a:gd name="T62" fmla="*/ 28 w 127"/>
              <a:gd name="T63" fmla="*/ 116 h 127"/>
              <a:gd name="T64" fmla="*/ 19 w 127"/>
              <a:gd name="T65" fmla="*/ 108 h 127"/>
              <a:gd name="T66" fmla="*/ 11 w 127"/>
              <a:gd name="T67" fmla="*/ 99 h 127"/>
              <a:gd name="T68" fmla="*/ 5 w 127"/>
              <a:gd name="T69" fmla="*/ 88 h 127"/>
              <a:gd name="T70" fmla="*/ 0 w 127"/>
              <a:gd name="T71" fmla="*/ 77 h 127"/>
              <a:gd name="T72" fmla="*/ 0 w 127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7">
                <a:moveTo>
                  <a:pt x="0" y="63"/>
                </a:moveTo>
                <a:lnTo>
                  <a:pt x="0" y="63"/>
                </a:lnTo>
                <a:lnTo>
                  <a:pt x="0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3" y="0"/>
                </a:lnTo>
                <a:lnTo>
                  <a:pt x="63" y="0"/>
                </a:lnTo>
                <a:lnTo>
                  <a:pt x="77" y="0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0"/>
                </a:lnTo>
                <a:lnTo>
                  <a:pt x="127" y="63"/>
                </a:lnTo>
                <a:lnTo>
                  <a:pt x="127" y="63"/>
                </a:lnTo>
                <a:lnTo>
                  <a:pt x="125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9" y="116"/>
                </a:lnTo>
                <a:lnTo>
                  <a:pt x="88" y="122"/>
                </a:lnTo>
                <a:lnTo>
                  <a:pt x="77" y="126"/>
                </a:lnTo>
                <a:lnTo>
                  <a:pt x="63" y="127"/>
                </a:lnTo>
                <a:lnTo>
                  <a:pt x="63" y="127"/>
                </a:lnTo>
                <a:lnTo>
                  <a:pt x="50" y="126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0" y="77"/>
                </a:lnTo>
                <a:lnTo>
                  <a:pt x="0" y="63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Freeform 39">
            <a:extLst>
              <a:ext uri="{FF2B5EF4-FFF2-40B4-BE49-F238E27FC236}">
                <a16:creationId xmlns:a16="http://schemas.microsoft.com/office/drawing/2014/main" id="{9956780B-E058-4D05-94D5-8478675B2367}"/>
              </a:ext>
            </a:extLst>
          </p:cNvPr>
          <p:cNvSpPr>
            <a:spLocks/>
          </p:cNvSpPr>
          <p:nvPr/>
        </p:nvSpPr>
        <p:spPr bwMode="auto">
          <a:xfrm>
            <a:off x="4781550" y="2870200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8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6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8 h 127"/>
              <a:gd name="T32" fmla="*/ 123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6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Freeform 40">
            <a:extLst>
              <a:ext uri="{FF2B5EF4-FFF2-40B4-BE49-F238E27FC236}">
                <a16:creationId xmlns:a16="http://schemas.microsoft.com/office/drawing/2014/main" id="{32E66DBD-B2E0-4376-A000-F95EFC319A91}"/>
              </a:ext>
            </a:extLst>
          </p:cNvPr>
          <p:cNvSpPr>
            <a:spLocks/>
          </p:cNvSpPr>
          <p:nvPr/>
        </p:nvSpPr>
        <p:spPr bwMode="auto">
          <a:xfrm>
            <a:off x="4781550" y="2870200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8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6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8 h 127"/>
              <a:gd name="T32" fmla="*/ 123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6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Freeform 41">
            <a:extLst>
              <a:ext uri="{FF2B5EF4-FFF2-40B4-BE49-F238E27FC236}">
                <a16:creationId xmlns:a16="http://schemas.microsoft.com/office/drawing/2014/main" id="{A2594AB7-1D95-484D-A299-478F648BD87C}"/>
              </a:ext>
            </a:extLst>
          </p:cNvPr>
          <p:cNvSpPr>
            <a:spLocks/>
          </p:cNvSpPr>
          <p:nvPr/>
        </p:nvSpPr>
        <p:spPr bwMode="auto">
          <a:xfrm>
            <a:off x="4781550" y="2870200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8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6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8 h 127"/>
              <a:gd name="T32" fmla="*/ 123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2 h 127"/>
              <a:gd name="T52" fmla="*/ 76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Freeform 42">
            <a:extLst>
              <a:ext uri="{FF2B5EF4-FFF2-40B4-BE49-F238E27FC236}">
                <a16:creationId xmlns:a16="http://schemas.microsoft.com/office/drawing/2014/main" id="{34F90949-A772-499C-A96B-B7DCC1602973}"/>
              </a:ext>
            </a:extLst>
          </p:cNvPr>
          <p:cNvSpPr>
            <a:spLocks/>
          </p:cNvSpPr>
          <p:nvPr/>
        </p:nvSpPr>
        <p:spPr bwMode="auto">
          <a:xfrm>
            <a:off x="4781550" y="3641725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4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8 w 128"/>
              <a:gd name="T13" fmla="*/ 11 h 128"/>
              <a:gd name="T14" fmla="*/ 39 w 128"/>
              <a:gd name="T15" fmla="*/ 5 h 128"/>
              <a:gd name="T16" fmla="*/ 51 w 128"/>
              <a:gd name="T17" fmla="*/ 2 h 128"/>
              <a:gd name="T18" fmla="*/ 64 w 128"/>
              <a:gd name="T19" fmla="*/ 0 h 128"/>
              <a:gd name="T20" fmla="*/ 64 w 128"/>
              <a:gd name="T21" fmla="*/ 0 h 128"/>
              <a:gd name="T22" fmla="*/ 76 w 128"/>
              <a:gd name="T23" fmla="*/ 2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6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8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4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6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8" y="117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Freeform 43">
            <a:extLst>
              <a:ext uri="{FF2B5EF4-FFF2-40B4-BE49-F238E27FC236}">
                <a16:creationId xmlns:a16="http://schemas.microsoft.com/office/drawing/2014/main" id="{0429B28D-E980-4072-B406-9B4E0B8AA79B}"/>
              </a:ext>
            </a:extLst>
          </p:cNvPr>
          <p:cNvSpPr>
            <a:spLocks/>
          </p:cNvSpPr>
          <p:nvPr/>
        </p:nvSpPr>
        <p:spPr bwMode="auto">
          <a:xfrm>
            <a:off x="4781550" y="3641725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4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8 w 128"/>
              <a:gd name="T13" fmla="*/ 11 h 128"/>
              <a:gd name="T14" fmla="*/ 39 w 128"/>
              <a:gd name="T15" fmla="*/ 5 h 128"/>
              <a:gd name="T16" fmla="*/ 51 w 128"/>
              <a:gd name="T17" fmla="*/ 2 h 128"/>
              <a:gd name="T18" fmla="*/ 64 w 128"/>
              <a:gd name="T19" fmla="*/ 0 h 128"/>
              <a:gd name="T20" fmla="*/ 64 w 128"/>
              <a:gd name="T21" fmla="*/ 0 h 128"/>
              <a:gd name="T22" fmla="*/ 76 w 128"/>
              <a:gd name="T23" fmla="*/ 2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6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8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4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6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8" y="117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Freeform 44">
            <a:extLst>
              <a:ext uri="{FF2B5EF4-FFF2-40B4-BE49-F238E27FC236}">
                <a16:creationId xmlns:a16="http://schemas.microsoft.com/office/drawing/2014/main" id="{9E7BBF14-2627-4F13-9DB8-52E74D074201}"/>
              </a:ext>
            </a:extLst>
          </p:cNvPr>
          <p:cNvSpPr>
            <a:spLocks/>
          </p:cNvSpPr>
          <p:nvPr/>
        </p:nvSpPr>
        <p:spPr bwMode="auto">
          <a:xfrm>
            <a:off x="4781550" y="3641725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4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8 w 128"/>
              <a:gd name="T13" fmla="*/ 11 h 128"/>
              <a:gd name="T14" fmla="*/ 39 w 128"/>
              <a:gd name="T15" fmla="*/ 5 h 128"/>
              <a:gd name="T16" fmla="*/ 51 w 128"/>
              <a:gd name="T17" fmla="*/ 2 h 128"/>
              <a:gd name="T18" fmla="*/ 64 w 128"/>
              <a:gd name="T19" fmla="*/ 0 h 128"/>
              <a:gd name="T20" fmla="*/ 64 w 128"/>
              <a:gd name="T21" fmla="*/ 0 h 128"/>
              <a:gd name="T22" fmla="*/ 76 w 128"/>
              <a:gd name="T23" fmla="*/ 2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6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8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4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6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8" y="117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Freeform 45">
            <a:extLst>
              <a:ext uri="{FF2B5EF4-FFF2-40B4-BE49-F238E27FC236}">
                <a16:creationId xmlns:a16="http://schemas.microsoft.com/office/drawing/2014/main" id="{7A5413E6-976F-49CF-B111-CDB1862055FD}"/>
              </a:ext>
            </a:extLst>
          </p:cNvPr>
          <p:cNvSpPr>
            <a:spLocks/>
          </p:cNvSpPr>
          <p:nvPr/>
        </p:nvSpPr>
        <p:spPr bwMode="auto">
          <a:xfrm>
            <a:off x="5203825" y="4291013"/>
            <a:ext cx="201613" cy="203200"/>
          </a:xfrm>
          <a:custGeom>
            <a:avLst/>
            <a:gdLst>
              <a:gd name="T0" fmla="*/ 0 w 127"/>
              <a:gd name="T1" fmla="*/ 64 h 128"/>
              <a:gd name="T2" fmla="*/ 0 w 127"/>
              <a:gd name="T3" fmla="*/ 64 h 128"/>
              <a:gd name="T4" fmla="*/ 0 w 127"/>
              <a:gd name="T5" fmla="*/ 52 h 128"/>
              <a:gd name="T6" fmla="*/ 5 w 127"/>
              <a:gd name="T7" fmla="*/ 39 h 128"/>
              <a:gd name="T8" fmla="*/ 11 w 127"/>
              <a:gd name="T9" fmla="*/ 28 h 128"/>
              <a:gd name="T10" fmla="*/ 19 w 127"/>
              <a:gd name="T11" fmla="*/ 19 h 128"/>
              <a:gd name="T12" fmla="*/ 28 w 127"/>
              <a:gd name="T13" fmla="*/ 11 h 128"/>
              <a:gd name="T14" fmla="*/ 39 w 127"/>
              <a:gd name="T15" fmla="*/ 5 h 128"/>
              <a:gd name="T16" fmla="*/ 50 w 127"/>
              <a:gd name="T17" fmla="*/ 2 h 128"/>
              <a:gd name="T18" fmla="*/ 63 w 127"/>
              <a:gd name="T19" fmla="*/ 0 h 128"/>
              <a:gd name="T20" fmla="*/ 63 w 127"/>
              <a:gd name="T21" fmla="*/ 0 h 128"/>
              <a:gd name="T22" fmla="*/ 77 w 127"/>
              <a:gd name="T23" fmla="*/ 2 h 128"/>
              <a:gd name="T24" fmla="*/ 88 w 127"/>
              <a:gd name="T25" fmla="*/ 5 h 128"/>
              <a:gd name="T26" fmla="*/ 99 w 127"/>
              <a:gd name="T27" fmla="*/ 11 h 128"/>
              <a:gd name="T28" fmla="*/ 108 w 127"/>
              <a:gd name="T29" fmla="*/ 19 h 128"/>
              <a:gd name="T30" fmla="*/ 116 w 127"/>
              <a:gd name="T31" fmla="*/ 28 h 128"/>
              <a:gd name="T32" fmla="*/ 122 w 127"/>
              <a:gd name="T33" fmla="*/ 39 h 128"/>
              <a:gd name="T34" fmla="*/ 125 w 127"/>
              <a:gd name="T35" fmla="*/ 52 h 128"/>
              <a:gd name="T36" fmla="*/ 127 w 127"/>
              <a:gd name="T37" fmla="*/ 64 h 128"/>
              <a:gd name="T38" fmla="*/ 127 w 127"/>
              <a:gd name="T39" fmla="*/ 64 h 128"/>
              <a:gd name="T40" fmla="*/ 125 w 127"/>
              <a:gd name="T41" fmla="*/ 77 h 128"/>
              <a:gd name="T42" fmla="*/ 122 w 127"/>
              <a:gd name="T43" fmla="*/ 89 h 128"/>
              <a:gd name="T44" fmla="*/ 116 w 127"/>
              <a:gd name="T45" fmla="*/ 100 h 128"/>
              <a:gd name="T46" fmla="*/ 108 w 127"/>
              <a:gd name="T47" fmla="*/ 110 h 128"/>
              <a:gd name="T48" fmla="*/ 99 w 127"/>
              <a:gd name="T49" fmla="*/ 117 h 128"/>
              <a:gd name="T50" fmla="*/ 88 w 127"/>
              <a:gd name="T51" fmla="*/ 124 h 128"/>
              <a:gd name="T52" fmla="*/ 77 w 127"/>
              <a:gd name="T53" fmla="*/ 127 h 128"/>
              <a:gd name="T54" fmla="*/ 63 w 127"/>
              <a:gd name="T55" fmla="*/ 128 h 128"/>
              <a:gd name="T56" fmla="*/ 63 w 127"/>
              <a:gd name="T57" fmla="*/ 128 h 128"/>
              <a:gd name="T58" fmla="*/ 50 w 127"/>
              <a:gd name="T59" fmla="*/ 127 h 128"/>
              <a:gd name="T60" fmla="*/ 39 w 127"/>
              <a:gd name="T61" fmla="*/ 124 h 128"/>
              <a:gd name="T62" fmla="*/ 28 w 127"/>
              <a:gd name="T63" fmla="*/ 117 h 128"/>
              <a:gd name="T64" fmla="*/ 19 w 127"/>
              <a:gd name="T65" fmla="*/ 110 h 128"/>
              <a:gd name="T66" fmla="*/ 11 w 127"/>
              <a:gd name="T67" fmla="*/ 100 h 128"/>
              <a:gd name="T68" fmla="*/ 5 w 127"/>
              <a:gd name="T69" fmla="*/ 89 h 128"/>
              <a:gd name="T70" fmla="*/ 0 w 127"/>
              <a:gd name="T71" fmla="*/ 77 h 128"/>
              <a:gd name="T72" fmla="*/ 0 w 127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8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3" y="0"/>
                </a:lnTo>
                <a:lnTo>
                  <a:pt x="63" y="0"/>
                </a:lnTo>
                <a:lnTo>
                  <a:pt x="77" y="2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2"/>
                </a:lnTo>
                <a:lnTo>
                  <a:pt x="127" y="64"/>
                </a:lnTo>
                <a:lnTo>
                  <a:pt x="127" y="64"/>
                </a:lnTo>
                <a:lnTo>
                  <a:pt x="125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9" y="117"/>
                </a:lnTo>
                <a:lnTo>
                  <a:pt x="88" y="124"/>
                </a:lnTo>
                <a:lnTo>
                  <a:pt x="77" y="127"/>
                </a:lnTo>
                <a:lnTo>
                  <a:pt x="63" y="128"/>
                </a:lnTo>
                <a:lnTo>
                  <a:pt x="63" y="128"/>
                </a:lnTo>
                <a:lnTo>
                  <a:pt x="50" y="127"/>
                </a:lnTo>
                <a:lnTo>
                  <a:pt x="39" y="124"/>
                </a:lnTo>
                <a:lnTo>
                  <a:pt x="28" y="117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0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Freeform 46">
            <a:extLst>
              <a:ext uri="{FF2B5EF4-FFF2-40B4-BE49-F238E27FC236}">
                <a16:creationId xmlns:a16="http://schemas.microsoft.com/office/drawing/2014/main" id="{849103E5-CF59-4F00-A955-C5F313D9A952}"/>
              </a:ext>
            </a:extLst>
          </p:cNvPr>
          <p:cNvSpPr>
            <a:spLocks/>
          </p:cNvSpPr>
          <p:nvPr/>
        </p:nvSpPr>
        <p:spPr bwMode="auto">
          <a:xfrm>
            <a:off x="5203825" y="4291013"/>
            <a:ext cx="201613" cy="203200"/>
          </a:xfrm>
          <a:custGeom>
            <a:avLst/>
            <a:gdLst>
              <a:gd name="T0" fmla="*/ 0 w 127"/>
              <a:gd name="T1" fmla="*/ 64 h 128"/>
              <a:gd name="T2" fmla="*/ 0 w 127"/>
              <a:gd name="T3" fmla="*/ 64 h 128"/>
              <a:gd name="T4" fmla="*/ 0 w 127"/>
              <a:gd name="T5" fmla="*/ 52 h 128"/>
              <a:gd name="T6" fmla="*/ 5 w 127"/>
              <a:gd name="T7" fmla="*/ 39 h 128"/>
              <a:gd name="T8" fmla="*/ 11 w 127"/>
              <a:gd name="T9" fmla="*/ 28 h 128"/>
              <a:gd name="T10" fmla="*/ 19 w 127"/>
              <a:gd name="T11" fmla="*/ 19 h 128"/>
              <a:gd name="T12" fmla="*/ 28 w 127"/>
              <a:gd name="T13" fmla="*/ 11 h 128"/>
              <a:gd name="T14" fmla="*/ 39 w 127"/>
              <a:gd name="T15" fmla="*/ 5 h 128"/>
              <a:gd name="T16" fmla="*/ 50 w 127"/>
              <a:gd name="T17" fmla="*/ 2 h 128"/>
              <a:gd name="T18" fmla="*/ 63 w 127"/>
              <a:gd name="T19" fmla="*/ 0 h 128"/>
              <a:gd name="T20" fmla="*/ 63 w 127"/>
              <a:gd name="T21" fmla="*/ 0 h 128"/>
              <a:gd name="T22" fmla="*/ 77 w 127"/>
              <a:gd name="T23" fmla="*/ 2 h 128"/>
              <a:gd name="T24" fmla="*/ 88 w 127"/>
              <a:gd name="T25" fmla="*/ 5 h 128"/>
              <a:gd name="T26" fmla="*/ 99 w 127"/>
              <a:gd name="T27" fmla="*/ 11 h 128"/>
              <a:gd name="T28" fmla="*/ 108 w 127"/>
              <a:gd name="T29" fmla="*/ 19 h 128"/>
              <a:gd name="T30" fmla="*/ 116 w 127"/>
              <a:gd name="T31" fmla="*/ 28 h 128"/>
              <a:gd name="T32" fmla="*/ 122 w 127"/>
              <a:gd name="T33" fmla="*/ 39 h 128"/>
              <a:gd name="T34" fmla="*/ 125 w 127"/>
              <a:gd name="T35" fmla="*/ 52 h 128"/>
              <a:gd name="T36" fmla="*/ 127 w 127"/>
              <a:gd name="T37" fmla="*/ 64 h 128"/>
              <a:gd name="T38" fmla="*/ 127 w 127"/>
              <a:gd name="T39" fmla="*/ 64 h 128"/>
              <a:gd name="T40" fmla="*/ 125 w 127"/>
              <a:gd name="T41" fmla="*/ 77 h 128"/>
              <a:gd name="T42" fmla="*/ 122 w 127"/>
              <a:gd name="T43" fmla="*/ 89 h 128"/>
              <a:gd name="T44" fmla="*/ 116 w 127"/>
              <a:gd name="T45" fmla="*/ 100 h 128"/>
              <a:gd name="T46" fmla="*/ 108 w 127"/>
              <a:gd name="T47" fmla="*/ 110 h 128"/>
              <a:gd name="T48" fmla="*/ 99 w 127"/>
              <a:gd name="T49" fmla="*/ 117 h 128"/>
              <a:gd name="T50" fmla="*/ 88 w 127"/>
              <a:gd name="T51" fmla="*/ 124 h 128"/>
              <a:gd name="T52" fmla="*/ 77 w 127"/>
              <a:gd name="T53" fmla="*/ 127 h 128"/>
              <a:gd name="T54" fmla="*/ 63 w 127"/>
              <a:gd name="T55" fmla="*/ 128 h 128"/>
              <a:gd name="T56" fmla="*/ 63 w 127"/>
              <a:gd name="T57" fmla="*/ 128 h 128"/>
              <a:gd name="T58" fmla="*/ 50 w 127"/>
              <a:gd name="T59" fmla="*/ 127 h 128"/>
              <a:gd name="T60" fmla="*/ 39 w 127"/>
              <a:gd name="T61" fmla="*/ 124 h 128"/>
              <a:gd name="T62" fmla="*/ 28 w 127"/>
              <a:gd name="T63" fmla="*/ 117 h 128"/>
              <a:gd name="T64" fmla="*/ 19 w 127"/>
              <a:gd name="T65" fmla="*/ 110 h 128"/>
              <a:gd name="T66" fmla="*/ 11 w 127"/>
              <a:gd name="T67" fmla="*/ 100 h 128"/>
              <a:gd name="T68" fmla="*/ 5 w 127"/>
              <a:gd name="T69" fmla="*/ 89 h 128"/>
              <a:gd name="T70" fmla="*/ 0 w 127"/>
              <a:gd name="T71" fmla="*/ 77 h 128"/>
              <a:gd name="T72" fmla="*/ 0 w 127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8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3" y="0"/>
                </a:lnTo>
                <a:lnTo>
                  <a:pt x="63" y="0"/>
                </a:lnTo>
                <a:lnTo>
                  <a:pt x="77" y="2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2"/>
                </a:lnTo>
                <a:lnTo>
                  <a:pt x="127" y="64"/>
                </a:lnTo>
                <a:lnTo>
                  <a:pt x="127" y="64"/>
                </a:lnTo>
                <a:lnTo>
                  <a:pt x="125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9" y="117"/>
                </a:lnTo>
                <a:lnTo>
                  <a:pt x="88" y="124"/>
                </a:lnTo>
                <a:lnTo>
                  <a:pt x="77" y="127"/>
                </a:lnTo>
                <a:lnTo>
                  <a:pt x="63" y="128"/>
                </a:lnTo>
                <a:lnTo>
                  <a:pt x="63" y="128"/>
                </a:lnTo>
                <a:lnTo>
                  <a:pt x="50" y="127"/>
                </a:lnTo>
                <a:lnTo>
                  <a:pt x="39" y="124"/>
                </a:lnTo>
                <a:lnTo>
                  <a:pt x="28" y="117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Freeform 47">
            <a:extLst>
              <a:ext uri="{FF2B5EF4-FFF2-40B4-BE49-F238E27FC236}">
                <a16:creationId xmlns:a16="http://schemas.microsoft.com/office/drawing/2014/main" id="{9660FE1C-AEF6-4A05-956C-964AD7D4DC36}"/>
              </a:ext>
            </a:extLst>
          </p:cNvPr>
          <p:cNvSpPr>
            <a:spLocks/>
          </p:cNvSpPr>
          <p:nvPr/>
        </p:nvSpPr>
        <p:spPr bwMode="auto">
          <a:xfrm>
            <a:off x="5203825" y="4291013"/>
            <a:ext cx="201613" cy="203200"/>
          </a:xfrm>
          <a:custGeom>
            <a:avLst/>
            <a:gdLst>
              <a:gd name="T0" fmla="*/ 0 w 127"/>
              <a:gd name="T1" fmla="*/ 64 h 128"/>
              <a:gd name="T2" fmla="*/ 0 w 127"/>
              <a:gd name="T3" fmla="*/ 64 h 128"/>
              <a:gd name="T4" fmla="*/ 0 w 127"/>
              <a:gd name="T5" fmla="*/ 52 h 128"/>
              <a:gd name="T6" fmla="*/ 5 w 127"/>
              <a:gd name="T7" fmla="*/ 39 h 128"/>
              <a:gd name="T8" fmla="*/ 11 w 127"/>
              <a:gd name="T9" fmla="*/ 28 h 128"/>
              <a:gd name="T10" fmla="*/ 19 w 127"/>
              <a:gd name="T11" fmla="*/ 19 h 128"/>
              <a:gd name="T12" fmla="*/ 28 w 127"/>
              <a:gd name="T13" fmla="*/ 11 h 128"/>
              <a:gd name="T14" fmla="*/ 39 w 127"/>
              <a:gd name="T15" fmla="*/ 5 h 128"/>
              <a:gd name="T16" fmla="*/ 50 w 127"/>
              <a:gd name="T17" fmla="*/ 2 h 128"/>
              <a:gd name="T18" fmla="*/ 63 w 127"/>
              <a:gd name="T19" fmla="*/ 0 h 128"/>
              <a:gd name="T20" fmla="*/ 63 w 127"/>
              <a:gd name="T21" fmla="*/ 0 h 128"/>
              <a:gd name="T22" fmla="*/ 77 w 127"/>
              <a:gd name="T23" fmla="*/ 2 h 128"/>
              <a:gd name="T24" fmla="*/ 88 w 127"/>
              <a:gd name="T25" fmla="*/ 5 h 128"/>
              <a:gd name="T26" fmla="*/ 99 w 127"/>
              <a:gd name="T27" fmla="*/ 11 h 128"/>
              <a:gd name="T28" fmla="*/ 108 w 127"/>
              <a:gd name="T29" fmla="*/ 19 h 128"/>
              <a:gd name="T30" fmla="*/ 116 w 127"/>
              <a:gd name="T31" fmla="*/ 28 h 128"/>
              <a:gd name="T32" fmla="*/ 122 w 127"/>
              <a:gd name="T33" fmla="*/ 39 h 128"/>
              <a:gd name="T34" fmla="*/ 125 w 127"/>
              <a:gd name="T35" fmla="*/ 52 h 128"/>
              <a:gd name="T36" fmla="*/ 127 w 127"/>
              <a:gd name="T37" fmla="*/ 64 h 128"/>
              <a:gd name="T38" fmla="*/ 127 w 127"/>
              <a:gd name="T39" fmla="*/ 64 h 128"/>
              <a:gd name="T40" fmla="*/ 125 w 127"/>
              <a:gd name="T41" fmla="*/ 77 h 128"/>
              <a:gd name="T42" fmla="*/ 122 w 127"/>
              <a:gd name="T43" fmla="*/ 89 h 128"/>
              <a:gd name="T44" fmla="*/ 116 w 127"/>
              <a:gd name="T45" fmla="*/ 100 h 128"/>
              <a:gd name="T46" fmla="*/ 108 w 127"/>
              <a:gd name="T47" fmla="*/ 110 h 128"/>
              <a:gd name="T48" fmla="*/ 99 w 127"/>
              <a:gd name="T49" fmla="*/ 117 h 128"/>
              <a:gd name="T50" fmla="*/ 88 w 127"/>
              <a:gd name="T51" fmla="*/ 124 h 128"/>
              <a:gd name="T52" fmla="*/ 77 w 127"/>
              <a:gd name="T53" fmla="*/ 127 h 128"/>
              <a:gd name="T54" fmla="*/ 63 w 127"/>
              <a:gd name="T55" fmla="*/ 128 h 128"/>
              <a:gd name="T56" fmla="*/ 63 w 127"/>
              <a:gd name="T57" fmla="*/ 128 h 128"/>
              <a:gd name="T58" fmla="*/ 50 w 127"/>
              <a:gd name="T59" fmla="*/ 127 h 128"/>
              <a:gd name="T60" fmla="*/ 39 w 127"/>
              <a:gd name="T61" fmla="*/ 124 h 128"/>
              <a:gd name="T62" fmla="*/ 28 w 127"/>
              <a:gd name="T63" fmla="*/ 117 h 128"/>
              <a:gd name="T64" fmla="*/ 19 w 127"/>
              <a:gd name="T65" fmla="*/ 110 h 128"/>
              <a:gd name="T66" fmla="*/ 11 w 127"/>
              <a:gd name="T67" fmla="*/ 100 h 128"/>
              <a:gd name="T68" fmla="*/ 5 w 127"/>
              <a:gd name="T69" fmla="*/ 89 h 128"/>
              <a:gd name="T70" fmla="*/ 0 w 127"/>
              <a:gd name="T71" fmla="*/ 77 h 128"/>
              <a:gd name="T72" fmla="*/ 0 w 127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8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3" y="0"/>
                </a:lnTo>
                <a:lnTo>
                  <a:pt x="63" y="0"/>
                </a:lnTo>
                <a:lnTo>
                  <a:pt x="77" y="2"/>
                </a:lnTo>
                <a:lnTo>
                  <a:pt x="88" y="5"/>
                </a:lnTo>
                <a:lnTo>
                  <a:pt x="99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5" y="52"/>
                </a:lnTo>
                <a:lnTo>
                  <a:pt x="127" y="64"/>
                </a:lnTo>
                <a:lnTo>
                  <a:pt x="127" y="64"/>
                </a:lnTo>
                <a:lnTo>
                  <a:pt x="125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9" y="117"/>
                </a:lnTo>
                <a:lnTo>
                  <a:pt x="88" y="124"/>
                </a:lnTo>
                <a:lnTo>
                  <a:pt x="77" y="127"/>
                </a:lnTo>
                <a:lnTo>
                  <a:pt x="63" y="128"/>
                </a:lnTo>
                <a:lnTo>
                  <a:pt x="63" y="128"/>
                </a:lnTo>
                <a:lnTo>
                  <a:pt x="50" y="127"/>
                </a:lnTo>
                <a:lnTo>
                  <a:pt x="39" y="124"/>
                </a:lnTo>
                <a:lnTo>
                  <a:pt x="28" y="117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Freeform 48">
            <a:extLst>
              <a:ext uri="{FF2B5EF4-FFF2-40B4-BE49-F238E27FC236}">
                <a16:creationId xmlns:a16="http://schemas.microsoft.com/office/drawing/2014/main" id="{5498BC42-1DBD-4558-8DE2-8876234DAD04}"/>
              </a:ext>
            </a:extLst>
          </p:cNvPr>
          <p:cNvSpPr>
            <a:spLocks/>
          </p:cNvSpPr>
          <p:nvPr/>
        </p:nvSpPr>
        <p:spPr bwMode="auto">
          <a:xfrm>
            <a:off x="5913438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Freeform 49">
            <a:extLst>
              <a:ext uri="{FF2B5EF4-FFF2-40B4-BE49-F238E27FC236}">
                <a16:creationId xmlns:a16="http://schemas.microsoft.com/office/drawing/2014/main" id="{F6340158-831D-4A96-9C60-DB029FC3DB3C}"/>
              </a:ext>
            </a:extLst>
          </p:cNvPr>
          <p:cNvSpPr>
            <a:spLocks/>
          </p:cNvSpPr>
          <p:nvPr/>
        </p:nvSpPr>
        <p:spPr bwMode="auto">
          <a:xfrm>
            <a:off x="5913438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Freeform 50">
            <a:extLst>
              <a:ext uri="{FF2B5EF4-FFF2-40B4-BE49-F238E27FC236}">
                <a16:creationId xmlns:a16="http://schemas.microsoft.com/office/drawing/2014/main" id="{CF543D8B-1CB9-4BF6-A751-8DA8245D0E4E}"/>
              </a:ext>
            </a:extLst>
          </p:cNvPr>
          <p:cNvSpPr>
            <a:spLocks/>
          </p:cNvSpPr>
          <p:nvPr/>
        </p:nvSpPr>
        <p:spPr bwMode="auto">
          <a:xfrm>
            <a:off x="5913438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Freeform 51">
            <a:extLst>
              <a:ext uri="{FF2B5EF4-FFF2-40B4-BE49-F238E27FC236}">
                <a16:creationId xmlns:a16="http://schemas.microsoft.com/office/drawing/2014/main" id="{2B94D50A-AFD1-47A6-831F-39E8A232E52A}"/>
              </a:ext>
            </a:extLst>
          </p:cNvPr>
          <p:cNvSpPr>
            <a:spLocks/>
          </p:cNvSpPr>
          <p:nvPr/>
        </p:nvSpPr>
        <p:spPr bwMode="auto">
          <a:xfrm>
            <a:off x="6684963" y="4502150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Freeform 52">
            <a:extLst>
              <a:ext uri="{FF2B5EF4-FFF2-40B4-BE49-F238E27FC236}">
                <a16:creationId xmlns:a16="http://schemas.microsoft.com/office/drawing/2014/main" id="{C03749D7-5CE1-446C-B7A2-D242723A4ADC}"/>
              </a:ext>
            </a:extLst>
          </p:cNvPr>
          <p:cNvSpPr>
            <a:spLocks/>
          </p:cNvSpPr>
          <p:nvPr/>
        </p:nvSpPr>
        <p:spPr bwMode="auto">
          <a:xfrm>
            <a:off x="6684963" y="4502150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Freeform 53">
            <a:extLst>
              <a:ext uri="{FF2B5EF4-FFF2-40B4-BE49-F238E27FC236}">
                <a16:creationId xmlns:a16="http://schemas.microsoft.com/office/drawing/2014/main" id="{0031FBB3-7F14-4CC0-B24F-23F3FD32FA9D}"/>
              </a:ext>
            </a:extLst>
          </p:cNvPr>
          <p:cNvSpPr>
            <a:spLocks/>
          </p:cNvSpPr>
          <p:nvPr/>
        </p:nvSpPr>
        <p:spPr bwMode="auto">
          <a:xfrm>
            <a:off x="6684963" y="4502150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4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4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Freeform 54">
            <a:extLst>
              <a:ext uri="{FF2B5EF4-FFF2-40B4-BE49-F238E27FC236}">
                <a16:creationId xmlns:a16="http://schemas.microsoft.com/office/drawing/2014/main" id="{6DA148A1-08A7-4FAF-B404-9473AB28D1D9}"/>
              </a:ext>
            </a:extLst>
          </p:cNvPr>
          <p:cNvSpPr>
            <a:spLocks/>
          </p:cNvSpPr>
          <p:nvPr/>
        </p:nvSpPr>
        <p:spPr bwMode="auto">
          <a:xfrm>
            <a:off x="7273925" y="3997325"/>
            <a:ext cx="204788" cy="201613"/>
          </a:xfrm>
          <a:custGeom>
            <a:avLst/>
            <a:gdLst>
              <a:gd name="T0" fmla="*/ 0 w 129"/>
              <a:gd name="T1" fmla="*/ 63 h 127"/>
              <a:gd name="T2" fmla="*/ 0 w 129"/>
              <a:gd name="T3" fmla="*/ 63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8 w 129"/>
              <a:gd name="T13" fmla="*/ 11 h 127"/>
              <a:gd name="T14" fmla="*/ 39 w 129"/>
              <a:gd name="T15" fmla="*/ 5 h 127"/>
              <a:gd name="T16" fmla="*/ 52 w 129"/>
              <a:gd name="T17" fmla="*/ 0 h 127"/>
              <a:gd name="T18" fmla="*/ 64 w 129"/>
              <a:gd name="T19" fmla="*/ 0 h 127"/>
              <a:gd name="T20" fmla="*/ 64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3 h 127"/>
              <a:gd name="T38" fmla="*/ 129 w 129"/>
              <a:gd name="T39" fmla="*/ 63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4 w 129"/>
              <a:gd name="T55" fmla="*/ 127 h 127"/>
              <a:gd name="T56" fmla="*/ 64 w 129"/>
              <a:gd name="T57" fmla="*/ 127 h 127"/>
              <a:gd name="T58" fmla="*/ 52 w 129"/>
              <a:gd name="T59" fmla="*/ 127 h 127"/>
              <a:gd name="T60" fmla="*/ 39 w 129"/>
              <a:gd name="T61" fmla="*/ 122 h 127"/>
              <a:gd name="T62" fmla="*/ 28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3"/>
                </a:moveTo>
                <a:lnTo>
                  <a:pt x="0" y="63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3"/>
                </a:lnTo>
                <a:lnTo>
                  <a:pt x="129" y="63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3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Freeform 55">
            <a:extLst>
              <a:ext uri="{FF2B5EF4-FFF2-40B4-BE49-F238E27FC236}">
                <a16:creationId xmlns:a16="http://schemas.microsoft.com/office/drawing/2014/main" id="{CA15F6FC-FCA3-4F98-B61C-A51216613148}"/>
              </a:ext>
            </a:extLst>
          </p:cNvPr>
          <p:cNvSpPr>
            <a:spLocks/>
          </p:cNvSpPr>
          <p:nvPr/>
        </p:nvSpPr>
        <p:spPr bwMode="auto">
          <a:xfrm>
            <a:off x="7273925" y="3997325"/>
            <a:ext cx="204788" cy="201613"/>
          </a:xfrm>
          <a:custGeom>
            <a:avLst/>
            <a:gdLst>
              <a:gd name="T0" fmla="*/ 0 w 129"/>
              <a:gd name="T1" fmla="*/ 63 h 127"/>
              <a:gd name="T2" fmla="*/ 0 w 129"/>
              <a:gd name="T3" fmla="*/ 63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8 w 129"/>
              <a:gd name="T13" fmla="*/ 11 h 127"/>
              <a:gd name="T14" fmla="*/ 39 w 129"/>
              <a:gd name="T15" fmla="*/ 5 h 127"/>
              <a:gd name="T16" fmla="*/ 52 w 129"/>
              <a:gd name="T17" fmla="*/ 0 h 127"/>
              <a:gd name="T18" fmla="*/ 64 w 129"/>
              <a:gd name="T19" fmla="*/ 0 h 127"/>
              <a:gd name="T20" fmla="*/ 64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3 h 127"/>
              <a:gd name="T38" fmla="*/ 129 w 129"/>
              <a:gd name="T39" fmla="*/ 63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4 w 129"/>
              <a:gd name="T55" fmla="*/ 127 h 127"/>
              <a:gd name="T56" fmla="*/ 64 w 129"/>
              <a:gd name="T57" fmla="*/ 127 h 127"/>
              <a:gd name="T58" fmla="*/ 52 w 129"/>
              <a:gd name="T59" fmla="*/ 127 h 127"/>
              <a:gd name="T60" fmla="*/ 39 w 129"/>
              <a:gd name="T61" fmla="*/ 122 h 127"/>
              <a:gd name="T62" fmla="*/ 28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3"/>
                </a:moveTo>
                <a:lnTo>
                  <a:pt x="0" y="63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3"/>
                </a:lnTo>
                <a:lnTo>
                  <a:pt x="129" y="63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3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Freeform 56">
            <a:extLst>
              <a:ext uri="{FF2B5EF4-FFF2-40B4-BE49-F238E27FC236}">
                <a16:creationId xmlns:a16="http://schemas.microsoft.com/office/drawing/2014/main" id="{AE556843-9EFC-4462-AB80-79DDF81A359A}"/>
              </a:ext>
            </a:extLst>
          </p:cNvPr>
          <p:cNvSpPr>
            <a:spLocks/>
          </p:cNvSpPr>
          <p:nvPr/>
        </p:nvSpPr>
        <p:spPr bwMode="auto">
          <a:xfrm>
            <a:off x="7273925" y="3997325"/>
            <a:ext cx="204788" cy="201613"/>
          </a:xfrm>
          <a:custGeom>
            <a:avLst/>
            <a:gdLst>
              <a:gd name="T0" fmla="*/ 0 w 129"/>
              <a:gd name="T1" fmla="*/ 63 h 127"/>
              <a:gd name="T2" fmla="*/ 0 w 129"/>
              <a:gd name="T3" fmla="*/ 63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8 w 129"/>
              <a:gd name="T13" fmla="*/ 11 h 127"/>
              <a:gd name="T14" fmla="*/ 39 w 129"/>
              <a:gd name="T15" fmla="*/ 5 h 127"/>
              <a:gd name="T16" fmla="*/ 52 w 129"/>
              <a:gd name="T17" fmla="*/ 0 h 127"/>
              <a:gd name="T18" fmla="*/ 64 w 129"/>
              <a:gd name="T19" fmla="*/ 0 h 127"/>
              <a:gd name="T20" fmla="*/ 64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3 h 127"/>
              <a:gd name="T38" fmla="*/ 129 w 129"/>
              <a:gd name="T39" fmla="*/ 63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4 w 129"/>
              <a:gd name="T55" fmla="*/ 127 h 127"/>
              <a:gd name="T56" fmla="*/ 64 w 129"/>
              <a:gd name="T57" fmla="*/ 127 h 127"/>
              <a:gd name="T58" fmla="*/ 52 w 129"/>
              <a:gd name="T59" fmla="*/ 127 h 127"/>
              <a:gd name="T60" fmla="*/ 39 w 129"/>
              <a:gd name="T61" fmla="*/ 122 h 127"/>
              <a:gd name="T62" fmla="*/ 28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3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3"/>
                </a:moveTo>
                <a:lnTo>
                  <a:pt x="0" y="63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3"/>
                </a:lnTo>
                <a:lnTo>
                  <a:pt x="129" y="63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2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3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7">
            <a:extLst>
              <a:ext uri="{FF2B5EF4-FFF2-40B4-BE49-F238E27FC236}">
                <a16:creationId xmlns:a16="http://schemas.microsoft.com/office/drawing/2014/main" id="{3BB9CB01-C7A9-4431-96CA-946631158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0175" y="3271837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61" name="Rectangle 58">
            <a:extLst>
              <a:ext uri="{FF2B5EF4-FFF2-40B4-BE49-F238E27FC236}">
                <a16:creationId xmlns:a16="http://schemas.microsoft.com/office/drawing/2014/main" id="{06213F4E-6563-4E20-8DB5-5F46960953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85075" y="2549237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2" name="Rectangle 59">
            <a:extLst>
              <a:ext uri="{FF2B5EF4-FFF2-40B4-BE49-F238E27FC236}">
                <a16:creationId xmlns:a16="http://schemas.microsoft.com/office/drawing/2014/main" id="{8A1B4330-B0F9-4299-AA57-468DB4A649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4201" y="1915566"/>
            <a:ext cx="9778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→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3" name="Rectangle 60">
            <a:extLst>
              <a:ext uri="{FF2B5EF4-FFF2-40B4-BE49-F238E27FC236}">
                <a16:creationId xmlns:a16="http://schemas.microsoft.com/office/drawing/2014/main" id="{E1AD1B15-AA78-44E5-9EF7-B2111B6571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7287" y="1685410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4" name="Rectangle 61">
            <a:extLst>
              <a:ext uri="{FF2B5EF4-FFF2-40B4-BE49-F238E27FC236}">
                <a16:creationId xmlns:a16="http://schemas.microsoft.com/office/drawing/2014/main" id="{F91E57F2-638A-4BDC-8019-E7F5EA4E2A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5416" y="2127251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65" name="Rectangle 62">
            <a:extLst>
              <a:ext uri="{FF2B5EF4-FFF2-40B4-BE49-F238E27FC236}">
                <a16:creationId xmlns:a16="http://schemas.microsoft.com/office/drawing/2014/main" id="{EAA32F43-994C-4644-BE47-BFD71353F0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9170" y="2834224"/>
            <a:ext cx="104195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zmb+T-DM1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6" name="Rectangle 63">
            <a:extLst>
              <a:ext uri="{FF2B5EF4-FFF2-40B4-BE49-F238E27FC236}">
                <a16:creationId xmlns:a16="http://schemas.microsoft.com/office/drawing/2014/main" id="{592AAF17-DC0E-4271-B733-482706AC03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8282" y="3650992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67" name="Rectangle 64">
            <a:extLst>
              <a:ext uri="{FF2B5EF4-FFF2-40B4-BE49-F238E27FC236}">
                <a16:creationId xmlns:a16="http://schemas.microsoft.com/office/drawing/2014/main" id="{3F7B95CD-6C9D-40CA-8311-9BB0E456A1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8180" y="4401880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8" name="Rectangle 65">
            <a:extLst>
              <a:ext uri="{FF2B5EF4-FFF2-40B4-BE49-F238E27FC236}">
                <a16:creationId xmlns:a16="http://schemas.microsoft.com/office/drawing/2014/main" id="{FB37D0EA-F9F4-4BF1-8BE4-B6531241A7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1800" y="4819908"/>
            <a:ext cx="9730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Ner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69" name="Rectangle 66">
            <a:extLst>
              <a:ext uri="{FF2B5EF4-FFF2-40B4-BE49-F238E27FC236}">
                <a16:creationId xmlns:a16="http://schemas.microsoft.com/office/drawing/2014/main" id="{AB473EC1-67B9-426F-B66D-F68D97A197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08775" y="4727575"/>
            <a:ext cx="9698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70" name="Rectangle 67">
            <a:extLst>
              <a:ext uri="{FF2B5EF4-FFF2-40B4-BE49-F238E27FC236}">
                <a16:creationId xmlns:a16="http://schemas.microsoft.com/office/drawing/2014/main" id="{FB68EE42-27A9-4652-95FF-FAA3381E6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47108" y="4170376"/>
            <a:ext cx="72295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B5C285D7-DA76-4F07-AE7F-E7C4EB2307F4}"/>
              </a:ext>
            </a:extLst>
          </p:cNvPr>
          <p:cNvSpPr txBox="1"/>
          <p:nvPr/>
        </p:nvSpPr>
        <p:spPr>
          <a:xfrm>
            <a:off x="2979390" y="12003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27947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752599B0-5F8E-4851-8829-2E17E601EA5A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7102475" y="2360613"/>
            <a:ext cx="447675" cy="9048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5E5E998C-F5C3-407D-954D-79B2E4343DDB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4983163" y="2776538"/>
            <a:ext cx="2513013" cy="5588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12CEA95C-6377-4640-941C-4DCB27BED1B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62525" y="2065338"/>
            <a:ext cx="808038" cy="6254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80A03D1A-8F38-4549-9906-121EBCBFFB67}"/>
              </a:ext>
            </a:extLst>
          </p:cNvPr>
          <p:cNvSpPr>
            <a:spLocks noChangeShapeType="1"/>
          </p:cNvSpPr>
          <p:nvPr/>
        </p:nvSpPr>
        <p:spPr bwMode="auto">
          <a:xfrm>
            <a:off x="5851525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186C7B9C-8E24-486E-8832-7D4C7071F775}"/>
              </a:ext>
            </a:extLst>
          </p:cNvPr>
          <p:cNvSpPr>
            <a:spLocks noChangeShapeType="1"/>
          </p:cNvSpPr>
          <p:nvPr/>
        </p:nvSpPr>
        <p:spPr bwMode="auto">
          <a:xfrm>
            <a:off x="5895975" y="2092325"/>
            <a:ext cx="1117600" cy="22606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DC0CCAC7-CBC0-4C11-B8C2-45A8FD37EEC7}"/>
              </a:ext>
            </a:extLst>
          </p:cNvPr>
          <p:cNvSpPr>
            <a:spLocks noChangeShapeType="1"/>
          </p:cNvSpPr>
          <p:nvPr/>
        </p:nvSpPr>
        <p:spPr bwMode="auto">
          <a:xfrm>
            <a:off x="4883150" y="2855913"/>
            <a:ext cx="0" cy="10017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43BD9614-FA2D-46F1-9708-FCF4CA3112CA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7600" y="2846388"/>
            <a:ext cx="877888" cy="177482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1A17435C-4D0E-4457-BF9C-DA173D509322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2525" y="2816225"/>
            <a:ext cx="2016125" cy="15668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3CA11BD1-C313-474D-8C69-D979A28305A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49950" y="4467225"/>
            <a:ext cx="1008063" cy="223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15">
            <a:extLst>
              <a:ext uri="{FF2B5EF4-FFF2-40B4-BE49-F238E27FC236}">
                <a16:creationId xmlns:a16="http://schemas.microsoft.com/office/drawing/2014/main" id="{86754646-17B6-4DC5-93EE-F58CECCFA6B2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1FC45EFD-CAFE-4DA9-A6F6-5D85FE09F4BC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F9E77D72-E647-4744-A999-31697D6AF3F8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0ABAC201-8E24-4833-897B-547B7B914377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AFEF6084-1559-4DB9-88A7-3180BE6874A1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F1583609-1704-4F77-9B68-632B5505E834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21">
            <a:extLst>
              <a:ext uri="{FF2B5EF4-FFF2-40B4-BE49-F238E27FC236}">
                <a16:creationId xmlns:a16="http://schemas.microsoft.com/office/drawing/2014/main" id="{B440307C-A541-4205-90C9-29FD2B1C0F1F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B41354DB-9506-4B22-AE27-AB31C307AE7A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3">
            <a:extLst>
              <a:ext uri="{FF2B5EF4-FFF2-40B4-BE49-F238E27FC236}">
                <a16:creationId xmlns:a16="http://schemas.microsoft.com/office/drawing/2014/main" id="{55EFB432-DC7F-477A-BBE2-19CED9BBA6C3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23C2B93B-D276-469C-8A29-00AB45AC3080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9D656BE8-D174-4DD8-96B4-E06E1DF1810A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2D7288F5-B355-48AF-9A62-8A9BA7777197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97895DBA-959B-43A6-9961-6407E50D9034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ECEBAF1C-FB30-4F1E-9113-297C7C057881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9AE8A776-5109-46B5-9B12-802A3D178C0D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1A68864F-DC1E-4173-90E8-C2852162FE6C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E6906B72-E3C6-401D-90B8-583D2A12C176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A4FE3BCA-7F73-498D-9331-7DCCFD0B89AA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3">
            <a:extLst>
              <a:ext uri="{FF2B5EF4-FFF2-40B4-BE49-F238E27FC236}">
                <a16:creationId xmlns:a16="http://schemas.microsoft.com/office/drawing/2014/main" id="{B04F0493-1ACB-4275-AD76-BF7BEA1EB289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4">
            <a:extLst>
              <a:ext uri="{FF2B5EF4-FFF2-40B4-BE49-F238E27FC236}">
                <a16:creationId xmlns:a16="http://schemas.microsoft.com/office/drawing/2014/main" id="{E5EA96F8-D338-493E-9F16-F6BF13EF41D3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5">
            <a:extLst>
              <a:ext uri="{FF2B5EF4-FFF2-40B4-BE49-F238E27FC236}">
                <a16:creationId xmlns:a16="http://schemas.microsoft.com/office/drawing/2014/main" id="{D1C33882-AF3E-43FF-A747-4D8832749C38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C318534C-D6ED-492E-B2F4-E0001533AB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3789" y="3276085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F0BADBF6-67D2-4A0C-B630-B5DE6527B6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9625" y="1999107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8A82825B-3077-41AB-813C-36C0B4432D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4240" y="1688433"/>
            <a:ext cx="5738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2" name="Rectangle 39">
            <a:extLst>
              <a:ext uri="{FF2B5EF4-FFF2-40B4-BE49-F238E27FC236}">
                <a16:creationId xmlns:a16="http://schemas.microsoft.com/office/drawing/2014/main" id="{25FB02D1-E366-44EF-9676-EDCD1DA4B8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5291" y="2558792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DC7AAC4F-0301-4599-9DD4-5C929B4370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86971" y="4064814"/>
            <a:ext cx="9730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Ner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6132816A-E2EC-4460-A7B9-5635C3EECC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4532" y="4816476"/>
            <a:ext cx="96981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4E0AC0E6-06A8-466A-B033-96A392CC4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55009" y="4544755"/>
            <a:ext cx="72295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P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8D02A7E-86A5-4F04-8FCB-2DBBFDF1A231}"/>
              </a:ext>
            </a:extLst>
          </p:cNvPr>
          <p:cNvSpPr txBox="1"/>
          <p:nvPr/>
        </p:nvSpPr>
        <p:spPr>
          <a:xfrm>
            <a:off x="2970382" y="13191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6412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B202C517-D2D6-4BFA-BD3E-738B365156ED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7102475" y="2360613"/>
            <a:ext cx="447675" cy="9048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83A07ED7-EFC6-4727-900F-A3364710A718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5949950" y="2022475"/>
            <a:ext cx="1008063" cy="22542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551A8D41-26D2-4DF2-8ADD-8FF12A19986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3163" y="2290763"/>
            <a:ext cx="1974850" cy="4397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A66958CE-C0A8-4271-9758-4FE76372E8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62525" y="2333625"/>
            <a:ext cx="2016125" cy="1563688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B9FB3050-51DA-4B5D-BC2F-BEE176901D7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895975" y="2360613"/>
            <a:ext cx="1117600" cy="22606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CBF82191-821E-4D0D-A25D-3EAEB16BB07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62525" y="2065338"/>
            <a:ext cx="808038" cy="625475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54F2E625-C660-4C36-AC58-81DBA03628F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27600" y="2092325"/>
            <a:ext cx="877888" cy="177800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D7952585-9CC1-4807-AE7B-33AF27962F37}"/>
              </a:ext>
            </a:extLst>
          </p:cNvPr>
          <p:cNvSpPr>
            <a:spLocks noChangeShapeType="1"/>
          </p:cNvSpPr>
          <p:nvPr/>
        </p:nvSpPr>
        <p:spPr bwMode="auto">
          <a:xfrm>
            <a:off x="4883150" y="2855913"/>
            <a:ext cx="0" cy="10017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7A9F2303-A740-428D-A6AE-BC2952C1A2C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2525" y="4022725"/>
            <a:ext cx="808038" cy="62865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5">
            <a:extLst>
              <a:ext uri="{FF2B5EF4-FFF2-40B4-BE49-F238E27FC236}">
                <a16:creationId xmlns:a16="http://schemas.microsoft.com/office/drawing/2014/main" id="{8E7B3A7F-7B2A-4015-BA1C-8626C9C7C6CA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3163" y="3983038"/>
            <a:ext cx="1974850" cy="4397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AA588029-37EE-4C67-9190-11737E9FECE8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446A41E7-EDA2-4F2B-9AAC-A7B34C20391E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B18AF4BE-7547-4E2F-9668-5A9D9FE5B890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CD91348E-0C0F-43A7-950B-66B4DE88D8AF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0E17CF27-6E22-49E5-BBC3-5499C193DD20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21">
            <a:extLst>
              <a:ext uri="{FF2B5EF4-FFF2-40B4-BE49-F238E27FC236}">
                <a16:creationId xmlns:a16="http://schemas.microsoft.com/office/drawing/2014/main" id="{E5DBB166-F4B0-476E-B0CD-44ABC3059E7D}"/>
              </a:ext>
            </a:extLst>
          </p:cNvPr>
          <p:cNvSpPr>
            <a:spLocks/>
          </p:cNvSpPr>
          <p:nvPr/>
        </p:nvSpPr>
        <p:spPr bwMode="auto">
          <a:xfrm>
            <a:off x="6956425" y="2168525"/>
            <a:ext cx="203200" cy="201613"/>
          </a:xfrm>
          <a:custGeom>
            <a:avLst/>
            <a:gdLst>
              <a:gd name="T0" fmla="*/ 0 w 128"/>
              <a:gd name="T1" fmla="*/ 65 h 127"/>
              <a:gd name="T2" fmla="*/ 0 w 128"/>
              <a:gd name="T3" fmla="*/ 65 h 127"/>
              <a:gd name="T4" fmla="*/ 1 w 128"/>
              <a:gd name="T5" fmla="*/ 50 h 127"/>
              <a:gd name="T6" fmla="*/ 6 w 128"/>
              <a:gd name="T7" fmla="*/ 40 h 127"/>
              <a:gd name="T8" fmla="*/ 11 w 128"/>
              <a:gd name="T9" fmla="*/ 29 h 127"/>
              <a:gd name="T10" fmla="*/ 18 w 128"/>
              <a:gd name="T11" fmla="*/ 19 h 127"/>
              <a:gd name="T12" fmla="*/ 29 w 128"/>
              <a:gd name="T13" fmla="*/ 11 h 127"/>
              <a:gd name="T14" fmla="*/ 39 w 128"/>
              <a:gd name="T15" fmla="*/ 5 h 127"/>
              <a:gd name="T16" fmla="*/ 51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8 w 128"/>
              <a:gd name="T23" fmla="*/ 0 h 127"/>
              <a:gd name="T24" fmla="*/ 89 w 128"/>
              <a:gd name="T25" fmla="*/ 5 h 127"/>
              <a:gd name="T26" fmla="*/ 100 w 128"/>
              <a:gd name="T27" fmla="*/ 11 h 127"/>
              <a:gd name="T28" fmla="*/ 109 w 128"/>
              <a:gd name="T29" fmla="*/ 19 h 127"/>
              <a:gd name="T30" fmla="*/ 117 w 128"/>
              <a:gd name="T31" fmla="*/ 29 h 127"/>
              <a:gd name="T32" fmla="*/ 123 w 128"/>
              <a:gd name="T33" fmla="*/ 40 h 127"/>
              <a:gd name="T34" fmla="*/ 127 w 128"/>
              <a:gd name="T35" fmla="*/ 50 h 127"/>
              <a:gd name="T36" fmla="*/ 128 w 128"/>
              <a:gd name="T37" fmla="*/ 65 h 127"/>
              <a:gd name="T38" fmla="*/ 128 w 128"/>
              <a:gd name="T39" fmla="*/ 65 h 127"/>
              <a:gd name="T40" fmla="*/ 127 w 128"/>
              <a:gd name="T41" fmla="*/ 77 h 127"/>
              <a:gd name="T42" fmla="*/ 123 w 128"/>
              <a:gd name="T43" fmla="*/ 88 h 127"/>
              <a:gd name="T44" fmla="*/ 117 w 128"/>
              <a:gd name="T45" fmla="*/ 99 h 127"/>
              <a:gd name="T46" fmla="*/ 109 w 128"/>
              <a:gd name="T47" fmla="*/ 108 h 127"/>
              <a:gd name="T48" fmla="*/ 100 w 128"/>
              <a:gd name="T49" fmla="*/ 116 h 127"/>
              <a:gd name="T50" fmla="*/ 89 w 128"/>
              <a:gd name="T51" fmla="*/ 123 h 127"/>
              <a:gd name="T52" fmla="*/ 78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1 w 128"/>
              <a:gd name="T59" fmla="*/ 127 h 127"/>
              <a:gd name="T60" fmla="*/ 39 w 128"/>
              <a:gd name="T61" fmla="*/ 123 h 127"/>
              <a:gd name="T62" fmla="*/ 29 w 128"/>
              <a:gd name="T63" fmla="*/ 116 h 127"/>
              <a:gd name="T64" fmla="*/ 18 w 128"/>
              <a:gd name="T65" fmla="*/ 108 h 127"/>
              <a:gd name="T66" fmla="*/ 11 w 128"/>
              <a:gd name="T67" fmla="*/ 99 h 127"/>
              <a:gd name="T68" fmla="*/ 6 w 128"/>
              <a:gd name="T69" fmla="*/ 88 h 127"/>
              <a:gd name="T70" fmla="*/ 1 w 128"/>
              <a:gd name="T71" fmla="*/ 77 h 127"/>
              <a:gd name="T72" fmla="*/ 0 w 128"/>
              <a:gd name="T73" fmla="*/ 65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5"/>
                </a:moveTo>
                <a:lnTo>
                  <a:pt x="0" y="65"/>
                </a:lnTo>
                <a:lnTo>
                  <a:pt x="1" y="50"/>
                </a:lnTo>
                <a:lnTo>
                  <a:pt x="6" y="40"/>
                </a:lnTo>
                <a:lnTo>
                  <a:pt x="11" y="29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0"/>
                </a:lnTo>
                <a:lnTo>
                  <a:pt x="64" y="0"/>
                </a:lnTo>
                <a:lnTo>
                  <a:pt x="64" y="0"/>
                </a:lnTo>
                <a:lnTo>
                  <a:pt x="78" y="0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0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88"/>
                </a:lnTo>
                <a:lnTo>
                  <a:pt x="117" y="99"/>
                </a:lnTo>
                <a:lnTo>
                  <a:pt x="109" y="108"/>
                </a:lnTo>
                <a:lnTo>
                  <a:pt x="100" y="116"/>
                </a:lnTo>
                <a:lnTo>
                  <a:pt x="89" y="123"/>
                </a:lnTo>
                <a:lnTo>
                  <a:pt x="78" y="127"/>
                </a:lnTo>
                <a:lnTo>
                  <a:pt x="64" y="127"/>
                </a:lnTo>
                <a:lnTo>
                  <a:pt x="64" y="127"/>
                </a:lnTo>
                <a:lnTo>
                  <a:pt x="51" y="127"/>
                </a:lnTo>
                <a:lnTo>
                  <a:pt x="39" y="123"/>
                </a:lnTo>
                <a:lnTo>
                  <a:pt x="29" y="116"/>
                </a:lnTo>
                <a:lnTo>
                  <a:pt x="18" y="108"/>
                </a:lnTo>
                <a:lnTo>
                  <a:pt x="11" y="99"/>
                </a:lnTo>
                <a:lnTo>
                  <a:pt x="6" y="88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D6244213-7FF7-4847-B63E-BCE684099746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3">
            <a:extLst>
              <a:ext uri="{FF2B5EF4-FFF2-40B4-BE49-F238E27FC236}">
                <a16:creationId xmlns:a16="http://schemas.microsoft.com/office/drawing/2014/main" id="{7C7BBA41-65EB-4578-B682-475303131882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9C0B4FF5-21B9-4162-8996-AD2DF1AFCACA}"/>
              </a:ext>
            </a:extLst>
          </p:cNvPr>
          <p:cNvSpPr>
            <a:spLocks/>
          </p:cNvSpPr>
          <p:nvPr/>
        </p:nvSpPr>
        <p:spPr bwMode="auto">
          <a:xfrm>
            <a:off x="5748338" y="1900238"/>
            <a:ext cx="204788" cy="201613"/>
          </a:xfrm>
          <a:custGeom>
            <a:avLst/>
            <a:gdLst>
              <a:gd name="T0" fmla="*/ 0 w 129"/>
              <a:gd name="T1" fmla="*/ 64 h 127"/>
              <a:gd name="T2" fmla="*/ 0 w 129"/>
              <a:gd name="T3" fmla="*/ 64 h 127"/>
              <a:gd name="T4" fmla="*/ 2 w 129"/>
              <a:gd name="T5" fmla="*/ 50 h 127"/>
              <a:gd name="T6" fmla="*/ 5 w 129"/>
              <a:gd name="T7" fmla="*/ 39 h 127"/>
              <a:gd name="T8" fmla="*/ 11 w 129"/>
              <a:gd name="T9" fmla="*/ 28 h 127"/>
              <a:gd name="T10" fmla="*/ 19 w 129"/>
              <a:gd name="T11" fmla="*/ 19 h 127"/>
              <a:gd name="T12" fmla="*/ 29 w 129"/>
              <a:gd name="T13" fmla="*/ 11 h 127"/>
              <a:gd name="T14" fmla="*/ 40 w 129"/>
              <a:gd name="T15" fmla="*/ 5 h 127"/>
              <a:gd name="T16" fmla="*/ 52 w 129"/>
              <a:gd name="T17" fmla="*/ 0 h 127"/>
              <a:gd name="T18" fmla="*/ 65 w 129"/>
              <a:gd name="T19" fmla="*/ 0 h 127"/>
              <a:gd name="T20" fmla="*/ 65 w 129"/>
              <a:gd name="T21" fmla="*/ 0 h 127"/>
              <a:gd name="T22" fmla="*/ 77 w 129"/>
              <a:gd name="T23" fmla="*/ 0 h 127"/>
              <a:gd name="T24" fmla="*/ 90 w 129"/>
              <a:gd name="T25" fmla="*/ 5 h 127"/>
              <a:gd name="T26" fmla="*/ 101 w 129"/>
              <a:gd name="T27" fmla="*/ 11 h 127"/>
              <a:gd name="T28" fmla="*/ 110 w 129"/>
              <a:gd name="T29" fmla="*/ 19 h 127"/>
              <a:gd name="T30" fmla="*/ 118 w 129"/>
              <a:gd name="T31" fmla="*/ 28 h 127"/>
              <a:gd name="T32" fmla="*/ 124 w 129"/>
              <a:gd name="T33" fmla="*/ 39 h 127"/>
              <a:gd name="T34" fmla="*/ 127 w 129"/>
              <a:gd name="T35" fmla="*/ 50 h 127"/>
              <a:gd name="T36" fmla="*/ 129 w 129"/>
              <a:gd name="T37" fmla="*/ 64 h 127"/>
              <a:gd name="T38" fmla="*/ 129 w 129"/>
              <a:gd name="T39" fmla="*/ 64 h 127"/>
              <a:gd name="T40" fmla="*/ 127 w 129"/>
              <a:gd name="T41" fmla="*/ 77 h 127"/>
              <a:gd name="T42" fmla="*/ 124 w 129"/>
              <a:gd name="T43" fmla="*/ 88 h 127"/>
              <a:gd name="T44" fmla="*/ 118 w 129"/>
              <a:gd name="T45" fmla="*/ 99 h 127"/>
              <a:gd name="T46" fmla="*/ 110 w 129"/>
              <a:gd name="T47" fmla="*/ 108 h 127"/>
              <a:gd name="T48" fmla="*/ 101 w 129"/>
              <a:gd name="T49" fmla="*/ 116 h 127"/>
              <a:gd name="T50" fmla="*/ 90 w 129"/>
              <a:gd name="T51" fmla="*/ 122 h 127"/>
              <a:gd name="T52" fmla="*/ 77 w 129"/>
              <a:gd name="T53" fmla="*/ 127 h 127"/>
              <a:gd name="T54" fmla="*/ 65 w 129"/>
              <a:gd name="T55" fmla="*/ 127 h 127"/>
              <a:gd name="T56" fmla="*/ 65 w 129"/>
              <a:gd name="T57" fmla="*/ 127 h 127"/>
              <a:gd name="T58" fmla="*/ 52 w 129"/>
              <a:gd name="T59" fmla="*/ 127 h 127"/>
              <a:gd name="T60" fmla="*/ 40 w 129"/>
              <a:gd name="T61" fmla="*/ 122 h 127"/>
              <a:gd name="T62" fmla="*/ 29 w 129"/>
              <a:gd name="T63" fmla="*/ 116 h 127"/>
              <a:gd name="T64" fmla="*/ 19 w 129"/>
              <a:gd name="T65" fmla="*/ 108 h 127"/>
              <a:gd name="T66" fmla="*/ 11 w 129"/>
              <a:gd name="T67" fmla="*/ 99 h 127"/>
              <a:gd name="T68" fmla="*/ 5 w 129"/>
              <a:gd name="T69" fmla="*/ 88 h 127"/>
              <a:gd name="T70" fmla="*/ 2 w 129"/>
              <a:gd name="T71" fmla="*/ 77 h 127"/>
              <a:gd name="T72" fmla="*/ 0 w 129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7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0"/>
                </a:lnTo>
                <a:lnTo>
                  <a:pt x="65" y="0"/>
                </a:lnTo>
                <a:lnTo>
                  <a:pt x="65" y="0"/>
                </a:lnTo>
                <a:lnTo>
                  <a:pt x="77" y="0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8"/>
                </a:lnTo>
                <a:lnTo>
                  <a:pt x="118" y="99"/>
                </a:lnTo>
                <a:lnTo>
                  <a:pt x="110" y="108"/>
                </a:lnTo>
                <a:lnTo>
                  <a:pt x="101" y="116"/>
                </a:lnTo>
                <a:lnTo>
                  <a:pt x="90" y="122"/>
                </a:lnTo>
                <a:lnTo>
                  <a:pt x="77" y="127"/>
                </a:lnTo>
                <a:lnTo>
                  <a:pt x="65" y="127"/>
                </a:lnTo>
                <a:lnTo>
                  <a:pt x="65" y="127"/>
                </a:lnTo>
                <a:lnTo>
                  <a:pt x="52" y="127"/>
                </a:lnTo>
                <a:lnTo>
                  <a:pt x="40" y="122"/>
                </a:lnTo>
                <a:lnTo>
                  <a:pt x="29" y="116"/>
                </a:lnTo>
                <a:lnTo>
                  <a:pt x="19" y="108"/>
                </a:lnTo>
                <a:lnTo>
                  <a:pt x="11" y="99"/>
                </a:lnTo>
                <a:lnTo>
                  <a:pt x="5" y="88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47EE56CF-E500-4DEF-8EB2-B527E4D009EE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8AD5B427-CE0F-4B15-9A37-41BDB6FB1895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07029BDF-8ACB-4039-993F-BBA93C85E2D2}"/>
              </a:ext>
            </a:extLst>
          </p:cNvPr>
          <p:cNvSpPr>
            <a:spLocks/>
          </p:cNvSpPr>
          <p:nvPr/>
        </p:nvSpPr>
        <p:spPr bwMode="auto">
          <a:xfrm>
            <a:off x="4781550" y="26511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29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9 h 129"/>
              <a:gd name="T32" fmla="*/ 123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29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9"/>
                </a:lnTo>
                <a:lnTo>
                  <a:pt x="123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1B9AC99A-6AB4-4F0A-97A7-A09133A7B147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33B56DFD-E818-456D-8D99-48210D52D1F4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E460DB5C-BB34-414D-94F3-3FA673AFE399}"/>
              </a:ext>
            </a:extLst>
          </p:cNvPr>
          <p:cNvSpPr>
            <a:spLocks/>
          </p:cNvSpPr>
          <p:nvPr/>
        </p:nvSpPr>
        <p:spPr bwMode="auto">
          <a:xfrm>
            <a:off x="4781550" y="385762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3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3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3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3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C236AADF-61E0-4EC6-AA38-AA8621ADD5C0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F6C1E475-3756-4C86-9C76-7F15F3567898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Freeform 33">
            <a:extLst>
              <a:ext uri="{FF2B5EF4-FFF2-40B4-BE49-F238E27FC236}">
                <a16:creationId xmlns:a16="http://schemas.microsoft.com/office/drawing/2014/main" id="{93D6C4EF-E324-4C29-9C8F-EA8A3590D340}"/>
              </a:ext>
            </a:extLst>
          </p:cNvPr>
          <p:cNvSpPr>
            <a:spLocks/>
          </p:cNvSpPr>
          <p:nvPr/>
        </p:nvSpPr>
        <p:spPr bwMode="auto">
          <a:xfrm>
            <a:off x="5748338" y="4611688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2 h 129"/>
              <a:gd name="T6" fmla="*/ 5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9 w 129"/>
              <a:gd name="T13" fmla="*/ 11 h 129"/>
              <a:gd name="T14" fmla="*/ 40 w 129"/>
              <a:gd name="T15" fmla="*/ 5 h 129"/>
              <a:gd name="T16" fmla="*/ 52 w 129"/>
              <a:gd name="T17" fmla="*/ 2 h 129"/>
              <a:gd name="T18" fmla="*/ 65 w 129"/>
              <a:gd name="T19" fmla="*/ 0 h 129"/>
              <a:gd name="T20" fmla="*/ 65 w 129"/>
              <a:gd name="T21" fmla="*/ 0 h 129"/>
              <a:gd name="T22" fmla="*/ 77 w 129"/>
              <a:gd name="T23" fmla="*/ 2 h 129"/>
              <a:gd name="T24" fmla="*/ 90 w 129"/>
              <a:gd name="T25" fmla="*/ 5 h 129"/>
              <a:gd name="T26" fmla="*/ 101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2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1 w 129"/>
              <a:gd name="T49" fmla="*/ 118 h 129"/>
              <a:gd name="T50" fmla="*/ 90 w 129"/>
              <a:gd name="T51" fmla="*/ 124 h 129"/>
              <a:gd name="T52" fmla="*/ 77 w 129"/>
              <a:gd name="T53" fmla="*/ 127 h 129"/>
              <a:gd name="T54" fmla="*/ 65 w 129"/>
              <a:gd name="T55" fmla="*/ 129 h 129"/>
              <a:gd name="T56" fmla="*/ 65 w 129"/>
              <a:gd name="T57" fmla="*/ 129 h 129"/>
              <a:gd name="T58" fmla="*/ 52 w 129"/>
              <a:gd name="T59" fmla="*/ 127 h 129"/>
              <a:gd name="T60" fmla="*/ 40 w 129"/>
              <a:gd name="T61" fmla="*/ 124 h 129"/>
              <a:gd name="T62" fmla="*/ 29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5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2"/>
                </a:lnTo>
                <a:lnTo>
                  <a:pt x="5" y="39"/>
                </a:lnTo>
                <a:lnTo>
                  <a:pt x="11" y="28"/>
                </a:lnTo>
                <a:lnTo>
                  <a:pt x="19" y="19"/>
                </a:lnTo>
                <a:lnTo>
                  <a:pt x="29" y="11"/>
                </a:lnTo>
                <a:lnTo>
                  <a:pt x="40" y="5"/>
                </a:lnTo>
                <a:lnTo>
                  <a:pt x="52" y="2"/>
                </a:lnTo>
                <a:lnTo>
                  <a:pt x="65" y="0"/>
                </a:lnTo>
                <a:lnTo>
                  <a:pt x="65" y="0"/>
                </a:lnTo>
                <a:lnTo>
                  <a:pt x="77" y="2"/>
                </a:lnTo>
                <a:lnTo>
                  <a:pt x="90" y="5"/>
                </a:lnTo>
                <a:lnTo>
                  <a:pt x="101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2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1" y="118"/>
                </a:lnTo>
                <a:lnTo>
                  <a:pt x="90" y="124"/>
                </a:lnTo>
                <a:lnTo>
                  <a:pt x="77" y="127"/>
                </a:lnTo>
                <a:lnTo>
                  <a:pt x="65" y="129"/>
                </a:lnTo>
                <a:lnTo>
                  <a:pt x="65" y="129"/>
                </a:lnTo>
                <a:lnTo>
                  <a:pt x="52" y="127"/>
                </a:lnTo>
                <a:lnTo>
                  <a:pt x="40" y="124"/>
                </a:lnTo>
                <a:lnTo>
                  <a:pt x="29" y="118"/>
                </a:lnTo>
                <a:lnTo>
                  <a:pt x="19" y="110"/>
                </a:lnTo>
                <a:lnTo>
                  <a:pt x="11" y="100"/>
                </a:lnTo>
                <a:lnTo>
                  <a:pt x="5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Freeform 34">
            <a:extLst>
              <a:ext uri="{FF2B5EF4-FFF2-40B4-BE49-F238E27FC236}">
                <a16:creationId xmlns:a16="http://schemas.microsoft.com/office/drawing/2014/main" id="{8A0A77CB-6713-46B7-BAC1-9F391259DCFC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Freeform 35">
            <a:extLst>
              <a:ext uri="{FF2B5EF4-FFF2-40B4-BE49-F238E27FC236}">
                <a16:creationId xmlns:a16="http://schemas.microsoft.com/office/drawing/2014/main" id="{B38D4C96-F79C-4F25-A7B0-11B238090AB3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Freeform 36">
            <a:extLst>
              <a:ext uri="{FF2B5EF4-FFF2-40B4-BE49-F238E27FC236}">
                <a16:creationId xmlns:a16="http://schemas.microsoft.com/office/drawing/2014/main" id="{9101A39F-CD18-4B66-BCF9-BDFA6A118F80}"/>
              </a:ext>
            </a:extLst>
          </p:cNvPr>
          <p:cNvSpPr>
            <a:spLocks/>
          </p:cNvSpPr>
          <p:nvPr/>
        </p:nvSpPr>
        <p:spPr bwMode="auto">
          <a:xfrm>
            <a:off x="6956425" y="4343400"/>
            <a:ext cx="203200" cy="203200"/>
          </a:xfrm>
          <a:custGeom>
            <a:avLst/>
            <a:gdLst>
              <a:gd name="T0" fmla="*/ 0 w 128"/>
              <a:gd name="T1" fmla="*/ 64 h 128"/>
              <a:gd name="T2" fmla="*/ 0 w 128"/>
              <a:gd name="T3" fmla="*/ 64 h 128"/>
              <a:gd name="T4" fmla="*/ 1 w 128"/>
              <a:gd name="T5" fmla="*/ 52 h 128"/>
              <a:gd name="T6" fmla="*/ 6 w 128"/>
              <a:gd name="T7" fmla="*/ 39 h 128"/>
              <a:gd name="T8" fmla="*/ 11 w 128"/>
              <a:gd name="T9" fmla="*/ 28 h 128"/>
              <a:gd name="T10" fmla="*/ 18 w 128"/>
              <a:gd name="T11" fmla="*/ 19 h 128"/>
              <a:gd name="T12" fmla="*/ 29 w 128"/>
              <a:gd name="T13" fmla="*/ 11 h 128"/>
              <a:gd name="T14" fmla="*/ 39 w 128"/>
              <a:gd name="T15" fmla="*/ 5 h 128"/>
              <a:gd name="T16" fmla="*/ 51 w 128"/>
              <a:gd name="T17" fmla="*/ 1 h 128"/>
              <a:gd name="T18" fmla="*/ 64 w 128"/>
              <a:gd name="T19" fmla="*/ 0 h 128"/>
              <a:gd name="T20" fmla="*/ 64 w 128"/>
              <a:gd name="T21" fmla="*/ 0 h 128"/>
              <a:gd name="T22" fmla="*/ 78 w 128"/>
              <a:gd name="T23" fmla="*/ 1 h 128"/>
              <a:gd name="T24" fmla="*/ 89 w 128"/>
              <a:gd name="T25" fmla="*/ 5 h 128"/>
              <a:gd name="T26" fmla="*/ 100 w 128"/>
              <a:gd name="T27" fmla="*/ 11 h 128"/>
              <a:gd name="T28" fmla="*/ 109 w 128"/>
              <a:gd name="T29" fmla="*/ 19 h 128"/>
              <a:gd name="T30" fmla="*/ 117 w 128"/>
              <a:gd name="T31" fmla="*/ 28 h 128"/>
              <a:gd name="T32" fmla="*/ 123 w 128"/>
              <a:gd name="T33" fmla="*/ 39 h 128"/>
              <a:gd name="T34" fmla="*/ 127 w 128"/>
              <a:gd name="T35" fmla="*/ 52 h 128"/>
              <a:gd name="T36" fmla="*/ 128 w 128"/>
              <a:gd name="T37" fmla="*/ 64 h 128"/>
              <a:gd name="T38" fmla="*/ 128 w 128"/>
              <a:gd name="T39" fmla="*/ 64 h 128"/>
              <a:gd name="T40" fmla="*/ 127 w 128"/>
              <a:gd name="T41" fmla="*/ 77 h 128"/>
              <a:gd name="T42" fmla="*/ 123 w 128"/>
              <a:gd name="T43" fmla="*/ 89 h 128"/>
              <a:gd name="T44" fmla="*/ 117 w 128"/>
              <a:gd name="T45" fmla="*/ 100 h 128"/>
              <a:gd name="T46" fmla="*/ 109 w 128"/>
              <a:gd name="T47" fmla="*/ 110 h 128"/>
              <a:gd name="T48" fmla="*/ 100 w 128"/>
              <a:gd name="T49" fmla="*/ 117 h 128"/>
              <a:gd name="T50" fmla="*/ 89 w 128"/>
              <a:gd name="T51" fmla="*/ 124 h 128"/>
              <a:gd name="T52" fmla="*/ 78 w 128"/>
              <a:gd name="T53" fmla="*/ 127 h 128"/>
              <a:gd name="T54" fmla="*/ 64 w 128"/>
              <a:gd name="T55" fmla="*/ 128 h 128"/>
              <a:gd name="T56" fmla="*/ 64 w 128"/>
              <a:gd name="T57" fmla="*/ 128 h 128"/>
              <a:gd name="T58" fmla="*/ 51 w 128"/>
              <a:gd name="T59" fmla="*/ 127 h 128"/>
              <a:gd name="T60" fmla="*/ 39 w 128"/>
              <a:gd name="T61" fmla="*/ 124 h 128"/>
              <a:gd name="T62" fmla="*/ 29 w 128"/>
              <a:gd name="T63" fmla="*/ 117 h 128"/>
              <a:gd name="T64" fmla="*/ 18 w 128"/>
              <a:gd name="T65" fmla="*/ 110 h 128"/>
              <a:gd name="T66" fmla="*/ 11 w 128"/>
              <a:gd name="T67" fmla="*/ 100 h 128"/>
              <a:gd name="T68" fmla="*/ 6 w 128"/>
              <a:gd name="T69" fmla="*/ 89 h 128"/>
              <a:gd name="T70" fmla="*/ 1 w 128"/>
              <a:gd name="T71" fmla="*/ 77 h 128"/>
              <a:gd name="T72" fmla="*/ 0 w 128"/>
              <a:gd name="T73" fmla="*/ 64 h 1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8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6" y="39"/>
                </a:lnTo>
                <a:lnTo>
                  <a:pt x="11" y="28"/>
                </a:lnTo>
                <a:lnTo>
                  <a:pt x="18" y="19"/>
                </a:lnTo>
                <a:lnTo>
                  <a:pt x="29" y="11"/>
                </a:lnTo>
                <a:lnTo>
                  <a:pt x="39" y="5"/>
                </a:lnTo>
                <a:lnTo>
                  <a:pt x="51" y="1"/>
                </a:lnTo>
                <a:lnTo>
                  <a:pt x="64" y="0"/>
                </a:lnTo>
                <a:lnTo>
                  <a:pt x="64" y="0"/>
                </a:lnTo>
                <a:lnTo>
                  <a:pt x="78" y="1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7"/>
                </a:lnTo>
                <a:lnTo>
                  <a:pt x="89" y="124"/>
                </a:lnTo>
                <a:lnTo>
                  <a:pt x="78" y="127"/>
                </a:lnTo>
                <a:lnTo>
                  <a:pt x="64" y="128"/>
                </a:lnTo>
                <a:lnTo>
                  <a:pt x="64" y="128"/>
                </a:lnTo>
                <a:lnTo>
                  <a:pt x="51" y="127"/>
                </a:lnTo>
                <a:lnTo>
                  <a:pt x="39" y="124"/>
                </a:lnTo>
                <a:lnTo>
                  <a:pt x="29" y="117"/>
                </a:lnTo>
                <a:lnTo>
                  <a:pt x="18" y="110"/>
                </a:lnTo>
                <a:lnTo>
                  <a:pt x="11" y="100"/>
                </a:lnTo>
                <a:lnTo>
                  <a:pt x="6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801CE1B4-5B4F-4DE4-AC19-39E6545180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91290" y="3269453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0235316C-FFF8-4273-89FD-A0FD744488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41044" y="1995766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2" name="Rectangle 39">
            <a:extLst>
              <a:ext uri="{FF2B5EF4-FFF2-40B4-BE49-F238E27FC236}">
                <a16:creationId xmlns:a16="http://schemas.microsoft.com/office/drawing/2014/main" id="{E1DC3EDF-5D3C-41A3-8023-1E313C5829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9422" y="1677245"/>
            <a:ext cx="9778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→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D4FA0BF4-0A94-462E-9F04-B284D0589D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5789" y="2651125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4" name="Rectangle 41">
            <a:extLst>
              <a:ext uri="{FF2B5EF4-FFF2-40B4-BE49-F238E27FC236}">
                <a16:creationId xmlns:a16="http://schemas.microsoft.com/office/drawing/2014/main" id="{4E8A1D1A-D58C-4155-B9D5-6EFB93C90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8256" y="3870325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T</a:t>
            </a:r>
            <a:r>
              <a:rPr lang="en-US" altLang="zh-CN" sz="1000" dirty="0" err="1">
                <a:cs typeface="Arial" panose="020B0604020202020204" pitchFamily="34" charset="0"/>
              </a:rPr>
              <a:t>z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mb</a:t>
            </a: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DA6ED51C-AE95-4B44-B563-D213F6D1EB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9819" y="4864120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+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7B064A84-93FC-49E0-946C-DBFA008CCD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137399" y="4544755"/>
            <a:ext cx="9730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lang="en-US" altLang="zh-CN" sz="1000" dirty="0"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Ner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7B792B6-DE4C-46F2-A89B-DF7CDE3F5D9A}"/>
              </a:ext>
            </a:extLst>
          </p:cNvPr>
          <p:cNvSpPr txBox="1"/>
          <p:nvPr/>
        </p:nvSpPr>
        <p:spPr>
          <a:xfrm>
            <a:off x="3015425" y="120030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30128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CBD6A382-A2A2-47CE-8FDC-8FFBB30D2046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962775" y="2092325"/>
            <a:ext cx="587375" cy="11731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83977471-150A-46B2-BCFF-8FC451D0227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661025" y="2001838"/>
            <a:ext cx="1155700" cy="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B2FD34B2-FC2F-4869-9AE5-8D580578383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67288" y="2057400"/>
            <a:ext cx="1866900" cy="124301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9">
            <a:extLst>
              <a:ext uri="{FF2B5EF4-FFF2-40B4-BE49-F238E27FC236}">
                <a16:creationId xmlns:a16="http://schemas.microsoft.com/office/drawing/2014/main" id="{E9E2E827-125C-465D-AC62-8BA6F264E4D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5607050" y="2092325"/>
            <a:ext cx="1263650" cy="2528888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0">
            <a:extLst>
              <a:ext uri="{FF2B5EF4-FFF2-40B4-BE49-F238E27FC236}">
                <a16:creationId xmlns:a16="http://schemas.microsoft.com/office/drawing/2014/main" id="{6231B14B-B5FA-490B-996E-22AFBA4EFAB9}"/>
              </a:ext>
            </a:extLst>
          </p:cNvPr>
          <p:cNvSpPr>
            <a:spLocks noChangeShapeType="1"/>
          </p:cNvSpPr>
          <p:nvPr/>
        </p:nvSpPr>
        <p:spPr bwMode="auto">
          <a:xfrm>
            <a:off x="6918325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02A6B906-4083-4EC8-829D-32DF1A4F8F1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27600" y="2092325"/>
            <a:ext cx="587375" cy="11731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2">
            <a:extLst>
              <a:ext uri="{FF2B5EF4-FFF2-40B4-BE49-F238E27FC236}">
                <a16:creationId xmlns:a16="http://schemas.microsoft.com/office/drawing/2014/main" id="{0DC509CC-092F-4656-9280-7FB328636D84}"/>
              </a:ext>
            </a:extLst>
          </p:cNvPr>
          <p:cNvSpPr>
            <a:spLocks noChangeShapeType="1"/>
          </p:cNvSpPr>
          <p:nvPr/>
        </p:nvSpPr>
        <p:spPr bwMode="auto">
          <a:xfrm>
            <a:off x="5562600" y="2101850"/>
            <a:ext cx="0" cy="25098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6DB31EE8-9949-4A72-8959-854371F54E85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7600" y="3448050"/>
            <a:ext cx="587375" cy="1173163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4">
            <a:extLst>
              <a:ext uri="{FF2B5EF4-FFF2-40B4-BE49-F238E27FC236}">
                <a16:creationId xmlns:a16="http://schemas.microsoft.com/office/drawing/2014/main" id="{BFCA8B3F-3750-46D0-B94F-BD68638E1F46}"/>
              </a:ext>
            </a:extLst>
          </p:cNvPr>
          <p:cNvSpPr>
            <a:spLocks noChangeShapeType="1"/>
          </p:cNvSpPr>
          <p:nvPr/>
        </p:nvSpPr>
        <p:spPr bwMode="auto">
          <a:xfrm>
            <a:off x="5661025" y="4713288"/>
            <a:ext cx="1155700" cy="0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15">
            <a:extLst>
              <a:ext uri="{FF2B5EF4-FFF2-40B4-BE49-F238E27FC236}">
                <a16:creationId xmlns:a16="http://schemas.microsoft.com/office/drawing/2014/main" id="{031AF153-7FCB-4BD4-9DEE-FC143FD00794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B00AF24F-A1B3-43D7-9B0B-9A6F97FFAE47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70AF0AC5-1619-4020-B369-D70CF97F4DB1}"/>
              </a:ext>
            </a:extLst>
          </p:cNvPr>
          <p:cNvSpPr>
            <a:spLocks/>
          </p:cNvSpPr>
          <p:nvPr/>
        </p:nvSpPr>
        <p:spPr bwMode="auto">
          <a:xfrm>
            <a:off x="7493000" y="3255963"/>
            <a:ext cx="204788" cy="204788"/>
          </a:xfrm>
          <a:custGeom>
            <a:avLst/>
            <a:gdLst>
              <a:gd name="T0" fmla="*/ 0 w 129"/>
              <a:gd name="T1" fmla="*/ 64 h 129"/>
              <a:gd name="T2" fmla="*/ 0 w 129"/>
              <a:gd name="T3" fmla="*/ 64 h 129"/>
              <a:gd name="T4" fmla="*/ 2 w 129"/>
              <a:gd name="T5" fmla="*/ 50 h 129"/>
              <a:gd name="T6" fmla="*/ 6 w 129"/>
              <a:gd name="T7" fmla="*/ 39 h 129"/>
              <a:gd name="T8" fmla="*/ 11 w 129"/>
              <a:gd name="T9" fmla="*/ 28 h 129"/>
              <a:gd name="T10" fmla="*/ 19 w 129"/>
              <a:gd name="T11" fmla="*/ 19 h 129"/>
              <a:gd name="T12" fmla="*/ 28 w 129"/>
              <a:gd name="T13" fmla="*/ 11 h 129"/>
              <a:gd name="T14" fmla="*/ 39 w 129"/>
              <a:gd name="T15" fmla="*/ 5 h 129"/>
              <a:gd name="T16" fmla="*/ 52 w 129"/>
              <a:gd name="T17" fmla="*/ 2 h 129"/>
              <a:gd name="T18" fmla="*/ 64 w 129"/>
              <a:gd name="T19" fmla="*/ 0 h 129"/>
              <a:gd name="T20" fmla="*/ 64 w 129"/>
              <a:gd name="T21" fmla="*/ 0 h 129"/>
              <a:gd name="T22" fmla="*/ 77 w 129"/>
              <a:gd name="T23" fmla="*/ 2 h 129"/>
              <a:gd name="T24" fmla="*/ 89 w 129"/>
              <a:gd name="T25" fmla="*/ 5 h 129"/>
              <a:gd name="T26" fmla="*/ 100 w 129"/>
              <a:gd name="T27" fmla="*/ 11 h 129"/>
              <a:gd name="T28" fmla="*/ 110 w 129"/>
              <a:gd name="T29" fmla="*/ 19 h 129"/>
              <a:gd name="T30" fmla="*/ 118 w 129"/>
              <a:gd name="T31" fmla="*/ 28 h 129"/>
              <a:gd name="T32" fmla="*/ 124 w 129"/>
              <a:gd name="T33" fmla="*/ 39 h 129"/>
              <a:gd name="T34" fmla="*/ 127 w 129"/>
              <a:gd name="T35" fmla="*/ 50 h 129"/>
              <a:gd name="T36" fmla="*/ 129 w 129"/>
              <a:gd name="T37" fmla="*/ 64 h 129"/>
              <a:gd name="T38" fmla="*/ 129 w 129"/>
              <a:gd name="T39" fmla="*/ 64 h 129"/>
              <a:gd name="T40" fmla="*/ 127 w 129"/>
              <a:gd name="T41" fmla="*/ 77 h 129"/>
              <a:gd name="T42" fmla="*/ 124 w 129"/>
              <a:gd name="T43" fmla="*/ 89 h 129"/>
              <a:gd name="T44" fmla="*/ 118 w 129"/>
              <a:gd name="T45" fmla="*/ 100 h 129"/>
              <a:gd name="T46" fmla="*/ 110 w 129"/>
              <a:gd name="T47" fmla="*/ 110 h 129"/>
              <a:gd name="T48" fmla="*/ 100 w 129"/>
              <a:gd name="T49" fmla="*/ 118 h 129"/>
              <a:gd name="T50" fmla="*/ 89 w 129"/>
              <a:gd name="T51" fmla="*/ 122 h 129"/>
              <a:gd name="T52" fmla="*/ 77 w 129"/>
              <a:gd name="T53" fmla="*/ 127 h 129"/>
              <a:gd name="T54" fmla="*/ 64 w 129"/>
              <a:gd name="T55" fmla="*/ 129 h 129"/>
              <a:gd name="T56" fmla="*/ 64 w 129"/>
              <a:gd name="T57" fmla="*/ 129 h 129"/>
              <a:gd name="T58" fmla="*/ 52 w 129"/>
              <a:gd name="T59" fmla="*/ 127 h 129"/>
              <a:gd name="T60" fmla="*/ 39 w 129"/>
              <a:gd name="T61" fmla="*/ 122 h 129"/>
              <a:gd name="T62" fmla="*/ 28 w 129"/>
              <a:gd name="T63" fmla="*/ 118 h 129"/>
              <a:gd name="T64" fmla="*/ 19 w 129"/>
              <a:gd name="T65" fmla="*/ 110 h 129"/>
              <a:gd name="T66" fmla="*/ 11 w 129"/>
              <a:gd name="T67" fmla="*/ 100 h 129"/>
              <a:gd name="T68" fmla="*/ 6 w 129"/>
              <a:gd name="T69" fmla="*/ 89 h 129"/>
              <a:gd name="T70" fmla="*/ 2 w 129"/>
              <a:gd name="T71" fmla="*/ 77 h 129"/>
              <a:gd name="T72" fmla="*/ 0 w 129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9" h="129">
                <a:moveTo>
                  <a:pt x="0" y="64"/>
                </a:moveTo>
                <a:lnTo>
                  <a:pt x="0" y="64"/>
                </a:lnTo>
                <a:lnTo>
                  <a:pt x="2" y="50"/>
                </a:lnTo>
                <a:lnTo>
                  <a:pt x="6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2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100" y="11"/>
                </a:lnTo>
                <a:lnTo>
                  <a:pt x="110" y="19"/>
                </a:lnTo>
                <a:lnTo>
                  <a:pt x="118" y="28"/>
                </a:lnTo>
                <a:lnTo>
                  <a:pt x="124" y="39"/>
                </a:lnTo>
                <a:lnTo>
                  <a:pt x="127" y="50"/>
                </a:lnTo>
                <a:lnTo>
                  <a:pt x="129" y="64"/>
                </a:lnTo>
                <a:lnTo>
                  <a:pt x="129" y="64"/>
                </a:lnTo>
                <a:lnTo>
                  <a:pt x="127" y="77"/>
                </a:lnTo>
                <a:lnTo>
                  <a:pt x="124" y="89"/>
                </a:lnTo>
                <a:lnTo>
                  <a:pt x="118" y="100"/>
                </a:lnTo>
                <a:lnTo>
                  <a:pt x="110" y="110"/>
                </a:lnTo>
                <a:lnTo>
                  <a:pt x="100" y="118"/>
                </a:lnTo>
                <a:lnTo>
                  <a:pt x="89" y="122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2" y="127"/>
                </a:lnTo>
                <a:lnTo>
                  <a:pt x="39" y="122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6" y="89"/>
                </a:lnTo>
                <a:lnTo>
                  <a:pt x="2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80E8174E-4F2B-447F-A46D-AA5B76762456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C4274A63-3A93-4EDE-8593-2054A73A46EE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C1BD48EC-46E1-410F-989F-CCB54191EF75}"/>
              </a:ext>
            </a:extLst>
          </p:cNvPr>
          <p:cNvSpPr>
            <a:spLocks/>
          </p:cNvSpPr>
          <p:nvPr/>
        </p:nvSpPr>
        <p:spPr bwMode="auto">
          <a:xfrm>
            <a:off x="6816725" y="1900238"/>
            <a:ext cx="203200" cy="201613"/>
          </a:xfrm>
          <a:custGeom>
            <a:avLst/>
            <a:gdLst>
              <a:gd name="T0" fmla="*/ 0 w 128"/>
              <a:gd name="T1" fmla="*/ 64 h 127"/>
              <a:gd name="T2" fmla="*/ 0 w 128"/>
              <a:gd name="T3" fmla="*/ 64 h 127"/>
              <a:gd name="T4" fmla="*/ 1 w 128"/>
              <a:gd name="T5" fmla="*/ 50 h 127"/>
              <a:gd name="T6" fmla="*/ 4 w 128"/>
              <a:gd name="T7" fmla="*/ 39 h 127"/>
              <a:gd name="T8" fmla="*/ 11 w 128"/>
              <a:gd name="T9" fmla="*/ 28 h 127"/>
              <a:gd name="T10" fmla="*/ 19 w 128"/>
              <a:gd name="T11" fmla="*/ 19 h 127"/>
              <a:gd name="T12" fmla="*/ 28 w 128"/>
              <a:gd name="T13" fmla="*/ 11 h 127"/>
              <a:gd name="T14" fmla="*/ 39 w 128"/>
              <a:gd name="T15" fmla="*/ 5 h 127"/>
              <a:gd name="T16" fmla="*/ 50 w 128"/>
              <a:gd name="T17" fmla="*/ 0 h 127"/>
              <a:gd name="T18" fmla="*/ 64 w 128"/>
              <a:gd name="T19" fmla="*/ 0 h 127"/>
              <a:gd name="T20" fmla="*/ 64 w 128"/>
              <a:gd name="T21" fmla="*/ 0 h 127"/>
              <a:gd name="T22" fmla="*/ 77 w 128"/>
              <a:gd name="T23" fmla="*/ 0 h 127"/>
              <a:gd name="T24" fmla="*/ 89 w 128"/>
              <a:gd name="T25" fmla="*/ 5 h 127"/>
              <a:gd name="T26" fmla="*/ 99 w 128"/>
              <a:gd name="T27" fmla="*/ 11 h 127"/>
              <a:gd name="T28" fmla="*/ 110 w 128"/>
              <a:gd name="T29" fmla="*/ 19 h 127"/>
              <a:gd name="T30" fmla="*/ 117 w 128"/>
              <a:gd name="T31" fmla="*/ 28 h 127"/>
              <a:gd name="T32" fmla="*/ 122 w 128"/>
              <a:gd name="T33" fmla="*/ 39 h 127"/>
              <a:gd name="T34" fmla="*/ 127 w 128"/>
              <a:gd name="T35" fmla="*/ 50 h 127"/>
              <a:gd name="T36" fmla="*/ 128 w 128"/>
              <a:gd name="T37" fmla="*/ 64 h 127"/>
              <a:gd name="T38" fmla="*/ 128 w 128"/>
              <a:gd name="T39" fmla="*/ 64 h 127"/>
              <a:gd name="T40" fmla="*/ 127 w 128"/>
              <a:gd name="T41" fmla="*/ 77 h 127"/>
              <a:gd name="T42" fmla="*/ 122 w 128"/>
              <a:gd name="T43" fmla="*/ 88 h 127"/>
              <a:gd name="T44" fmla="*/ 117 w 128"/>
              <a:gd name="T45" fmla="*/ 99 h 127"/>
              <a:gd name="T46" fmla="*/ 110 w 128"/>
              <a:gd name="T47" fmla="*/ 108 h 127"/>
              <a:gd name="T48" fmla="*/ 99 w 128"/>
              <a:gd name="T49" fmla="*/ 116 h 127"/>
              <a:gd name="T50" fmla="*/ 89 w 128"/>
              <a:gd name="T51" fmla="*/ 122 h 127"/>
              <a:gd name="T52" fmla="*/ 77 w 128"/>
              <a:gd name="T53" fmla="*/ 127 h 127"/>
              <a:gd name="T54" fmla="*/ 64 w 128"/>
              <a:gd name="T55" fmla="*/ 127 h 127"/>
              <a:gd name="T56" fmla="*/ 64 w 128"/>
              <a:gd name="T57" fmla="*/ 127 h 127"/>
              <a:gd name="T58" fmla="*/ 50 w 128"/>
              <a:gd name="T59" fmla="*/ 127 h 127"/>
              <a:gd name="T60" fmla="*/ 39 w 128"/>
              <a:gd name="T61" fmla="*/ 122 h 127"/>
              <a:gd name="T62" fmla="*/ 28 w 128"/>
              <a:gd name="T63" fmla="*/ 116 h 127"/>
              <a:gd name="T64" fmla="*/ 19 w 128"/>
              <a:gd name="T65" fmla="*/ 108 h 127"/>
              <a:gd name="T66" fmla="*/ 11 w 128"/>
              <a:gd name="T67" fmla="*/ 99 h 127"/>
              <a:gd name="T68" fmla="*/ 4 w 128"/>
              <a:gd name="T69" fmla="*/ 88 h 127"/>
              <a:gd name="T70" fmla="*/ 1 w 128"/>
              <a:gd name="T71" fmla="*/ 77 h 127"/>
              <a:gd name="T72" fmla="*/ 0 w 128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7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7" y="0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8"/>
                </a:lnTo>
                <a:lnTo>
                  <a:pt x="117" y="99"/>
                </a:lnTo>
                <a:lnTo>
                  <a:pt x="110" y="108"/>
                </a:lnTo>
                <a:lnTo>
                  <a:pt x="99" y="116"/>
                </a:lnTo>
                <a:lnTo>
                  <a:pt x="89" y="122"/>
                </a:lnTo>
                <a:lnTo>
                  <a:pt x="77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9" y="108"/>
                </a:lnTo>
                <a:lnTo>
                  <a:pt x="11" y="99"/>
                </a:lnTo>
                <a:lnTo>
                  <a:pt x="4" y="88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Freeform 21">
            <a:extLst>
              <a:ext uri="{FF2B5EF4-FFF2-40B4-BE49-F238E27FC236}">
                <a16:creationId xmlns:a16="http://schemas.microsoft.com/office/drawing/2014/main" id="{BA3C04FE-9E3B-4707-AA6B-7FC2887FDD78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34BD8B6E-59A2-441B-922F-6F79DAF50F09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Freeform 23">
            <a:extLst>
              <a:ext uri="{FF2B5EF4-FFF2-40B4-BE49-F238E27FC236}">
                <a16:creationId xmlns:a16="http://schemas.microsoft.com/office/drawing/2014/main" id="{C08A38E6-6705-433C-9D3C-6C3EDBFBD669}"/>
              </a:ext>
            </a:extLst>
          </p:cNvPr>
          <p:cNvSpPr>
            <a:spLocks/>
          </p:cNvSpPr>
          <p:nvPr/>
        </p:nvSpPr>
        <p:spPr bwMode="auto">
          <a:xfrm>
            <a:off x="5461000" y="1900238"/>
            <a:ext cx="200025" cy="201613"/>
          </a:xfrm>
          <a:custGeom>
            <a:avLst/>
            <a:gdLst>
              <a:gd name="T0" fmla="*/ 0 w 126"/>
              <a:gd name="T1" fmla="*/ 64 h 127"/>
              <a:gd name="T2" fmla="*/ 0 w 126"/>
              <a:gd name="T3" fmla="*/ 64 h 127"/>
              <a:gd name="T4" fmla="*/ 0 w 126"/>
              <a:gd name="T5" fmla="*/ 50 h 127"/>
              <a:gd name="T6" fmla="*/ 4 w 126"/>
              <a:gd name="T7" fmla="*/ 39 h 127"/>
              <a:gd name="T8" fmla="*/ 10 w 126"/>
              <a:gd name="T9" fmla="*/ 28 h 127"/>
              <a:gd name="T10" fmla="*/ 18 w 126"/>
              <a:gd name="T11" fmla="*/ 19 h 127"/>
              <a:gd name="T12" fmla="*/ 28 w 126"/>
              <a:gd name="T13" fmla="*/ 11 h 127"/>
              <a:gd name="T14" fmla="*/ 39 w 126"/>
              <a:gd name="T15" fmla="*/ 5 h 127"/>
              <a:gd name="T16" fmla="*/ 50 w 126"/>
              <a:gd name="T17" fmla="*/ 0 h 127"/>
              <a:gd name="T18" fmla="*/ 64 w 126"/>
              <a:gd name="T19" fmla="*/ 0 h 127"/>
              <a:gd name="T20" fmla="*/ 64 w 126"/>
              <a:gd name="T21" fmla="*/ 0 h 127"/>
              <a:gd name="T22" fmla="*/ 76 w 126"/>
              <a:gd name="T23" fmla="*/ 0 h 127"/>
              <a:gd name="T24" fmla="*/ 87 w 126"/>
              <a:gd name="T25" fmla="*/ 5 h 127"/>
              <a:gd name="T26" fmla="*/ 98 w 126"/>
              <a:gd name="T27" fmla="*/ 11 h 127"/>
              <a:gd name="T28" fmla="*/ 108 w 126"/>
              <a:gd name="T29" fmla="*/ 19 h 127"/>
              <a:gd name="T30" fmla="*/ 116 w 126"/>
              <a:gd name="T31" fmla="*/ 28 h 127"/>
              <a:gd name="T32" fmla="*/ 122 w 126"/>
              <a:gd name="T33" fmla="*/ 39 h 127"/>
              <a:gd name="T34" fmla="*/ 126 w 126"/>
              <a:gd name="T35" fmla="*/ 50 h 127"/>
              <a:gd name="T36" fmla="*/ 126 w 126"/>
              <a:gd name="T37" fmla="*/ 64 h 127"/>
              <a:gd name="T38" fmla="*/ 126 w 126"/>
              <a:gd name="T39" fmla="*/ 64 h 127"/>
              <a:gd name="T40" fmla="*/ 126 w 126"/>
              <a:gd name="T41" fmla="*/ 77 h 127"/>
              <a:gd name="T42" fmla="*/ 122 w 126"/>
              <a:gd name="T43" fmla="*/ 88 h 127"/>
              <a:gd name="T44" fmla="*/ 116 w 126"/>
              <a:gd name="T45" fmla="*/ 99 h 127"/>
              <a:gd name="T46" fmla="*/ 108 w 126"/>
              <a:gd name="T47" fmla="*/ 108 h 127"/>
              <a:gd name="T48" fmla="*/ 98 w 126"/>
              <a:gd name="T49" fmla="*/ 116 h 127"/>
              <a:gd name="T50" fmla="*/ 87 w 126"/>
              <a:gd name="T51" fmla="*/ 122 h 127"/>
              <a:gd name="T52" fmla="*/ 76 w 126"/>
              <a:gd name="T53" fmla="*/ 127 h 127"/>
              <a:gd name="T54" fmla="*/ 64 w 126"/>
              <a:gd name="T55" fmla="*/ 127 h 127"/>
              <a:gd name="T56" fmla="*/ 64 w 126"/>
              <a:gd name="T57" fmla="*/ 127 h 127"/>
              <a:gd name="T58" fmla="*/ 50 w 126"/>
              <a:gd name="T59" fmla="*/ 127 h 127"/>
              <a:gd name="T60" fmla="*/ 39 w 126"/>
              <a:gd name="T61" fmla="*/ 122 h 127"/>
              <a:gd name="T62" fmla="*/ 28 w 126"/>
              <a:gd name="T63" fmla="*/ 116 h 127"/>
              <a:gd name="T64" fmla="*/ 18 w 126"/>
              <a:gd name="T65" fmla="*/ 108 h 127"/>
              <a:gd name="T66" fmla="*/ 10 w 126"/>
              <a:gd name="T67" fmla="*/ 99 h 127"/>
              <a:gd name="T68" fmla="*/ 4 w 126"/>
              <a:gd name="T69" fmla="*/ 88 h 127"/>
              <a:gd name="T70" fmla="*/ 0 w 126"/>
              <a:gd name="T71" fmla="*/ 77 h 127"/>
              <a:gd name="T72" fmla="*/ 0 w 126"/>
              <a:gd name="T73" fmla="*/ 64 h 1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7">
                <a:moveTo>
                  <a:pt x="0" y="64"/>
                </a:moveTo>
                <a:lnTo>
                  <a:pt x="0" y="64"/>
                </a:lnTo>
                <a:lnTo>
                  <a:pt x="0" y="50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0"/>
                </a:lnTo>
                <a:lnTo>
                  <a:pt x="64" y="0"/>
                </a:lnTo>
                <a:lnTo>
                  <a:pt x="64" y="0"/>
                </a:lnTo>
                <a:lnTo>
                  <a:pt x="76" y="0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0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8"/>
                </a:lnTo>
                <a:lnTo>
                  <a:pt x="116" y="99"/>
                </a:lnTo>
                <a:lnTo>
                  <a:pt x="108" y="108"/>
                </a:lnTo>
                <a:lnTo>
                  <a:pt x="98" y="116"/>
                </a:lnTo>
                <a:lnTo>
                  <a:pt x="87" y="122"/>
                </a:lnTo>
                <a:lnTo>
                  <a:pt x="76" y="127"/>
                </a:lnTo>
                <a:lnTo>
                  <a:pt x="64" y="127"/>
                </a:lnTo>
                <a:lnTo>
                  <a:pt x="64" y="127"/>
                </a:lnTo>
                <a:lnTo>
                  <a:pt x="50" y="127"/>
                </a:lnTo>
                <a:lnTo>
                  <a:pt x="39" y="122"/>
                </a:lnTo>
                <a:lnTo>
                  <a:pt x="28" y="116"/>
                </a:lnTo>
                <a:lnTo>
                  <a:pt x="18" y="108"/>
                </a:lnTo>
                <a:lnTo>
                  <a:pt x="10" y="99"/>
                </a:lnTo>
                <a:lnTo>
                  <a:pt x="4" y="88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6FAFEAD2-F005-4F21-A50B-90D1FA79C802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9E522737-3923-41AF-92E0-95EF6915567C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6">
            <a:extLst>
              <a:ext uri="{FF2B5EF4-FFF2-40B4-BE49-F238E27FC236}">
                <a16:creationId xmlns:a16="http://schemas.microsoft.com/office/drawing/2014/main" id="{970EB633-1872-4773-8666-28A52B1C4F48}"/>
              </a:ext>
            </a:extLst>
          </p:cNvPr>
          <p:cNvSpPr>
            <a:spLocks/>
          </p:cNvSpPr>
          <p:nvPr/>
        </p:nvSpPr>
        <p:spPr bwMode="auto">
          <a:xfrm>
            <a:off x="4781550" y="3255963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0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3 w 128"/>
              <a:gd name="T33" fmla="*/ 39 h 129"/>
              <a:gd name="T34" fmla="*/ 127 w 128"/>
              <a:gd name="T35" fmla="*/ 50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3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2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2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0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3" y="39"/>
                </a:lnTo>
                <a:lnTo>
                  <a:pt x="127" y="50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3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2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2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176EBA61-31A7-4980-9A8C-874C420C72B2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C7FED589-6F51-467B-BBAB-4245803E9C62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Freeform 29">
            <a:extLst>
              <a:ext uri="{FF2B5EF4-FFF2-40B4-BE49-F238E27FC236}">
                <a16:creationId xmlns:a16="http://schemas.microsoft.com/office/drawing/2014/main" id="{041B58E0-4237-470C-9F19-9A2D5C57C00C}"/>
              </a:ext>
            </a:extLst>
          </p:cNvPr>
          <p:cNvSpPr>
            <a:spLocks/>
          </p:cNvSpPr>
          <p:nvPr/>
        </p:nvSpPr>
        <p:spPr bwMode="auto">
          <a:xfrm>
            <a:off x="5461000" y="4611688"/>
            <a:ext cx="200025" cy="204788"/>
          </a:xfrm>
          <a:custGeom>
            <a:avLst/>
            <a:gdLst>
              <a:gd name="T0" fmla="*/ 0 w 126"/>
              <a:gd name="T1" fmla="*/ 64 h 129"/>
              <a:gd name="T2" fmla="*/ 0 w 126"/>
              <a:gd name="T3" fmla="*/ 64 h 129"/>
              <a:gd name="T4" fmla="*/ 0 w 126"/>
              <a:gd name="T5" fmla="*/ 52 h 129"/>
              <a:gd name="T6" fmla="*/ 4 w 126"/>
              <a:gd name="T7" fmla="*/ 39 h 129"/>
              <a:gd name="T8" fmla="*/ 10 w 126"/>
              <a:gd name="T9" fmla="*/ 28 h 129"/>
              <a:gd name="T10" fmla="*/ 18 w 126"/>
              <a:gd name="T11" fmla="*/ 19 h 129"/>
              <a:gd name="T12" fmla="*/ 28 w 126"/>
              <a:gd name="T13" fmla="*/ 11 h 129"/>
              <a:gd name="T14" fmla="*/ 39 w 126"/>
              <a:gd name="T15" fmla="*/ 5 h 129"/>
              <a:gd name="T16" fmla="*/ 50 w 126"/>
              <a:gd name="T17" fmla="*/ 2 h 129"/>
              <a:gd name="T18" fmla="*/ 64 w 126"/>
              <a:gd name="T19" fmla="*/ 0 h 129"/>
              <a:gd name="T20" fmla="*/ 64 w 126"/>
              <a:gd name="T21" fmla="*/ 0 h 129"/>
              <a:gd name="T22" fmla="*/ 76 w 126"/>
              <a:gd name="T23" fmla="*/ 2 h 129"/>
              <a:gd name="T24" fmla="*/ 87 w 126"/>
              <a:gd name="T25" fmla="*/ 5 h 129"/>
              <a:gd name="T26" fmla="*/ 98 w 126"/>
              <a:gd name="T27" fmla="*/ 11 h 129"/>
              <a:gd name="T28" fmla="*/ 108 w 126"/>
              <a:gd name="T29" fmla="*/ 19 h 129"/>
              <a:gd name="T30" fmla="*/ 116 w 126"/>
              <a:gd name="T31" fmla="*/ 28 h 129"/>
              <a:gd name="T32" fmla="*/ 122 w 126"/>
              <a:gd name="T33" fmla="*/ 39 h 129"/>
              <a:gd name="T34" fmla="*/ 126 w 126"/>
              <a:gd name="T35" fmla="*/ 52 h 129"/>
              <a:gd name="T36" fmla="*/ 126 w 126"/>
              <a:gd name="T37" fmla="*/ 64 h 129"/>
              <a:gd name="T38" fmla="*/ 126 w 126"/>
              <a:gd name="T39" fmla="*/ 64 h 129"/>
              <a:gd name="T40" fmla="*/ 126 w 126"/>
              <a:gd name="T41" fmla="*/ 77 h 129"/>
              <a:gd name="T42" fmla="*/ 122 w 126"/>
              <a:gd name="T43" fmla="*/ 89 h 129"/>
              <a:gd name="T44" fmla="*/ 116 w 126"/>
              <a:gd name="T45" fmla="*/ 100 h 129"/>
              <a:gd name="T46" fmla="*/ 108 w 126"/>
              <a:gd name="T47" fmla="*/ 110 h 129"/>
              <a:gd name="T48" fmla="*/ 98 w 126"/>
              <a:gd name="T49" fmla="*/ 118 h 129"/>
              <a:gd name="T50" fmla="*/ 87 w 126"/>
              <a:gd name="T51" fmla="*/ 124 h 129"/>
              <a:gd name="T52" fmla="*/ 76 w 126"/>
              <a:gd name="T53" fmla="*/ 127 h 129"/>
              <a:gd name="T54" fmla="*/ 64 w 126"/>
              <a:gd name="T55" fmla="*/ 129 h 129"/>
              <a:gd name="T56" fmla="*/ 64 w 126"/>
              <a:gd name="T57" fmla="*/ 129 h 129"/>
              <a:gd name="T58" fmla="*/ 50 w 126"/>
              <a:gd name="T59" fmla="*/ 127 h 129"/>
              <a:gd name="T60" fmla="*/ 39 w 126"/>
              <a:gd name="T61" fmla="*/ 124 h 129"/>
              <a:gd name="T62" fmla="*/ 28 w 126"/>
              <a:gd name="T63" fmla="*/ 118 h 129"/>
              <a:gd name="T64" fmla="*/ 18 w 126"/>
              <a:gd name="T65" fmla="*/ 110 h 129"/>
              <a:gd name="T66" fmla="*/ 10 w 126"/>
              <a:gd name="T67" fmla="*/ 100 h 129"/>
              <a:gd name="T68" fmla="*/ 4 w 126"/>
              <a:gd name="T69" fmla="*/ 89 h 129"/>
              <a:gd name="T70" fmla="*/ 0 w 126"/>
              <a:gd name="T71" fmla="*/ 77 h 129"/>
              <a:gd name="T72" fmla="*/ 0 w 126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6" h="129">
                <a:moveTo>
                  <a:pt x="0" y="64"/>
                </a:moveTo>
                <a:lnTo>
                  <a:pt x="0" y="64"/>
                </a:lnTo>
                <a:lnTo>
                  <a:pt x="0" y="52"/>
                </a:lnTo>
                <a:lnTo>
                  <a:pt x="4" y="39"/>
                </a:lnTo>
                <a:lnTo>
                  <a:pt x="10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6" y="52"/>
                </a:lnTo>
                <a:lnTo>
                  <a:pt x="126" y="64"/>
                </a:lnTo>
                <a:lnTo>
                  <a:pt x="126" y="64"/>
                </a:lnTo>
                <a:lnTo>
                  <a:pt x="126" y="77"/>
                </a:lnTo>
                <a:lnTo>
                  <a:pt x="122" y="89"/>
                </a:lnTo>
                <a:lnTo>
                  <a:pt x="116" y="100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0" y="100"/>
                </a:lnTo>
                <a:lnTo>
                  <a:pt x="4" y="89"/>
                </a:lnTo>
                <a:lnTo>
                  <a:pt x="0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Freeform 30">
            <a:extLst>
              <a:ext uri="{FF2B5EF4-FFF2-40B4-BE49-F238E27FC236}">
                <a16:creationId xmlns:a16="http://schemas.microsoft.com/office/drawing/2014/main" id="{1A0F62AC-09A6-44AA-B4FE-A819C33BDC40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1">
            <a:extLst>
              <a:ext uri="{FF2B5EF4-FFF2-40B4-BE49-F238E27FC236}">
                <a16:creationId xmlns:a16="http://schemas.microsoft.com/office/drawing/2014/main" id="{66DEBB8D-E129-435B-95E2-C73C171FBDEB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2">
            <a:extLst>
              <a:ext uri="{FF2B5EF4-FFF2-40B4-BE49-F238E27FC236}">
                <a16:creationId xmlns:a16="http://schemas.microsoft.com/office/drawing/2014/main" id="{AB112277-67EA-4509-947E-DC12695076C9}"/>
              </a:ext>
            </a:extLst>
          </p:cNvPr>
          <p:cNvSpPr>
            <a:spLocks/>
          </p:cNvSpPr>
          <p:nvPr/>
        </p:nvSpPr>
        <p:spPr bwMode="auto">
          <a:xfrm>
            <a:off x="6816725" y="4611688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9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0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7 w 128"/>
              <a:gd name="T23" fmla="*/ 2 h 129"/>
              <a:gd name="T24" fmla="*/ 89 w 128"/>
              <a:gd name="T25" fmla="*/ 5 h 129"/>
              <a:gd name="T26" fmla="*/ 99 w 128"/>
              <a:gd name="T27" fmla="*/ 11 h 129"/>
              <a:gd name="T28" fmla="*/ 110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10 w 128"/>
              <a:gd name="T47" fmla="*/ 110 h 129"/>
              <a:gd name="T48" fmla="*/ 99 w 128"/>
              <a:gd name="T49" fmla="*/ 118 h 129"/>
              <a:gd name="T50" fmla="*/ 89 w 128"/>
              <a:gd name="T51" fmla="*/ 124 h 129"/>
              <a:gd name="T52" fmla="*/ 77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0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9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9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4" y="0"/>
                </a:lnTo>
                <a:lnTo>
                  <a:pt x="64" y="0"/>
                </a:lnTo>
                <a:lnTo>
                  <a:pt x="77" y="2"/>
                </a:lnTo>
                <a:lnTo>
                  <a:pt x="89" y="5"/>
                </a:lnTo>
                <a:lnTo>
                  <a:pt x="99" y="11"/>
                </a:lnTo>
                <a:lnTo>
                  <a:pt x="110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10" y="110"/>
                </a:lnTo>
                <a:lnTo>
                  <a:pt x="99" y="118"/>
                </a:lnTo>
                <a:lnTo>
                  <a:pt x="89" y="124"/>
                </a:lnTo>
                <a:lnTo>
                  <a:pt x="77" y="127"/>
                </a:lnTo>
                <a:lnTo>
                  <a:pt x="64" y="129"/>
                </a:lnTo>
                <a:lnTo>
                  <a:pt x="64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9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3">
            <a:extLst>
              <a:ext uri="{FF2B5EF4-FFF2-40B4-BE49-F238E27FC236}">
                <a16:creationId xmlns:a16="http://schemas.microsoft.com/office/drawing/2014/main" id="{FFEB16CA-ED0B-4FA1-A0BF-9474A6FCDA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9117" y="3276085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37" name="Rectangle 34">
            <a:extLst>
              <a:ext uri="{FF2B5EF4-FFF2-40B4-BE49-F238E27FC236}">
                <a16:creationId xmlns:a16="http://schemas.microsoft.com/office/drawing/2014/main" id="{D578BAB2-4CC9-4912-A189-6A3E7F9555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07151" y="1703129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B384F855-F97C-4711-8419-C02F723C33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0568" y="1703129"/>
            <a:ext cx="9778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zh-CN" altLang="en-US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39" name="Rectangle 36">
            <a:extLst>
              <a:ext uri="{FF2B5EF4-FFF2-40B4-BE49-F238E27FC236}">
                <a16:creationId xmlns:a16="http://schemas.microsoft.com/office/drawing/2014/main" id="{123C6FEC-06D0-4385-8E45-631BA6083F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8858" y="3277211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 err="1">
                <a:cs typeface="Arial" panose="020B0604020202020204" pitchFamily="34" charset="0"/>
              </a:rPr>
              <a:t>T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zmb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0" name="Rectangle 37">
            <a:extLst>
              <a:ext uri="{FF2B5EF4-FFF2-40B4-BE49-F238E27FC236}">
                <a16:creationId xmlns:a16="http://schemas.microsoft.com/office/drawing/2014/main" id="{3CC9571C-7F8A-4F0C-B05C-354133B370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0924" y="4816218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41" name="Rectangle 38">
            <a:extLst>
              <a:ext uri="{FF2B5EF4-FFF2-40B4-BE49-F238E27FC236}">
                <a16:creationId xmlns:a16="http://schemas.microsoft.com/office/drawing/2014/main" id="{B9AAB426-54EC-408A-8DBC-883A9FBFA7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6300" y="4816218"/>
            <a:ext cx="924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kumimoji="0" lang="en-US" altLang="zh-CN" sz="1000" b="0" i="0" u="none" strike="noStrike" cap="none" normalizeH="0" baseline="0" dirty="0" err="1">
                <a:ln>
                  <a:noFill/>
                </a:ln>
                <a:effectLst/>
                <a:cs typeface="Arial" panose="020B0604020202020204" pitchFamily="34" charset="0"/>
              </a:rPr>
              <a:t>Tzmb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CD99A142-98D2-4949-9A2D-8BAE078D58DE}"/>
              </a:ext>
            </a:extLst>
          </p:cNvPr>
          <p:cNvSpPr txBox="1"/>
          <p:nvPr/>
        </p:nvSpPr>
        <p:spPr>
          <a:xfrm>
            <a:off x="2997408" y="1272372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7507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Line 6">
            <a:extLst>
              <a:ext uri="{FF2B5EF4-FFF2-40B4-BE49-F238E27FC236}">
                <a16:creationId xmlns:a16="http://schemas.microsoft.com/office/drawing/2014/main" id="{15365C65-E9D8-4F2B-BBD5-B6C72474FA6F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311901" y="2070100"/>
            <a:ext cx="1214438" cy="1214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9306307B-6A85-4B09-A56A-CF94B6E9349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3163" y="3357563"/>
            <a:ext cx="2514600" cy="0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C82D0955-8378-4F7F-AE3B-D226FA852369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3001" y="3429000"/>
            <a:ext cx="1214438" cy="1214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Freeform 9">
            <a:extLst>
              <a:ext uri="{FF2B5EF4-FFF2-40B4-BE49-F238E27FC236}">
                <a16:creationId xmlns:a16="http://schemas.microsoft.com/office/drawing/2014/main" id="{5010D70A-2CF8-4BFA-9285-15A955E73418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eform 10">
            <a:extLst>
              <a:ext uri="{FF2B5EF4-FFF2-40B4-BE49-F238E27FC236}">
                <a16:creationId xmlns:a16="http://schemas.microsoft.com/office/drawing/2014/main" id="{82213A71-EBE9-416E-B7BC-BC2066D1F873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11">
            <a:extLst>
              <a:ext uri="{FF2B5EF4-FFF2-40B4-BE49-F238E27FC236}">
                <a16:creationId xmlns:a16="http://schemas.microsoft.com/office/drawing/2014/main" id="{E87CC3A6-FE5A-4BB3-8A64-6ED7C425953E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12">
            <a:extLst>
              <a:ext uri="{FF2B5EF4-FFF2-40B4-BE49-F238E27FC236}">
                <a16:creationId xmlns:a16="http://schemas.microsoft.com/office/drawing/2014/main" id="{67AB49FF-BB79-432C-A836-180D2A55063F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Freeform 13">
            <a:extLst>
              <a:ext uri="{FF2B5EF4-FFF2-40B4-BE49-F238E27FC236}">
                <a16:creationId xmlns:a16="http://schemas.microsoft.com/office/drawing/2014/main" id="{4CB1CBBC-7B4E-45CE-A758-61BCE08B7E35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14">
            <a:extLst>
              <a:ext uri="{FF2B5EF4-FFF2-40B4-BE49-F238E27FC236}">
                <a16:creationId xmlns:a16="http://schemas.microsoft.com/office/drawing/2014/main" id="{5D493AF1-21DC-4AC9-B413-8BA1308B497E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15">
            <a:extLst>
              <a:ext uri="{FF2B5EF4-FFF2-40B4-BE49-F238E27FC236}">
                <a16:creationId xmlns:a16="http://schemas.microsoft.com/office/drawing/2014/main" id="{DD609D42-3D06-4033-BAA0-C37BED213D26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3F095632-2E63-434E-BFC0-FD2D58A08456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4AD313EE-7739-4300-A155-B5D2A12345D3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71C03199-2569-4B05-BFAF-97C07EDD9973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eform 19">
            <a:extLst>
              <a:ext uri="{FF2B5EF4-FFF2-40B4-BE49-F238E27FC236}">
                <a16:creationId xmlns:a16="http://schemas.microsoft.com/office/drawing/2014/main" id="{762A18CE-8F2A-4B5E-9C94-B365F8DC0204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07B2ECDC-3487-4EF7-B303-2C3E88BBDDB6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1">
            <a:extLst>
              <a:ext uri="{FF2B5EF4-FFF2-40B4-BE49-F238E27FC236}">
                <a16:creationId xmlns:a16="http://schemas.microsoft.com/office/drawing/2014/main" id="{0DC79F8D-7DB2-4751-8043-00E8D6704E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8723" y="3271322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5" name="Rectangle 22">
            <a:extLst>
              <a:ext uri="{FF2B5EF4-FFF2-40B4-BE49-F238E27FC236}">
                <a16:creationId xmlns:a16="http://schemas.microsoft.com/office/drawing/2014/main" id="{4D125807-0D64-4B1B-83C4-C14323C093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29289" y="1674297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6" name="Rectangle 23">
            <a:extLst>
              <a:ext uri="{FF2B5EF4-FFF2-40B4-BE49-F238E27FC236}">
                <a16:creationId xmlns:a16="http://schemas.microsoft.com/office/drawing/2014/main" id="{C8EBAE37-411D-472D-B1E6-53DD8A2DE4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83925" y="3271322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27" name="Rectangle 24">
            <a:extLst>
              <a:ext uri="{FF2B5EF4-FFF2-40B4-BE49-F238E27FC236}">
                <a16:creationId xmlns:a16="http://schemas.microsoft.com/office/drawing/2014/main" id="{8A140E47-3750-4D95-B9C2-818E0D82AC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7310" y="4845474"/>
            <a:ext cx="9730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zh-CN" altLang="en-US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Ner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811BAFB-2FF9-4557-9AED-64D74538A89B}"/>
              </a:ext>
            </a:extLst>
          </p:cNvPr>
          <p:cNvSpPr txBox="1"/>
          <p:nvPr/>
        </p:nvSpPr>
        <p:spPr>
          <a:xfrm>
            <a:off x="2970381" y="13049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12119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6">
            <a:extLst>
              <a:ext uri="{FF2B5EF4-FFF2-40B4-BE49-F238E27FC236}">
                <a16:creationId xmlns:a16="http://schemas.microsoft.com/office/drawing/2014/main" id="{722FEA5E-0B63-42B1-B9E5-E0B93E8D060F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6311901" y="2070100"/>
            <a:ext cx="1214438" cy="1214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Line 7">
            <a:extLst>
              <a:ext uri="{FF2B5EF4-FFF2-40B4-BE49-F238E27FC236}">
                <a16:creationId xmlns:a16="http://schemas.microsoft.com/office/drawing/2014/main" id="{A6ED2226-BA80-43E4-B717-84E59309C5B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983163" y="3357563"/>
            <a:ext cx="2514600" cy="0"/>
          </a:xfrm>
          <a:prstGeom prst="line">
            <a:avLst/>
          </a:prstGeom>
          <a:noFill/>
          <a:ln w="1428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Line 8">
            <a:extLst>
              <a:ext uri="{FF2B5EF4-FFF2-40B4-BE49-F238E27FC236}">
                <a16:creationId xmlns:a16="http://schemas.microsoft.com/office/drawing/2014/main" id="{232F6724-3655-4744-A3DC-7128BEA67AF7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3001" y="3429000"/>
            <a:ext cx="1214438" cy="1214438"/>
          </a:xfrm>
          <a:prstGeom prst="line">
            <a:avLst/>
          </a:prstGeom>
          <a:noFill/>
          <a:ln w="7938">
            <a:solidFill>
              <a:srgbClr val="A9A9A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Freeform 9">
            <a:extLst>
              <a:ext uri="{FF2B5EF4-FFF2-40B4-BE49-F238E27FC236}">
                <a16:creationId xmlns:a16="http://schemas.microsoft.com/office/drawing/2014/main" id="{66DF8EF6-65DA-43B5-8D63-36F4653FFBEA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Freeform 10">
            <a:extLst>
              <a:ext uri="{FF2B5EF4-FFF2-40B4-BE49-F238E27FC236}">
                <a16:creationId xmlns:a16="http://schemas.microsoft.com/office/drawing/2014/main" id="{A4E02DB7-DBCE-4C52-AB93-4709E872A67B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Freeform 11">
            <a:extLst>
              <a:ext uri="{FF2B5EF4-FFF2-40B4-BE49-F238E27FC236}">
                <a16:creationId xmlns:a16="http://schemas.microsoft.com/office/drawing/2014/main" id="{10B22622-3311-4E1B-A60D-09DED5BB987D}"/>
              </a:ext>
            </a:extLst>
          </p:cNvPr>
          <p:cNvSpPr>
            <a:spLocks/>
          </p:cNvSpPr>
          <p:nvPr/>
        </p:nvSpPr>
        <p:spPr bwMode="auto">
          <a:xfrm>
            <a:off x="7497763" y="3254375"/>
            <a:ext cx="201613" cy="204788"/>
          </a:xfrm>
          <a:custGeom>
            <a:avLst/>
            <a:gdLst>
              <a:gd name="T0" fmla="*/ 0 w 127"/>
              <a:gd name="T1" fmla="*/ 65 h 129"/>
              <a:gd name="T2" fmla="*/ 0 w 127"/>
              <a:gd name="T3" fmla="*/ 65 h 129"/>
              <a:gd name="T4" fmla="*/ 0 w 127"/>
              <a:gd name="T5" fmla="*/ 52 h 129"/>
              <a:gd name="T6" fmla="*/ 4 w 127"/>
              <a:gd name="T7" fmla="*/ 39 h 129"/>
              <a:gd name="T8" fmla="*/ 11 w 127"/>
              <a:gd name="T9" fmla="*/ 28 h 129"/>
              <a:gd name="T10" fmla="*/ 18 w 127"/>
              <a:gd name="T11" fmla="*/ 19 h 129"/>
              <a:gd name="T12" fmla="*/ 28 w 127"/>
              <a:gd name="T13" fmla="*/ 11 h 129"/>
              <a:gd name="T14" fmla="*/ 39 w 127"/>
              <a:gd name="T15" fmla="*/ 5 h 129"/>
              <a:gd name="T16" fmla="*/ 50 w 127"/>
              <a:gd name="T17" fmla="*/ 2 h 129"/>
              <a:gd name="T18" fmla="*/ 62 w 127"/>
              <a:gd name="T19" fmla="*/ 0 h 129"/>
              <a:gd name="T20" fmla="*/ 62 w 127"/>
              <a:gd name="T21" fmla="*/ 0 h 129"/>
              <a:gd name="T22" fmla="*/ 76 w 127"/>
              <a:gd name="T23" fmla="*/ 2 h 129"/>
              <a:gd name="T24" fmla="*/ 87 w 127"/>
              <a:gd name="T25" fmla="*/ 5 h 129"/>
              <a:gd name="T26" fmla="*/ 98 w 127"/>
              <a:gd name="T27" fmla="*/ 11 h 129"/>
              <a:gd name="T28" fmla="*/ 108 w 127"/>
              <a:gd name="T29" fmla="*/ 19 h 129"/>
              <a:gd name="T30" fmla="*/ 116 w 127"/>
              <a:gd name="T31" fmla="*/ 28 h 129"/>
              <a:gd name="T32" fmla="*/ 122 w 127"/>
              <a:gd name="T33" fmla="*/ 39 h 129"/>
              <a:gd name="T34" fmla="*/ 127 w 127"/>
              <a:gd name="T35" fmla="*/ 52 h 129"/>
              <a:gd name="T36" fmla="*/ 127 w 127"/>
              <a:gd name="T37" fmla="*/ 65 h 129"/>
              <a:gd name="T38" fmla="*/ 127 w 127"/>
              <a:gd name="T39" fmla="*/ 65 h 129"/>
              <a:gd name="T40" fmla="*/ 127 w 127"/>
              <a:gd name="T41" fmla="*/ 77 h 129"/>
              <a:gd name="T42" fmla="*/ 122 w 127"/>
              <a:gd name="T43" fmla="*/ 90 h 129"/>
              <a:gd name="T44" fmla="*/ 116 w 127"/>
              <a:gd name="T45" fmla="*/ 101 h 129"/>
              <a:gd name="T46" fmla="*/ 108 w 127"/>
              <a:gd name="T47" fmla="*/ 110 h 129"/>
              <a:gd name="T48" fmla="*/ 98 w 127"/>
              <a:gd name="T49" fmla="*/ 118 h 129"/>
              <a:gd name="T50" fmla="*/ 87 w 127"/>
              <a:gd name="T51" fmla="*/ 124 h 129"/>
              <a:gd name="T52" fmla="*/ 76 w 127"/>
              <a:gd name="T53" fmla="*/ 127 h 129"/>
              <a:gd name="T54" fmla="*/ 62 w 127"/>
              <a:gd name="T55" fmla="*/ 129 h 129"/>
              <a:gd name="T56" fmla="*/ 62 w 127"/>
              <a:gd name="T57" fmla="*/ 129 h 129"/>
              <a:gd name="T58" fmla="*/ 50 w 127"/>
              <a:gd name="T59" fmla="*/ 127 h 129"/>
              <a:gd name="T60" fmla="*/ 39 w 127"/>
              <a:gd name="T61" fmla="*/ 124 h 129"/>
              <a:gd name="T62" fmla="*/ 28 w 127"/>
              <a:gd name="T63" fmla="*/ 118 h 129"/>
              <a:gd name="T64" fmla="*/ 18 w 127"/>
              <a:gd name="T65" fmla="*/ 110 h 129"/>
              <a:gd name="T66" fmla="*/ 11 w 127"/>
              <a:gd name="T67" fmla="*/ 101 h 129"/>
              <a:gd name="T68" fmla="*/ 4 w 127"/>
              <a:gd name="T69" fmla="*/ 90 h 129"/>
              <a:gd name="T70" fmla="*/ 0 w 127"/>
              <a:gd name="T71" fmla="*/ 77 h 129"/>
              <a:gd name="T72" fmla="*/ 0 w 127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7" h="129">
                <a:moveTo>
                  <a:pt x="0" y="65"/>
                </a:moveTo>
                <a:lnTo>
                  <a:pt x="0" y="65"/>
                </a:lnTo>
                <a:lnTo>
                  <a:pt x="0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0" y="2"/>
                </a:lnTo>
                <a:lnTo>
                  <a:pt x="62" y="0"/>
                </a:lnTo>
                <a:lnTo>
                  <a:pt x="62" y="0"/>
                </a:lnTo>
                <a:lnTo>
                  <a:pt x="76" y="2"/>
                </a:lnTo>
                <a:lnTo>
                  <a:pt x="87" y="5"/>
                </a:lnTo>
                <a:lnTo>
                  <a:pt x="98" y="11"/>
                </a:lnTo>
                <a:lnTo>
                  <a:pt x="108" y="19"/>
                </a:lnTo>
                <a:lnTo>
                  <a:pt x="116" y="28"/>
                </a:lnTo>
                <a:lnTo>
                  <a:pt x="122" y="39"/>
                </a:lnTo>
                <a:lnTo>
                  <a:pt x="127" y="52"/>
                </a:lnTo>
                <a:lnTo>
                  <a:pt x="127" y="65"/>
                </a:lnTo>
                <a:lnTo>
                  <a:pt x="127" y="65"/>
                </a:lnTo>
                <a:lnTo>
                  <a:pt x="127" y="77"/>
                </a:lnTo>
                <a:lnTo>
                  <a:pt x="122" y="90"/>
                </a:lnTo>
                <a:lnTo>
                  <a:pt x="116" y="101"/>
                </a:lnTo>
                <a:lnTo>
                  <a:pt x="108" y="110"/>
                </a:lnTo>
                <a:lnTo>
                  <a:pt x="98" y="118"/>
                </a:lnTo>
                <a:lnTo>
                  <a:pt x="87" y="124"/>
                </a:lnTo>
                <a:lnTo>
                  <a:pt x="76" y="127"/>
                </a:lnTo>
                <a:lnTo>
                  <a:pt x="62" y="129"/>
                </a:lnTo>
                <a:lnTo>
                  <a:pt x="62" y="129"/>
                </a:lnTo>
                <a:lnTo>
                  <a:pt x="50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0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Freeform 12">
            <a:extLst>
              <a:ext uri="{FF2B5EF4-FFF2-40B4-BE49-F238E27FC236}">
                <a16:creationId xmlns:a16="http://schemas.microsoft.com/office/drawing/2014/main" id="{6B458B77-0867-4C68-8644-BF1C03E524A4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Freeform 13">
            <a:extLst>
              <a:ext uri="{FF2B5EF4-FFF2-40B4-BE49-F238E27FC236}">
                <a16:creationId xmlns:a16="http://schemas.microsoft.com/office/drawing/2014/main" id="{A4B053D4-43F1-4EEE-B9A1-CFC87CDA2EE3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14">
            <a:extLst>
              <a:ext uri="{FF2B5EF4-FFF2-40B4-BE49-F238E27FC236}">
                <a16:creationId xmlns:a16="http://schemas.microsoft.com/office/drawing/2014/main" id="{129791B1-AD89-413D-9CDD-E689B402335C}"/>
              </a:ext>
            </a:extLst>
          </p:cNvPr>
          <p:cNvSpPr>
            <a:spLocks/>
          </p:cNvSpPr>
          <p:nvPr/>
        </p:nvSpPr>
        <p:spPr bwMode="auto">
          <a:xfrm>
            <a:off x="6138863" y="18954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40 h 129"/>
              <a:gd name="T8" fmla="*/ 11 w 128"/>
              <a:gd name="T9" fmla="*/ 30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7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7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30 h 129"/>
              <a:gd name="T32" fmla="*/ 122 w 128"/>
              <a:gd name="T33" fmla="*/ 40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9 h 129"/>
              <a:gd name="T42" fmla="*/ 122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9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40"/>
                </a:lnTo>
                <a:lnTo>
                  <a:pt x="11" y="30"/>
                </a:lnTo>
                <a:lnTo>
                  <a:pt x="18" y="19"/>
                </a:lnTo>
                <a:lnTo>
                  <a:pt x="28" y="11"/>
                </a:lnTo>
                <a:lnTo>
                  <a:pt x="39" y="7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7"/>
                </a:lnTo>
                <a:lnTo>
                  <a:pt x="100" y="11"/>
                </a:lnTo>
                <a:lnTo>
                  <a:pt x="109" y="19"/>
                </a:lnTo>
                <a:lnTo>
                  <a:pt x="117" y="30"/>
                </a:lnTo>
                <a:lnTo>
                  <a:pt x="122" y="40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9"/>
                </a:lnTo>
                <a:lnTo>
                  <a:pt x="122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9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Freeform 15">
            <a:extLst>
              <a:ext uri="{FF2B5EF4-FFF2-40B4-BE49-F238E27FC236}">
                <a16:creationId xmlns:a16="http://schemas.microsoft.com/office/drawing/2014/main" id="{404F72B5-3ACC-4C5C-A34C-F867B2F3F3B7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Freeform 16">
            <a:extLst>
              <a:ext uri="{FF2B5EF4-FFF2-40B4-BE49-F238E27FC236}">
                <a16:creationId xmlns:a16="http://schemas.microsoft.com/office/drawing/2014/main" id="{B425E3F8-EC81-4BE7-9D0F-D641F80C88B3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17">
            <a:extLst>
              <a:ext uri="{FF2B5EF4-FFF2-40B4-BE49-F238E27FC236}">
                <a16:creationId xmlns:a16="http://schemas.microsoft.com/office/drawing/2014/main" id="{4958B5DD-AB04-43B6-96D2-2DBA1EE0BFAA}"/>
              </a:ext>
            </a:extLst>
          </p:cNvPr>
          <p:cNvSpPr>
            <a:spLocks/>
          </p:cNvSpPr>
          <p:nvPr/>
        </p:nvSpPr>
        <p:spPr bwMode="auto">
          <a:xfrm>
            <a:off x="4779963" y="3254375"/>
            <a:ext cx="203200" cy="204788"/>
          </a:xfrm>
          <a:custGeom>
            <a:avLst/>
            <a:gdLst>
              <a:gd name="T0" fmla="*/ 0 w 128"/>
              <a:gd name="T1" fmla="*/ 65 h 129"/>
              <a:gd name="T2" fmla="*/ 0 w 128"/>
              <a:gd name="T3" fmla="*/ 65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4 w 128"/>
              <a:gd name="T33" fmla="*/ 39 h 129"/>
              <a:gd name="T34" fmla="*/ 127 w 128"/>
              <a:gd name="T35" fmla="*/ 52 h 129"/>
              <a:gd name="T36" fmla="*/ 128 w 128"/>
              <a:gd name="T37" fmla="*/ 65 h 129"/>
              <a:gd name="T38" fmla="*/ 128 w 128"/>
              <a:gd name="T39" fmla="*/ 65 h 129"/>
              <a:gd name="T40" fmla="*/ 127 w 128"/>
              <a:gd name="T41" fmla="*/ 77 h 129"/>
              <a:gd name="T42" fmla="*/ 124 w 128"/>
              <a:gd name="T43" fmla="*/ 90 h 129"/>
              <a:gd name="T44" fmla="*/ 117 w 128"/>
              <a:gd name="T45" fmla="*/ 101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1 h 129"/>
              <a:gd name="T68" fmla="*/ 4 w 128"/>
              <a:gd name="T69" fmla="*/ 90 h 129"/>
              <a:gd name="T70" fmla="*/ 1 w 128"/>
              <a:gd name="T71" fmla="*/ 77 h 129"/>
              <a:gd name="T72" fmla="*/ 0 w 128"/>
              <a:gd name="T73" fmla="*/ 65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5"/>
                </a:moveTo>
                <a:lnTo>
                  <a:pt x="0" y="65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4" y="39"/>
                </a:lnTo>
                <a:lnTo>
                  <a:pt x="127" y="52"/>
                </a:lnTo>
                <a:lnTo>
                  <a:pt x="128" y="65"/>
                </a:lnTo>
                <a:lnTo>
                  <a:pt x="128" y="65"/>
                </a:lnTo>
                <a:lnTo>
                  <a:pt x="127" y="77"/>
                </a:lnTo>
                <a:lnTo>
                  <a:pt x="124" y="90"/>
                </a:lnTo>
                <a:lnTo>
                  <a:pt x="117" y="101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1"/>
                </a:lnTo>
                <a:lnTo>
                  <a:pt x="4" y="90"/>
                </a:lnTo>
                <a:lnTo>
                  <a:pt x="1" y="77"/>
                </a:lnTo>
                <a:lnTo>
                  <a:pt x="0" y="6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Freeform 18">
            <a:extLst>
              <a:ext uri="{FF2B5EF4-FFF2-40B4-BE49-F238E27FC236}">
                <a16:creationId xmlns:a16="http://schemas.microsoft.com/office/drawing/2014/main" id="{72CBB62A-B203-4D29-AE74-65EEFDAC642F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  <a:close/>
              </a:path>
            </a:pathLst>
          </a:custGeom>
          <a:solidFill>
            <a:srgbClr val="E69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Freeform 19">
            <a:extLst>
              <a:ext uri="{FF2B5EF4-FFF2-40B4-BE49-F238E27FC236}">
                <a16:creationId xmlns:a16="http://schemas.microsoft.com/office/drawing/2014/main" id="{6C2665C0-942B-40B4-B71F-6DA490D845D4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20">
            <a:extLst>
              <a:ext uri="{FF2B5EF4-FFF2-40B4-BE49-F238E27FC236}">
                <a16:creationId xmlns:a16="http://schemas.microsoft.com/office/drawing/2014/main" id="{B4047019-EE8A-41B0-9AE6-DDCBA283C2E8}"/>
              </a:ext>
            </a:extLst>
          </p:cNvPr>
          <p:cNvSpPr>
            <a:spLocks/>
          </p:cNvSpPr>
          <p:nvPr/>
        </p:nvSpPr>
        <p:spPr bwMode="auto">
          <a:xfrm>
            <a:off x="6138863" y="4613275"/>
            <a:ext cx="203200" cy="204788"/>
          </a:xfrm>
          <a:custGeom>
            <a:avLst/>
            <a:gdLst>
              <a:gd name="T0" fmla="*/ 0 w 128"/>
              <a:gd name="T1" fmla="*/ 64 h 129"/>
              <a:gd name="T2" fmla="*/ 0 w 128"/>
              <a:gd name="T3" fmla="*/ 64 h 129"/>
              <a:gd name="T4" fmla="*/ 1 w 128"/>
              <a:gd name="T5" fmla="*/ 52 h 129"/>
              <a:gd name="T6" fmla="*/ 4 w 128"/>
              <a:gd name="T7" fmla="*/ 39 h 129"/>
              <a:gd name="T8" fmla="*/ 11 w 128"/>
              <a:gd name="T9" fmla="*/ 28 h 129"/>
              <a:gd name="T10" fmla="*/ 18 w 128"/>
              <a:gd name="T11" fmla="*/ 19 h 129"/>
              <a:gd name="T12" fmla="*/ 28 w 128"/>
              <a:gd name="T13" fmla="*/ 11 h 129"/>
              <a:gd name="T14" fmla="*/ 39 w 128"/>
              <a:gd name="T15" fmla="*/ 5 h 129"/>
              <a:gd name="T16" fmla="*/ 51 w 128"/>
              <a:gd name="T17" fmla="*/ 2 h 129"/>
              <a:gd name="T18" fmla="*/ 64 w 128"/>
              <a:gd name="T19" fmla="*/ 0 h 129"/>
              <a:gd name="T20" fmla="*/ 64 w 128"/>
              <a:gd name="T21" fmla="*/ 0 h 129"/>
              <a:gd name="T22" fmla="*/ 76 w 128"/>
              <a:gd name="T23" fmla="*/ 2 h 129"/>
              <a:gd name="T24" fmla="*/ 89 w 128"/>
              <a:gd name="T25" fmla="*/ 5 h 129"/>
              <a:gd name="T26" fmla="*/ 100 w 128"/>
              <a:gd name="T27" fmla="*/ 11 h 129"/>
              <a:gd name="T28" fmla="*/ 109 w 128"/>
              <a:gd name="T29" fmla="*/ 19 h 129"/>
              <a:gd name="T30" fmla="*/ 117 w 128"/>
              <a:gd name="T31" fmla="*/ 28 h 129"/>
              <a:gd name="T32" fmla="*/ 122 w 128"/>
              <a:gd name="T33" fmla="*/ 39 h 129"/>
              <a:gd name="T34" fmla="*/ 127 w 128"/>
              <a:gd name="T35" fmla="*/ 52 h 129"/>
              <a:gd name="T36" fmla="*/ 128 w 128"/>
              <a:gd name="T37" fmla="*/ 64 h 129"/>
              <a:gd name="T38" fmla="*/ 128 w 128"/>
              <a:gd name="T39" fmla="*/ 64 h 129"/>
              <a:gd name="T40" fmla="*/ 127 w 128"/>
              <a:gd name="T41" fmla="*/ 77 h 129"/>
              <a:gd name="T42" fmla="*/ 122 w 128"/>
              <a:gd name="T43" fmla="*/ 89 h 129"/>
              <a:gd name="T44" fmla="*/ 117 w 128"/>
              <a:gd name="T45" fmla="*/ 100 h 129"/>
              <a:gd name="T46" fmla="*/ 109 w 128"/>
              <a:gd name="T47" fmla="*/ 110 h 129"/>
              <a:gd name="T48" fmla="*/ 100 w 128"/>
              <a:gd name="T49" fmla="*/ 118 h 129"/>
              <a:gd name="T50" fmla="*/ 89 w 128"/>
              <a:gd name="T51" fmla="*/ 124 h 129"/>
              <a:gd name="T52" fmla="*/ 76 w 128"/>
              <a:gd name="T53" fmla="*/ 127 h 129"/>
              <a:gd name="T54" fmla="*/ 64 w 128"/>
              <a:gd name="T55" fmla="*/ 129 h 129"/>
              <a:gd name="T56" fmla="*/ 64 w 128"/>
              <a:gd name="T57" fmla="*/ 129 h 129"/>
              <a:gd name="T58" fmla="*/ 51 w 128"/>
              <a:gd name="T59" fmla="*/ 127 h 129"/>
              <a:gd name="T60" fmla="*/ 39 w 128"/>
              <a:gd name="T61" fmla="*/ 124 h 129"/>
              <a:gd name="T62" fmla="*/ 28 w 128"/>
              <a:gd name="T63" fmla="*/ 118 h 129"/>
              <a:gd name="T64" fmla="*/ 18 w 128"/>
              <a:gd name="T65" fmla="*/ 110 h 129"/>
              <a:gd name="T66" fmla="*/ 11 w 128"/>
              <a:gd name="T67" fmla="*/ 100 h 129"/>
              <a:gd name="T68" fmla="*/ 4 w 128"/>
              <a:gd name="T69" fmla="*/ 89 h 129"/>
              <a:gd name="T70" fmla="*/ 1 w 128"/>
              <a:gd name="T71" fmla="*/ 77 h 129"/>
              <a:gd name="T72" fmla="*/ 0 w 128"/>
              <a:gd name="T73" fmla="*/ 64 h 1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128" h="129">
                <a:moveTo>
                  <a:pt x="0" y="64"/>
                </a:moveTo>
                <a:lnTo>
                  <a:pt x="0" y="64"/>
                </a:lnTo>
                <a:lnTo>
                  <a:pt x="1" y="52"/>
                </a:lnTo>
                <a:lnTo>
                  <a:pt x="4" y="39"/>
                </a:lnTo>
                <a:lnTo>
                  <a:pt x="11" y="28"/>
                </a:lnTo>
                <a:lnTo>
                  <a:pt x="18" y="19"/>
                </a:lnTo>
                <a:lnTo>
                  <a:pt x="28" y="11"/>
                </a:lnTo>
                <a:lnTo>
                  <a:pt x="39" y="5"/>
                </a:lnTo>
                <a:lnTo>
                  <a:pt x="51" y="2"/>
                </a:lnTo>
                <a:lnTo>
                  <a:pt x="64" y="0"/>
                </a:lnTo>
                <a:lnTo>
                  <a:pt x="64" y="0"/>
                </a:lnTo>
                <a:lnTo>
                  <a:pt x="76" y="2"/>
                </a:lnTo>
                <a:lnTo>
                  <a:pt x="89" y="5"/>
                </a:lnTo>
                <a:lnTo>
                  <a:pt x="100" y="11"/>
                </a:lnTo>
                <a:lnTo>
                  <a:pt x="109" y="19"/>
                </a:lnTo>
                <a:lnTo>
                  <a:pt x="117" y="28"/>
                </a:lnTo>
                <a:lnTo>
                  <a:pt x="122" y="39"/>
                </a:lnTo>
                <a:lnTo>
                  <a:pt x="127" y="52"/>
                </a:lnTo>
                <a:lnTo>
                  <a:pt x="128" y="64"/>
                </a:lnTo>
                <a:lnTo>
                  <a:pt x="128" y="64"/>
                </a:lnTo>
                <a:lnTo>
                  <a:pt x="127" y="77"/>
                </a:lnTo>
                <a:lnTo>
                  <a:pt x="122" y="89"/>
                </a:lnTo>
                <a:lnTo>
                  <a:pt x="117" y="100"/>
                </a:lnTo>
                <a:lnTo>
                  <a:pt x="109" y="110"/>
                </a:lnTo>
                <a:lnTo>
                  <a:pt x="100" y="118"/>
                </a:lnTo>
                <a:lnTo>
                  <a:pt x="89" y="124"/>
                </a:lnTo>
                <a:lnTo>
                  <a:pt x="76" y="127"/>
                </a:lnTo>
                <a:lnTo>
                  <a:pt x="64" y="129"/>
                </a:lnTo>
                <a:lnTo>
                  <a:pt x="64" y="129"/>
                </a:lnTo>
                <a:lnTo>
                  <a:pt x="51" y="127"/>
                </a:lnTo>
                <a:lnTo>
                  <a:pt x="39" y="124"/>
                </a:lnTo>
                <a:lnTo>
                  <a:pt x="28" y="118"/>
                </a:lnTo>
                <a:lnTo>
                  <a:pt x="18" y="110"/>
                </a:lnTo>
                <a:lnTo>
                  <a:pt x="11" y="100"/>
                </a:lnTo>
                <a:lnTo>
                  <a:pt x="4" y="89"/>
                </a:lnTo>
                <a:lnTo>
                  <a:pt x="1" y="77"/>
                </a:lnTo>
                <a:lnTo>
                  <a:pt x="0" y="6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1">
            <a:extLst>
              <a:ext uri="{FF2B5EF4-FFF2-40B4-BE49-F238E27FC236}">
                <a16:creationId xmlns:a16="http://schemas.microsoft.com/office/drawing/2014/main" id="{7ADA7139-E175-4846-A5FC-FC1442BE74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58723" y="3271322"/>
            <a:ext cx="1715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</a:p>
        </p:txBody>
      </p:sp>
      <p:sp>
        <p:nvSpPr>
          <p:cNvPr id="22" name="Rectangle 22">
            <a:extLst>
              <a:ext uri="{FF2B5EF4-FFF2-40B4-BE49-F238E27FC236}">
                <a16:creationId xmlns:a16="http://schemas.microsoft.com/office/drawing/2014/main" id="{A3630DD7-585F-4682-A874-4CD2FF059A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29289" y="1674297"/>
            <a:ext cx="52899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Lap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3" name="Rectangle 23">
            <a:extLst>
              <a:ext uri="{FF2B5EF4-FFF2-40B4-BE49-F238E27FC236}">
                <a16:creationId xmlns:a16="http://schemas.microsoft.com/office/drawing/2014/main" id="{E7AD0D85-9144-42C7-89DE-9CBB8DF9EB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3170" y="3275287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</a:p>
        </p:txBody>
      </p:sp>
      <p:sp>
        <p:nvSpPr>
          <p:cNvPr id="24" name="Rectangle 24">
            <a:extLst>
              <a:ext uri="{FF2B5EF4-FFF2-40B4-BE49-F238E27FC236}">
                <a16:creationId xmlns:a16="http://schemas.microsoft.com/office/drawing/2014/main" id="{4FECC965-8107-4111-8601-8D532F406F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7310" y="4845474"/>
            <a:ext cx="97302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CT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+</a:t>
            </a:r>
            <a:r>
              <a:rPr lang="en-US" altLang="zh-CN" sz="1000" dirty="0">
                <a:cs typeface="Arial" panose="020B0604020202020204" pitchFamily="34" charset="0"/>
              </a:rPr>
              <a:t>T</a:t>
            </a:r>
            <a:r>
              <a:rPr kumimoji="0" lang="zh-CN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zmb</a:t>
            </a:r>
            <a:r>
              <a:rPr kumimoji="0" lang="zh-CN" altLang="en-US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→</a:t>
            </a:r>
            <a:r>
              <a:rPr kumimoji="0" lang="en-US" altLang="zh-CN" sz="10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rPr>
              <a:t>Nera</a:t>
            </a:r>
            <a:endParaRPr kumimoji="0" lang="zh-CN" altLang="zh-CN" sz="10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88159DA-FD5E-4D38-B7C6-651BC2CD7B24}"/>
              </a:ext>
            </a:extLst>
          </p:cNvPr>
          <p:cNvSpPr txBox="1"/>
          <p:nvPr/>
        </p:nvSpPr>
        <p:spPr>
          <a:xfrm>
            <a:off x="2893806" y="1304965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154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2</TotalTime>
  <Words>355</Words>
  <Application>Microsoft Office PowerPoint</Application>
  <PresentationFormat>宽屏</PresentationFormat>
  <Paragraphs>75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毓文</dc:creator>
  <cp:lastModifiedBy>YY</cp:lastModifiedBy>
  <cp:revision>37</cp:revision>
  <dcterms:created xsi:type="dcterms:W3CDTF">2022-01-03T08:08:31Z</dcterms:created>
  <dcterms:modified xsi:type="dcterms:W3CDTF">2022-03-14T08:12:01Z</dcterms:modified>
</cp:coreProperties>
</file>